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9.xml.rels" ContentType="application/vnd.openxmlformats-package.relationships+xml"/>
  <Override PartName="/ppt/slideMasters/_rels/slideMaster8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13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12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1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10.xml.rels" ContentType="application/vnd.openxmlformats-package.relationships+xml"/>
  <Override PartName="/ppt/slideMasters/_rels/slideMaster3.xml.rels" ContentType="application/vnd.openxmlformats-package.relationships+xml"/>
  <Override PartName="/ppt/slideMasters/slideMaster9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13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12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1.xml" ContentType="application/vnd.openxmlformats-officedocument.presentationml.slideMaster+xml"/>
  <Override PartName="/ppt/theme/theme9.xml" ContentType="application/vnd.openxmlformats-officedocument.theme+xml"/>
  <Override PartName="/ppt/theme/theme14.xml" ContentType="application/vnd.openxmlformats-officedocument.theme+xml"/>
  <Override PartName="/ppt/theme/theme8.xml" ContentType="application/vnd.openxmlformats-officedocument.theme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10.xml" ContentType="application/vnd.openxmlformats-officedocument.theme+xml"/>
  <Override PartName="/ppt/theme/theme5.xml" ContentType="application/vnd.openxmlformats-officedocument.theme+xml"/>
  <Override PartName="/ppt/theme/theme11.xml" ContentType="application/vnd.openxmlformats-officedocument.theme+xml"/>
  <Override PartName="/ppt/theme/theme6.xml" ContentType="application/vnd.openxmlformats-officedocument.theme+xml"/>
  <Override PartName="/ppt/theme/theme12.xml" ContentType="application/vnd.openxmlformats-officedocument.theme+xml"/>
  <Override PartName="/ppt/theme/theme7.xml" ContentType="application/vnd.openxmlformats-officedocument.theme+xml"/>
  <Override PartName="/ppt/theme/theme13.xml" ContentType="application/vnd.openxmlformats-officedocument.theme+xml"/>
  <Override PartName="/ppt/notesSlides/_rels/notesSlide7.xml.rels" ContentType="application/vnd.openxmlformats-package.relationships+xml"/>
  <Override PartName="/ppt/notesSlides/_rels/notesSlide1.xml.rels" ContentType="application/vnd.openxmlformats-package.relationships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7.xml" ContentType="application/vnd.openxmlformats-officedocument.presentationml.notesSlide+xml"/>
  <Override PartName="/ppt/_rels/presentation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73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29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17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150.xml.rels" ContentType="application/vnd.openxmlformats-package.relationships+xml"/>
  <Override PartName="/ppt/slideLayouts/_rels/slideLayout146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152.xml.rels" ContentType="application/vnd.openxmlformats-package.relationships+xml"/>
  <Override PartName="/ppt/slideLayouts/_rels/slideLayout151.xml.rels" ContentType="application/vnd.openxmlformats-package.relationships+xml"/>
  <Override PartName="/ppt/slideLayouts/_rels/slideLayout147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131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111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118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145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138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15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112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148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113.xml.rels" ContentType="application/vnd.openxmlformats-package.relationships+xml"/>
  <Override PartName="/ppt/slideLayouts/_rels/slideLayout109.xml.rels" ContentType="application/vnd.openxmlformats-package.relationships+xml"/>
  <Override PartName="/ppt/slideLayouts/_rels/slideLayout120.xml.rels" ContentType="application/vnd.openxmlformats-package.relationships+xml"/>
  <Override PartName="/ppt/slideLayouts/_rels/slideLayout121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10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123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122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155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0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136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139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144.xml.rels" ContentType="application/vnd.openxmlformats-package.relationships+xml"/>
  <Override PartName="/ppt/slideLayouts/_rels/slideLayout153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149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56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34.xml.rels" ContentType="application/vnd.openxmlformats-package.relationships+xml"/>
  <Override PartName="/ppt/slideLayouts/_rels/slideLayout143.xml.rels" ContentType="application/vnd.openxmlformats-package.relationships+xml"/>
  <Override PartName="/ppt/slideLayouts/_rels/slideLayout133.xml.rels" ContentType="application/vnd.openxmlformats-package.relationships+xml"/>
  <Override PartName="/ppt/slideLayouts/_rels/slideLayout142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132.xml.rels" ContentType="application/vnd.openxmlformats-package.relationships+xml"/>
  <Override PartName="/ppt/slideLayouts/_rels/slideLayout141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137.xml.rels" ContentType="application/vnd.openxmlformats-package.relationships+xml"/>
  <Override PartName="/ppt/slideLayouts/_rels/slideLayout130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35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6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15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128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27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2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125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126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119.xml.rels" ContentType="application/vnd.openxmlformats-package.relationships+xml"/>
  <Override PartName="/ppt/slideLayouts/_rels/slideLayout15.xml.rels" ContentType="application/vnd.openxmlformats-package.relationships+xml"/>
  <Override PartName="/ppt/slideLayouts/slideLayout124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122.xml" ContentType="application/vnd.openxmlformats-officedocument.presentationml.slideLayout+xml"/>
  <Override PartName="/ppt/slideLayouts/slideLayout121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14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111.xml" ContentType="application/vnd.openxmlformats-officedocument.presentationml.slideLayout+xml"/>
  <Override PartName="/ppt/slideLayouts/slideLayout110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102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149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145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146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147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148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150.xml" ContentType="application/vnd.openxmlformats-officedocument.presentationml.slideLayout+xml"/>
  <Override PartName="/ppt/slideLayouts/slideLayout151.xml" ContentType="application/vnd.openxmlformats-officedocument.presentationml.slideLayout+xml"/>
  <Override PartName="/ppt/slideLayouts/slideLayout152.xml" ContentType="application/vnd.openxmlformats-officedocument.presentationml.slideLayout+xml"/>
  <Override PartName="/ppt/slideLayouts/slideLayout153.xml" ContentType="application/vnd.openxmlformats-officedocument.presentationml.slideLayout+xml"/>
  <Override PartName="/ppt/slideLayouts/slideLayout154.xml" ContentType="application/vnd.openxmlformats-officedocument.presentationml.slideLayout+xml"/>
  <Override PartName="/ppt/slideLayouts/slideLayout155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144.xml" ContentType="application/vnd.openxmlformats-officedocument.presentationml.slideLayout+xml"/>
  <Override PartName="/ppt/slideLayouts/slideLayout156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133.xml" ContentType="application/vnd.openxmlformats-officedocument.presentationml.slideLayout+xml"/>
  <Override PartName="/ppt/slideLayouts/slideLayout132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5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9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95.xml" ContentType="application/vnd.openxmlformats-officedocument.presentationml.slideLayout+xml"/>
  <Override PartName="/ppt/media/image59.jpeg" ContentType="image/jpeg"/>
  <Override PartName="/ppt/media/image18.png" ContentType="image/png"/>
  <Override PartName="/ppt/media/image58.jpeg" ContentType="image/jpeg"/>
  <Override PartName="/ppt/media/image73.png" ContentType="image/png"/>
  <Override PartName="/ppt/media/image55.jpeg" ContentType="image/jpeg"/>
  <Override PartName="/ppt/media/image43.png" ContentType="image/png"/>
  <Override PartName="/ppt/media/image53.jpeg" ContentType="image/jpeg"/>
  <Override PartName="/ppt/media/image52.jpeg" ContentType="image/jpeg"/>
  <Override PartName="/ppt/media/image13.png" ContentType="image/png"/>
  <Override PartName="/ppt/media/image1.png" ContentType="image/png"/>
  <Override PartName="/ppt/media/image51.jpeg" ContentType="image/jpeg"/>
  <Override PartName="/ppt/media/image50.jpeg" ContentType="image/jpeg"/>
  <Override PartName="/ppt/media/image48.jpeg" ContentType="image/jpeg"/>
  <Override PartName="/ppt/media/image47.jpeg" ContentType="image/jpeg"/>
  <Override PartName="/ppt/media/image46.jpeg" ContentType="image/jpeg"/>
  <Override PartName="/ppt/media/image27.png" ContentType="image/png"/>
  <Override PartName="/ppt/media/image32.png" ContentType="image/png"/>
  <Override PartName="/ppt/media/image25.png" ContentType="image/png"/>
  <Override PartName="/ppt/media/image30.png" ContentType="image/png"/>
  <Override PartName="/ppt/media/image60.jpeg" ContentType="image/jpeg"/>
  <Override PartName="/ppt/media/image15.png" ContentType="image/png"/>
  <Override PartName="/ppt/media/image20.png" ContentType="image/png"/>
  <Override PartName="/ppt/media/image49.jpeg" ContentType="image/jpeg"/>
  <Override PartName="/ppt/media/image4.png" ContentType="image/png"/>
  <Override PartName="/ppt/media/image16.png" ContentType="image/png"/>
  <Override PartName="/ppt/media/image12.png" ContentType="image/png"/>
  <Override PartName="/ppt/media/image23.jpeg" ContentType="image/jpeg"/>
  <Override PartName="/ppt/media/image72.png" ContentType="image/png"/>
  <Override PartName="/ppt/media/image70.png" ContentType="image/png"/>
  <Override PartName="/ppt/media/image28.png" ContentType="image/png"/>
  <Override PartName="/ppt/media/image61.jpeg" ContentType="image/jpeg"/>
  <Override PartName="/ppt/media/image40.png" ContentType="image/png"/>
  <Override PartName="/ppt/media/image24.png" ContentType="image/png"/>
  <Override PartName="/ppt/media/image68.jpeg" ContentType="image/jpeg"/>
  <Override PartName="/ppt/media/image31.png" ContentType="image/png"/>
  <Override PartName="/ppt/media/image6.jpeg" ContentType="image/jpeg"/>
  <Override PartName="/ppt/media/image71.png" ContentType="image/png"/>
  <Override PartName="/ppt/media/image21.jpeg" ContentType="image/jpeg"/>
  <Override PartName="/ppt/media/image63.jpeg" ContentType="image/jpeg"/>
  <Override PartName="/ppt/media/image29.png" ContentType="image/png"/>
  <Override PartName="/ppt/media/image2.png" ContentType="image/png"/>
  <Override PartName="/ppt/media/image14.png" ContentType="image/png"/>
  <Override PartName="/ppt/media/image69.png" ContentType="image/png"/>
  <Override PartName="/ppt/media/image67.jpeg" ContentType="image/jpeg"/>
  <Override PartName="/ppt/media/image66.jpeg" ContentType="image/jpeg"/>
  <Override PartName="/ppt/media/image11.png" ContentType="image/png"/>
  <Override PartName="/ppt/media/image65.jpeg" ContentType="image/jpeg"/>
  <Override PartName="/ppt/media/image38.png" ContentType="image/png"/>
  <Override PartName="/ppt/media/image34.png" ContentType="image/png"/>
  <Override PartName="/ppt/media/image74.jpeg" ContentType="image/jpeg"/>
  <Override PartName="/ppt/media/image8.jpeg" ContentType="image/jpeg"/>
  <Override PartName="/ppt/media/image26.png" ContentType="image/png"/>
  <Override PartName="/ppt/media/image17.png" ContentType="image/png"/>
  <Override PartName="/ppt/media/image5.png" ContentType="image/png"/>
  <Override PartName="/ppt/media/image35.png" ContentType="image/png"/>
  <Override PartName="/ppt/media/image10.png" ContentType="image/png"/>
  <Override PartName="/ppt/media/image22.jpeg" ContentType="image/jpeg"/>
  <Override PartName="/ppt/media/image9.png" ContentType="image/png"/>
  <Override PartName="/ppt/media/image64.jpeg" ContentType="image/jpeg"/>
  <Override PartName="/ppt/media/image39.png" ContentType="image/png"/>
  <Override PartName="/ppt/media/image62.jpeg" ContentType="image/jpeg"/>
  <Override PartName="/ppt/media/image19.png" ContentType="image/png"/>
  <Override PartName="/ppt/media/image7.png" ContentType="image/png"/>
  <Override PartName="/ppt/media/image37.png" ContentType="image/png"/>
  <Override PartName="/ppt/media/image54.jpeg" ContentType="image/jpeg"/>
  <Override PartName="/ppt/media/image33.png" ContentType="image/png"/>
  <Override PartName="/ppt/media/image56.jpeg" ContentType="image/jpeg"/>
  <Override PartName="/ppt/media/image36.png" ContentType="image/png"/>
  <Override PartName="/ppt/media/image3.jpeg" ContentType="image/jpeg"/>
  <Override PartName="/ppt/media/image41.png" ContentType="image/png"/>
  <Override PartName="/ppt/media/image42.png" ContentType="image/png"/>
  <Override PartName="/ppt/media/image57.jpeg" ContentType="image/jpeg"/>
  <Override PartName="/ppt/media/image44.png" ContentType="image/png"/>
  <Override PartName="/ppt/media/image45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  <p:sldMasterId id="2147483765" r:id="rId11"/>
    <p:sldMasterId id="2147483778" r:id="rId12"/>
    <p:sldMasterId id="2147483791" r:id="rId13"/>
    <p:sldMasterId id="2147483804" r:id="rId14"/>
  </p:sldMasterIdLst>
  <p:notesMasterIdLst>
    <p:notesMasterId r:id="rId15"/>
  </p:notesMasterIdLst>
  <p:sldIdLst>
    <p:sldId id="256" r:id="rId16"/>
    <p:sldId id="257" r:id="rId17"/>
    <p:sldId id="258" r:id="rId18"/>
    <p:sldId id="259" r:id="rId19"/>
    <p:sldId id="260" r:id="rId20"/>
    <p:sldId id="261" r:id="rId21"/>
    <p:sldId id="262" r:id="rId22"/>
  </p:sldIdLst>
  <p:sldSz cx="6858000" cy="9144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slideMaster" Target="slideMasters/slideMaster10.xml"/><Relationship Id="rId12" Type="http://schemas.openxmlformats.org/officeDocument/2006/relationships/slideMaster" Target="slideMasters/slideMaster11.xml"/><Relationship Id="rId13" Type="http://schemas.openxmlformats.org/officeDocument/2006/relationships/slideMaster" Target="slideMasters/slideMaster12.xml"/><Relationship Id="rId14" Type="http://schemas.openxmlformats.org/officeDocument/2006/relationships/slideMaster" Target="slideMasters/slideMaster13.xml"/><Relationship Id="rId15" Type="http://schemas.openxmlformats.org/officeDocument/2006/relationships/notesMaster" Target="notesMasters/notesMaster1.xml"/><Relationship Id="rId16" Type="http://schemas.openxmlformats.org/officeDocument/2006/relationships/slide" Target="slides/slide1.xml"/><Relationship Id="rId17" Type="http://schemas.openxmlformats.org/officeDocument/2006/relationships/slide" Target="slides/slide2.xml"/><Relationship Id="rId18" Type="http://schemas.openxmlformats.org/officeDocument/2006/relationships/slide" Target="slides/slide3.xml"/><Relationship Id="rId19" Type="http://schemas.openxmlformats.org/officeDocument/2006/relationships/slide" Target="slides/slide4.xml"/><Relationship Id="rId20" Type="http://schemas.openxmlformats.org/officeDocument/2006/relationships/slide" Target="slides/slide5.xml"/><Relationship Id="rId21" Type="http://schemas.openxmlformats.org/officeDocument/2006/relationships/slide" Target="slides/slide6.xml"/><Relationship Id="rId22" Type="http://schemas.openxmlformats.org/officeDocument/2006/relationships/slide" Target="slides/slide7.xml"/><Relationship Id="rId23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14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3" name=""/>
          <p:cNvSpPr/>
          <p:nvPr/>
        </p:nvSpPr>
        <p:spPr>
          <a:xfrm>
            <a:off x="0" y="0"/>
            <a:ext cx="6735600" cy="9867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4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19240" cy="495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5" name="PlaceHolder 2"/>
          <p:cNvSpPr>
            <a:spLocks noGrp="1"/>
          </p:cNvSpPr>
          <p:nvPr>
            <p:ph type="dt" idx="40"/>
          </p:nvPr>
        </p:nvSpPr>
        <p:spPr>
          <a:xfrm>
            <a:off x="3814560" y="0"/>
            <a:ext cx="2919240" cy="495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6" name="PlaceHolder 3"/>
          <p:cNvSpPr>
            <a:spLocks noGrp="1"/>
          </p:cNvSpPr>
          <p:nvPr>
            <p:ph type="sldImg"/>
          </p:nvPr>
        </p:nvSpPr>
        <p:spPr>
          <a:xfrm>
            <a:off x="2119320" y="1233360"/>
            <a:ext cx="2496960" cy="333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7" name="PlaceHolder 4"/>
          <p:cNvSpPr>
            <a:spLocks noGrp="1"/>
          </p:cNvSpPr>
          <p:nvPr>
            <p:ph type="body"/>
          </p:nvPr>
        </p:nvSpPr>
        <p:spPr>
          <a:xfrm>
            <a:off x="674280" y="4747680"/>
            <a:ext cx="5388120" cy="38847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8" name="PlaceHolder 5"/>
          <p:cNvSpPr>
            <a:spLocks noGrp="1"/>
          </p:cNvSpPr>
          <p:nvPr>
            <p:ph type="ftr" idx="41"/>
          </p:nvPr>
        </p:nvSpPr>
        <p:spPr>
          <a:xfrm>
            <a:off x="-360" y="9370800"/>
            <a:ext cx="2919240" cy="49500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9" name="PlaceHolder 6"/>
          <p:cNvSpPr>
            <a:spLocks noGrp="1"/>
          </p:cNvSpPr>
          <p:nvPr>
            <p:ph type="sldNum" idx="42"/>
          </p:nvPr>
        </p:nvSpPr>
        <p:spPr>
          <a:xfrm>
            <a:off x="3814560" y="9370800"/>
            <a:ext cx="2919240" cy="49500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6E0D87F-9C23-406B-948C-CFD94B89C235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2" name="PlaceHolder 1"/>
          <p:cNvSpPr>
            <a:spLocks noGrp="1"/>
          </p:cNvSpPr>
          <p:nvPr>
            <p:ph type="sldImg"/>
          </p:nvPr>
        </p:nvSpPr>
        <p:spPr>
          <a:xfrm>
            <a:off x="2119320" y="1233360"/>
            <a:ext cx="2496960" cy="3330720"/>
          </a:xfrm>
          <a:prstGeom prst="rect">
            <a:avLst/>
          </a:prstGeom>
          <a:ln w="0">
            <a:noFill/>
          </a:ln>
        </p:spPr>
      </p:sp>
      <p:sp>
        <p:nvSpPr>
          <p:cNvPr id="1033" name="PlaceHolder 2"/>
          <p:cNvSpPr>
            <a:spLocks noGrp="1"/>
          </p:cNvSpPr>
          <p:nvPr>
            <p:ph type="body"/>
          </p:nvPr>
        </p:nvSpPr>
        <p:spPr>
          <a:xfrm>
            <a:off x="674280" y="4747680"/>
            <a:ext cx="5388120" cy="3884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4" name="スライド番号プレースホルダー 3"/>
          <p:cNvSpPr/>
          <p:nvPr/>
        </p:nvSpPr>
        <p:spPr>
          <a:xfrm>
            <a:off x="3814920" y="9371160"/>
            <a:ext cx="2919240" cy="495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88E397A-ACAE-480C-BBB7-64924CB1549A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5" name="PlaceHolder 1"/>
          <p:cNvSpPr>
            <a:spLocks noGrp="1"/>
          </p:cNvSpPr>
          <p:nvPr>
            <p:ph type="sldImg"/>
          </p:nvPr>
        </p:nvSpPr>
        <p:spPr>
          <a:xfrm>
            <a:off x="2119320" y="1233360"/>
            <a:ext cx="2496960" cy="3330720"/>
          </a:xfrm>
          <a:prstGeom prst="rect">
            <a:avLst/>
          </a:prstGeom>
          <a:ln w="0">
            <a:noFill/>
          </a:ln>
        </p:spPr>
      </p:sp>
      <p:sp>
        <p:nvSpPr>
          <p:cNvPr id="1036" name="PlaceHolder 2"/>
          <p:cNvSpPr>
            <a:spLocks noGrp="1"/>
          </p:cNvSpPr>
          <p:nvPr>
            <p:ph type="body"/>
          </p:nvPr>
        </p:nvSpPr>
        <p:spPr>
          <a:xfrm>
            <a:off x="674280" y="4747680"/>
            <a:ext cx="5388120" cy="3884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7" name="スライド番号プレースホルダー 3"/>
          <p:cNvSpPr/>
          <p:nvPr/>
        </p:nvSpPr>
        <p:spPr>
          <a:xfrm>
            <a:off x="3814920" y="9371160"/>
            <a:ext cx="2919240" cy="495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E6B093E-3793-4BFE-8631-D0E7C2E3FC95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8" name="PlaceHolder 1"/>
          <p:cNvSpPr>
            <a:spLocks noGrp="1"/>
          </p:cNvSpPr>
          <p:nvPr>
            <p:ph type="sldImg"/>
          </p:nvPr>
        </p:nvSpPr>
        <p:spPr>
          <a:xfrm>
            <a:off x="2119320" y="1233360"/>
            <a:ext cx="2496960" cy="3330720"/>
          </a:xfrm>
          <a:prstGeom prst="rect">
            <a:avLst/>
          </a:prstGeom>
          <a:ln w="0">
            <a:noFill/>
          </a:ln>
        </p:spPr>
      </p:sp>
      <p:sp>
        <p:nvSpPr>
          <p:cNvPr id="1039" name="PlaceHolder 2"/>
          <p:cNvSpPr>
            <a:spLocks noGrp="1"/>
          </p:cNvSpPr>
          <p:nvPr>
            <p:ph type="body"/>
          </p:nvPr>
        </p:nvSpPr>
        <p:spPr>
          <a:xfrm>
            <a:off x="674280" y="4747680"/>
            <a:ext cx="5388120" cy="3884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0" name="スライド番号プレースホルダー 3"/>
          <p:cNvSpPr/>
          <p:nvPr/>
        </p:nvSpPr>
        <p:spPr>
          <a:xfrm>
            <a:off x="3814920" y="9371160"/>
            <a:ext cx="2919240" cy="495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09D5C31-BD02-4769-9730-CBFA3198BC11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1" name="PlaceHolder 1"/>
          <p:cNvSpPr>
            <a:spLocks noGrp="1"/>
          </p:cNvSpPr>
          <p:nvPr>
            <p:ph type="sldImg"/>
          </p:nvPr>
        </p:nvSpPr>
        <p:spPr>
          <a:xfrm>
            <a:off x="2119320" y="1233360"/>
            <a:ext cx="2496960" cy="3330720"/>
          </a:xfrm>
          <a:prstGeom prst="rect">
            <a:avLst/>
          </a:prstGeom>
          <a:ln w="0">
            <a:noFill/>
          </a:ln>
        </p:spPr>
      </p:sp>
      <p:sp>
        <p:nvSpPr>
          <p:cNvPr id="1042" name="PlaceHolder 2"/>
          <p:cNvSpPr>
            <a:spLocks noGrp="1"/>
          </p:cNvSpPr>
          <p:nvPr>
            <p:ph type="body"/>
          </p:nvPr>
        </p:nvSpPr>
        <p:spPr>
          <a:xfrm>
            <a:off x="674280" y="4747680"/>
            <a:ext cx="5388120" cy="3884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3" name="スライド番号プレースホルダー 3"/>
          <p:cNvSpPr/>
          <p:nvPr/>
        </p:nvSpPr>
        <p:spPr>
          <a:xfrm>
            <a:off x="3814920" y="9371160"/>
            <a:ext cx="2919240" cy="495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8C55190-558E-4587-A744-5F829C83A790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114C3A-7CB8-4778-BC14-23F6B9BC566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1A5BCB-4928-4B4E-8588-8A912079594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96243E9D-6E38-4A81-8191-2ECC506E431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32B8CCE5-52DD-4B59-8CAE-A36B7FFA08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1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A3573B7C-4381-4DE5-9EB4-72D10CA3AB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031CC40A-7F6B-4780-A2ED-C84ACB78BA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BF669F0C-EDC1-4777-85E8-23308DFE1E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FADFA084-76D7-4214-82CF-9D0E1F5563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FF0BA30A-9564-49DF-A6BB-CFC9312342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1BF993B6-0213-48F0-9B34-BA4EA3D2527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12617534-A21D-4914-97F2-4E020BA770E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40D47428-1B4D-4CE2-A542-7D87B048483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C03CFB-35FA-4613-A7F1-15A94ED78BA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6DDD572F-59D8-400D-8759-CF797D08E23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BF14B2BF-4FF9-4974-8310-669B0CB4DA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FC4C4D0A-9C51-42D9-A3FC-78DC425B147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1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CA3393AE-05D8-4EEA-B959-73C8A39BB72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2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96C6E889-7C90-432D-B7B7-F929E20601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3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30D44AF6-8D73-4953-821C-15CC35A918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098DA7B8-6C69-427B-8CAD-CB694DFF4A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1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74C40326-E4DF-4B92-9502-B8086AE1A9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B0C5C1FA-F402-4EF8-A794-694A8F608F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FFC2412F-12BD-4FD2-AC37-CF8770EE5B1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05DD9C-9FC8-41A0-ACAE-910753BD390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3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F68497E3-00CD-448F-901D-ACC7039E11D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E6E3DB53-ED21-42F2-A967-826B8AB496C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8220B6DF-FDB8-43AE-9A52-7466634845D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7F5B0D56-8116-49C3-B5FD-94F22976711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AF2D0DB7-8601-4287-96C1-044C5E87F3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3ACD6DEB-BE25-4D64-A4F2-792DC82BA8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3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0B497D49-D669-4256-B3ED-75E64A80D6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51045D1C-6800-4D39-A2D3-502E595FE1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7C69CA10-3256-4498-A1B2-F5609F0203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0859C281-672E-4DD7-83B2-4A34BC7A2A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F58C362-136A-48D6-B021-26E06BA293F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EBB418E9-CCC3-4AE1-BA0B-8D45AF50BEB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4BB3D445-B4DC-4D7C-B5E1-8F7E0CC50EF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6CA01BD5-23A8-4878-9D5B-354C649304A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2E3E2705-BC2F-42A8-9572-7973C593048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A5E46690-C1B4-4051-BE2C-16E7439E973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62687FA2-4498-4FF7-A905-88CC108BE87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78B2C258-4369-46EC-AE28-53919C2ACD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3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18362FA3-E0D1-4639-BAB9-E3D01AEA43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4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F7FF3298-7FA4-4B5A-A862-AA51AB9AB6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2769E0DC-FD2D-4E94-A196-4BF3AB61DD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65C64F3-CBC6-4CDF-86BE-3210D4255E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DCF828DD-83C6-4F2C-B855-EFF641DC54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3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A3E94D2A-BB32-4833-A171-2947805C4D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7BEBEFAE-8FD2-4A00-924D-FDEB30CA24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7A5DD669-35D9-4BBF-B117-85294738558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FC0FF3C8-2EF8-4C58-A898-ACD3008B10A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A72B101F-2A97-4CF3-A2C5-F1FAED629C6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C4DA5808-DCBB-4629-A8A9-356B3C2813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9013552D-6AD7-4463-A3FB-125CA18490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1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1D928964-5206-4C51-9809-E7B824DAF0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14540164-ED78-4518-AEC0-2AAEF8CC444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C3E3AEC-E68E-42E9-AF5D-BAB478EAE3E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5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53816363-5D9A-4E4F-9128-9ACC6F33AD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9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1E1FC9E5-A677-4150-AD8B-02993F2C70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DEA148F9-A66B-4614-9614-1A2964087A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D8AE21B7-BBB1-4CDF-A29A-B5762070E9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183CA043-9411-4D98-94C9-AB2DB037A0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1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7D369899-B0E4-43DD-958A-023E6329B3D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9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2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E8965889-01BA-4A3C-830C-8D02BB867A1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B9B5004-0362-411E-BF9B-6D0698C1F30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39D4241-5667-4DBB-9299-FA16047933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646D57A-131D-4E5B-834A-1831BEBEF5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74F02B7-97C7-4BCC-9A27-EA8EC8AA2A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C749F8-18BF-48E3-8BA1-235B73D1DD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32BAA2E-4BBE-49A3-B367-78526B0086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AB4637A-ADEA-4CBF-BA07-D1151FE351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DC1E8FD-298D-4E71-8A94-AEF25257AFE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9BD438A-F830-4E56-9EFA-F4818195C25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9EAB67E-BE87-47EC-ADC5-47D96EA48A7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BDC86FA6-3A8B-41B5-876A-0F0102693D6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9A9EBC5-E3C8-4EF2-8B3B-046EE3D513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212B9EB-F49F-4387-9B47-81D7A41D3CA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BB4A5FA-F162-4723-8FBB-2B5381B1F0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E11664F-E96F-4F9C-BB15-3DB6FF44CF7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70D56C-A55E-45E0-AB4D-7E650B8F77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B1DD1B08-7536-4623-B352-B6A8EC5C13B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C57C8DF-AE00-4F7D-8113-647AC77D60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D3878D37-0FE0-4762-8E12-DE637366E6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E5BF118D-9E54-442E-B649-22CB2116BD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933A758-21BD-4630-95B1-4D7C52416E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52EC1013-4007-4175-B0C9-3B5E1DC31BC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7286B31-C66F-41F6-8A3A-503509A088C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BEB4D83F-92C4-44B0-8DFA-CEF90B7C335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AB5130AD-238C-41AA-AFF5-E23A6C6067F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1E46A41B-6F87-47E4-A86B-6AB2CABD0F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2D46A5-A309-496B-998F-A295F51ACA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DF0CA37D-6A89-4983-A819-8BA43404A6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01AE2AA3-EE52-4C66-B745-6996D0632B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8C9328CC-0B2B-4B50-9FB3-8E09565E62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EFBA9481-CBF1-4D69-B4B5-9B5D0FA08D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1C6FCFAC-6460-4234-9254-FDEE727112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181D2A6F-5DAA-4D0B-9085-996EC8C303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E3B96E60-A764-4FA8-8CBC-640AE9A042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89E833FF-06C6-48E1-9282-A05BE8C2F40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F851A61C-6A59-4748-86F5-53776A284E1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A72709E3-5849-4633-B74E-82F33508601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53F3AB-8060-4B45-A4E6-9E1B0F4E86B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035AE1DE-5D21-4948-B151-B21AF72367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156CB1D8-2C81-47E4-882A-BDF972D8B8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CE6E2145-D4C1-4D3D-AFED-59E985D37A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D7DB82A0-070D-4BCA-9AD7-70EBBB86D03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1FC09450-BF77-4671-A40B-52828CA3B16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0D1757DC-DA64-4CFB-9408-FDF077517C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EE51B9E2-65FA-4F8B-B0CD-B306D0D2F9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7C313309-C5DE-4668-84DC-F7B9361A77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B50B4B3B-4826-49BF-A554-104D8F1A0A7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5C39058A-FEE7-476D-8565-64944D7C7D8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1C58BD-1CCE-4976-9ED6-E70ABF8AEC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6C25B052-1384-4275-B2B9-92E97B62E19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9606EEEE-C212-46C2-95DC-4DCC9A7005B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CDA04A1F-CEE1-41CB-B34D-C16F93C418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C0720379-B24B-414D-953B-629BD54FCC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23A37F14-540C-4719-BEBA-B7F33D7D8D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BFA0B53C-876A-4B61-AFEA-280E5A6638F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1E7DC659-E4DF-46BC-8010-371A355243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CC806470-4E27-40F2-99F5-963B96D8E3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0D9BE06C-DDEF-482E-9609-70CE03EA14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979C427A-BD89-406C-84A2-0579D5C234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7498C2-A4E0-4058-BFDB-781EE1740B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26572D51-4E38-4D4A-ABA1-54B271DD14F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26354457-55C3-427A-800A-4061693A42B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C0670C19-2983-4ED6-BAE7-3869A7FEAA5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8CABEA29-BFCF-44AF-BE6D-788912138E7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39D9048F-B0BF-4891-817D-292D3BE0B64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92D6C075-B0CD-4185-BCC6-CDB158F1DAF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29AFA431-3D3A-49D9-8251-EB761D55E9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1B8107D7-A6E7-4662-8CA3-0C339DF06A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9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BBFD724E-C894-4850-9C3B-6B166E6BF4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82FAB683-F424-47A4-854C-CC6B0A9C6E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D88EB4-2E09-4278-BFC0-D8B7AB2D54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895C2386-C9BF-4E58-980D-3E169B0E0F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E3556C9E-2540-4B56-BA4E-E5B9107958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EA349C4D-0158-4C88-8318-EC1DD789D1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B1853126-01AE-4AB3-9EE3-A753625486A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C6E14588-A307-4116-9379-13E9C43DDCB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C48F6F5E-3125-4BC9-821F-301778DA2AC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04A1313C-AF65-45C1-B6E6-7FE69852C1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01C1FC95-37A3-4349-A97B-5836832B32D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78F46E9F-9346-4C57-AE8F-ABDC18509F0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64066653-908D-49B2-8809-F6139C6CBF9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3D950D-3066-4282-A893-2D7FF6151A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0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7E532F5E-8650-4726-B00E-EE307ABA7B5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1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FAF16713-742E-44B9-B452-39396409FC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08CF245F-21EA-4EC8-B940-1189589935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C6792A41-BC88-4735-A05C-4CA1FBB5AD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3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417A8DDC-E4E0-4A57-AEA4-B111AFD7C5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F2A34B76-1563-4223-BA27-81DF8469F84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7DC94BF0-E7F8-4DA6-B128-984A6BBB125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401570CB-CABA-47EA-AFCD-D16A703B6A8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3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9F30B248-1030-464A-B409-A5CB966F6E9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CA6FA6B3-79A1-41F8-B076-FAA30261F3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10.xml.rels><?xml version="1.0" encoding="UTF-8"?>
<Relationships xmlns="http://schemas.openxmlformats.org/package/2006/relationships"><Relationship Id="rId1" Type="http://schemas.openxmlformats.org/officeDocument/2006/relationships/theme" Target="../theme/theme10.xml"/><Relationship Id="rId2" Type="http://schemas.openxmlformats.org/officeDocument/2006/relationships/slideLayout" Target="../slideLayouts/slideLayout109.xml"/><Relationship Id="rId3" Type="http://schemas.openxmlformats.org/officeDocument/2006/relationships/slideLayout" Target="../slideLayouts/slideLayout110.xml"/><Relationship Id="rId4" Type="http://schemas.openxmlformats.org/officeDocument/2006/relationships/slideLayout" Target="../slideLayouts/slideLayout111.xml"/><Relationship Id="rId5" Type="http://schemas.openxmlformats.org/officeDocument/2006/relationships/slideLayout" Target="../slideLayouts/slideLayout112.xml"/><Relationship Id="rId6" Type="http://schemas.openxmlformats.org/officeDocument/2006/relationships/slideLayout" Target="../slideLayouts/slideLayout113.xml"/><Relationship Id="rId7" Type="http://schemas.openxmlformats.org/officeDocument/2006/relationships/slideLayout" Target="../slideLayouts/slideLayout114.xml"/><Relationship Id="rId8" Type="http://schemas.openxmlformats.org/officeDocument/2006/relationships/slideLayout" Target="../slideLayouts/slideLayout115.xml"/><Relationship Id="rId9" Type="http://schemas.openxmlformats.org/officeDocument/2006/relationships/slideLayout" Target="../slideLayouts/slideLayout116.xml"/><Relationship Id="rId10" Type="http://schemas.openxmlformats.org/officeDocument/2006/relationships/slideLayout" Target="../slideLayouts/slideLayout117.xml"/><Relationship Id="rId11" Type="http://schemas.openxmlformats.org/officeDocument/2006/relationships/slideLayout" Target="../slideLayouts/slideLayout118.xml"/><Relationship Id="rId12" Type="http://schemas.openxmlformats.org/officeDocument/2006/relationships/slideLayout" Target="../slideLayouts/slideLayout119.xml"/><Relationship Id="rId13" Type="http://schemas.openxmlformats.org/officeDocument/2006/relationships/slideLayout" Target="../slideLayouts/slideLayout120.xml"/>
</Relationships>
</file>

<file path=ppt/slideMasters/_rels/slideMaster11.xml.rels><?xml version="1.0" encoding="UTF-8"?>
<Relationships xmlns="http://schemas.openxmlformats.org/package/2006/relationships"><Relationship Id="rId1" Type="http://schemas.openxmlformats.org/officeDocument/2006/relationships/theme" Target="../theme/theme11.xml"/><Relationship Id="rId2" Type="http://schemas.openxmlformats.org/officeDocument/2006/relationships/slideLayout" Target="../slideLayouts/slideLayout121.xml"/><Relationship Id="rId3" Type="http://schemas.openxmlformats.org/officeDocument/2006/relationships/slideLayout" Target="../slideLayouts/slideLayout122.xml"/><Relationship Id="rId4" Type="http://schemas.openxmlformats.org/officeDocument/2006/relationships/slideLayout" Target="../slideLayouts/slideLayout123.xml"/><Relationship Id="rId5" Type="http://schemas.openxmlformats.org/officeDocument/2006/relationships/slideLayout" Target="../slideLayouts/slideLayout124.xml"/><Relationship Id="rId6" Type="http://schemas.openxmlformats.org/officeDocument/2006/relationships/slideLayout" Target="../slideLayouts/slideLayout125.xml"/><Relationship Id="rId7" Type="http://schemas.openxmlformats.org/officeDocument/2006/relationships/slideLayout" Target="../slideLayouts/slideLayout126.xml"/><Relationship Id="rId8" Type="http://schemas.openxmlformats.org/officeDocument/2006/relationships/slideLayout" Target="../slideLayouts/slideLayout127.xml"/><Relationship Id="rId9" Type="http://schemas.openxmlformats.org/officeDocument/2006/relationships/slideLayout" Target="../slideLayouts/slideLayout128.xml"/><Relationship Id="rId10" Type="http://schemas.openxmlformats.org/officeDocument/2006/relationships/slideLayout" Target="../slideLayouts/slideLayout129.xml"/><Relationship Id="rId11" Type="http://schemas.openxmlformats.org/officeDocument/2006/relationships/slideLayout" Target="../slideLayouts/slideLayout130.xml"/><Relationship Id="rId12" Type="http://schemas.openxmlformats.org/officeDocument/2006/relationships/slideLayout" Target="../slideLayouts/slideLayout131.xml"/><Relationship Id="rId13" Type="http://schemas.openxmlformats.org/officeDocument/2006/relationships/slideLayout" Target="../slideLayouts/slideLayout132.xml"/>
</Relationships>
</file>

<file path=ppt/slideMasters/_rels/slideMaster12.xml.rels><?xml version="1.0" encoding="UTF-8"?>
<Relationships xmlns="http://schemas.openxmlformats.org/package/2006/relationships"><Relationship Id="rId1" Type="http://schemas.openxmlformats.org/officeDocument/2006/relationships/theme" Target="../theme/theme12.xml"/><Relationship Id="rId2" Type="http://schemas.openxmlformats.org/officeDocument/2006/relationships/slideLayout" Target="../slideLayouts/slideLayout133.xml"/><Relationship Id="rId3" Type="http://schemas.openxmlformats.org/officeDocument/2006/relationships/slideLayout" Target="../slideLayouts/slideLayout134.xml"/><Relationship Id="rId4" Type="http://schemas.openxmlformats.org/officeDocument/2006/relationships/slideLayout" Target="../slideLayouts/slideLayout135.xml"/><Relationship Id="rId5" Type="http://schemas.openxmlformats.org/officeDocument/2006/relationships/slideLayout" Target="../slideLayouts/slideLayout136.xml"/><Relationship Id="rId6" Type="http://schemas.openxmlformats.org/officeDocument/2006/relationships/slideLayout" Target="../slideLayouts/slideLayout137.xml"/><Relationship Id="rId7" Type="http://schemas.openxmlformats.org/officeDocument/2006/relationships/slideLayout" Target="../slideLayouts/slideLayout138.xml"/><Relationship Id="rId8" Type="http://schemas.openxmlformats.org/officeDocument/2006/relationships/slideLayout" Target="../slideLayouts/slideLayout139.xml"/><Relationship Id="rId9" Type="http://schemas.openxmlformats.org/officeDocument/2006/relationships/slideLayout" Target="../slideLayouts/slideLayout140.xml"/><Relationship Id="rId10" Type="http://schemas.openxmlformats.org/officeDocument/2006/relationships/slideLayout" Target="../slideLayouts/slideLayout141.xml"/><Relationship Id="rId11" Type="http://schemas.openxmlformats.org/officeDocument/2006/relationships/slideLayout" Target="../slideLayouts/slideLayout142.xml"/><Relationship Id="rId12" Type="http://schemas.openxmlformats.org/officeDocument/2006/relationships/slideLayout" Target="../slideLayouts/slideLayout143.xml"/><Relationship Id="rId13" Type="http://schemas.openxmlformats.org/officeDocument/2006/relationships/slideLayout" Target="../slideLayouts/slideLayout144.xml"/>
</Relationships>
</file>

<file path=ppt/slideMasters/_rels/slideMaster13.xml.rels><?xml version="1.0" encoding="UTF-8"?>
<Relationships xmlns="http://schemas.openxmlformats.org/package/2006/relationships"><Relationship Id="rId1" Type="http://schemas.openxmlformats.org/officeDocument/2006/relationships/theme" Target="../theme/theme13.xml"/><Relationship Id="rId2" Type="http://schemas.openxmlformats.org/officeDocument/2006/relationships/slideLayout" Target="../slideLayouts/slideLayout145.xml"/><Relationship Id="rId3" Type="http://schemas.openxmlformats.org/officeDocument/2006/relationships/slideLayout" Target="../slideLayouts/slideLayout146.xml"/><Relationship Id="rId4" Type="http://schemas.openxmlformats.org/officeDocument/2006/relationships/slideLayout" Target="../slideLayouts/slideLayout147.xml"/><Relationship Id="rId5" Type="http://schemas.openxmlformats.org/officeDocument/2006/relationships/slideLayout" Target="../slideLayouts/slideLayout148.xml"/><Relationship Id="rId6" Type="http://schemas.openxmlformats.org/officeDocument/2006/relationships/slideLayout" Target="../slideLayouts/slideLayout149.xml"/><Relationship Id="rId7" Type="http://schemas.openxmlformats.org/officeDocument/2006/relationships/slideLayout" Target="../slideLayouts/slideLayout150.xml"/><Relationship Id="rId8" Type="http://schemas.openxmlformats.org/officeDocument/2006/relationships/slideLayout" Target="../slideLayouts/slideLayout151.xml"/><Relationship Id="rId9" Type="http://schemas.openxmlformats.org/officeDocument/2006/relationships/slideLayout" Target="../slideLayouts/slideLayout152.xml"/><Relationship Id="rId10" Type="http://schemas.openxmlformats.org/officeDocument/2006/relationships/slideLayout" Target="../slideLayouts/slideLayout153.xml"/><Relationship Id="rId11" Type="http://schemas.openxmlformats.org/officeDocument/2006/relationships/slideLayout" Target="../slideLayouts/slideLayout154.xml"/><Relationship Id="rId12" Type="http://schemas.openxmlformats.org/officeDocument/2006/relationships/slideLayout" Target="../slideLayouts/slideLayout155.xml"/><Relationship Id="rId13" Type="http://schemas.openxmlformats.org/officeDocument/2006/relationships/slideLayout" Target="../slideLayouts/slideLayout156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slideLayout" Target="../slideLayouts/slideLayout85.xml"/><Relationship Id="rId3" Type="http://schemas.openxmlformats.org/officeDocument/2006/relationships/slideLayout" Target="../slideLayouts/slideLayout86.xml"/><Relationship Id="rId4" Type="http://schemas.openxmlformats.org/officeDocument/2006/relationships/slideLayout" Target="../slideLayouts/slideLayout87.xml"/><Relationship Id="rId5" Type="http://schemas.openxmlformats.org/officeDocument/2006/relationships/slideLayout" Target="../slideLayouts/slideLayout88.xml"/><Relationship Id="rId6" Type="http://schemas.openxmlformats.org/officeDocument/2006/relationships/slideLayout" Target="../slideLayouts/slideLayout89.xml"/><Relationship Id="rId7" Type="http://schemas.openxmlformats.org/officeDocument/2006/relationships/slideLayout" Target="../slideLayouts/slideLayout90.xml"/><Relationship Id="rId8" Type="http://schemas.openxmlformats.org/officeDocument/2006/relationships/slideLayout" Target="../slideLayouts/slideLayout91.xml"/><Relationship Id="rId9" Type="http://schemas.openxmlformats.org/officeDocument/2006/relationships/slideLayout" Target="../slideLayouts/slideLayout92.xml"/><Relationship Id="rId10" Type="http://schemas.openxmlformats.org/officeDocument/2006/relationships/slideLayout" Target="../slideLayouts/slideLayout93.xml"/><Relationship Id="rId11" Type="http://schemas.openxmlformats.org/officeDocument/2006/relationships/slideLayout" Target="../slideLayouts/slideLayout94.xml"/><Relationship Id="rId12" Type="http://schemas.openxmlformats.org/officeDocument/2006/relationships/slideLayout" Target="../slideLayouts/slideLayout95.xml"/><Relationship Id="rId13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slideLayout" Target="../slideLayouts/slideLayout97.xml"/><Relationship Id="rId3" Type="http://schemas.openxmlformats.org/officeDocument/2006/relationships/slideLayout" Target="../slideLayouts/slideLayout98.xml"/><Relationship Id="rId4" Type="http://schemas.openxmlformats.org/officeDocument/2006/relationships/slideLayout" Target="../slideLayouts/slideLayout99.xml"/><Relationship Id="rId5" Type="http://schemas.openxmlformats.org/officeDocument/2006/relationships/slideLayout" Target="../slideLayouts/slideLayout100.xml"/><Relationship Id="rId6" Type="http://schemas.openxmlformats.org/officeDocument/2006/relationships/slideLayout" Target="../slideLayouts/slideLayout101.xml"/><Relationship Id="rId7" Type="http://schemas.openxmlformats.org/officeDocument/2006/relationships/slideLayout" Target="../slideLayouts/slideLayout102.xml"/><Relationship Id="rId8" Type="http://schemas.openxmlformats.org/officeDocument/2006/relationships/slideLayout" Target="../slideLayouts/slideLayout103.xml"/><Relationship Id="rId9" Type="http://schemas.openxmlformats.org/officeDocument/2006/relationships/slideLayout" Target="../slideLayouts/slideLayout104.xml"/><Relationship Id="rId10" Type="http://schemas.openxmlformats.org/officeDocument/2006/relationships/slideLayout" Target="../slideLayouts/slideLayout105.xml"/><Relationship Id="rId11" Type="http://schemas.openxmlformats.org/officeDocument/2006/relationships/slideLayout" Target="../slideLayouts/slideLayout106.xml"/><Relationship Id="rId12" Type="http://schemas.openxmlformats.org/officeDocument/2006/relationships/slideLayout" Target="../slideLayouts/slideLayout107.xml"/><Relationship Id="rId13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C12DFD0-DAE0-4E8E-AFE7-FA792DAD880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1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PlaceHolder 3"/>
          <p:cNvSpPr>
            <a:spLocks noGrp="1"/>
          </p:cNvSpPr>
          <p:nvPr>
            <p:ph type="dt" idx="28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Arial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PlaceHolder 4"/>
          <p:cNvSpPr>
            <a:spLocks noGrp="1"/>
          </p:cNvSpPr>
          <p:nvPr>
            <p:ph type="ftr" idx="29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PlaceHolder 5"/>
          <p:cNvSpPr>
            <a:spLocks noGrp="1"/>
          </p:cNvSpPr>
          <p:nvPr>
            <p:ph type="sldNum" idx="30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A9E8469-C156-42EC-93EA-A1A01B3058E7}" type="slidenum">
              <a:rPr b="0" lang="ja-JP" sz="9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66" r:id="rId2"/>
    <p:sldLayoutId id="2147483767" r:id="rId3"/>
    <p:sldLayoutId id="2147483768" r:id="rId4"/>
    <p:sldLayoutId id="2147483769" r:id="rId5"/>
    <p:sldLayoutId id="2147483770" r:id="rId6"/>
    <p:sldLayoutId id="2147483771" r:id="rId7"/>
    <p:sldLayoutId id="2147483772" r:id="rId8"/>
    <p:sldLayoutId id="2147483773" r:id="rId9"/>
    <p:sldLayoutId id="2147483774" r:id="rId10"/>
    <p:sldLayoutId id="2147483775" r:id="rId11"/>
    <p:sldLayoutId id="2147483776" r:id="rId12"/>
    <p:sldLayoutId id="2147483777" r:id="rId13"/>
  </p:sldLayoutIdLst>
</p:sldMaster>
</file>

<file path=ppt/slideMasters/slideMaster1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PlaceHolder 3"/>
          <p:cNvSpPr>
            <a:spLocks noGrp="1"/>
          </p:cNvSpPr>
          <p:nvPr>
            <p:ph type="dt" idx="31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Arial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PlaceHolder 4"/>
          <p:cNvSpPr>
            <a:spLocks noGrp="1"/>
          </p:cNvSpPr>
          <p:nvPr>
            <p:ph type="ftr" idx="32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PlaceHolder 5"/>
          <p:cNvSpPr>
            <a:spLocks noGrp="1"/>
          </p:cNvSpPr>
          <p:nvPr>
            <p:ph type="sldNum" idx="33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1572E9D-2874-4398-9EBE-DAB807992BBE}" type="slidenum">
              <a:rPr b="0" lang="ja-JP" sz="9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79" r:id="rId2"/>
    <p:sldLayoutId id="2147483780" r:id="rId3"/>
    <p:sldLayoutId id="2147483781" r:id="rId4"/>
    <p:sldLayoutId id="2147483782" r:id="rId5"/>
    <p:sldLayoutId id="2147483783" r:id="rId6"/>
    <p:sldLayoutId id="2147483784" r:id="rId7"/>
    <p:sldLayoutId id="2147483785" r:id="rId8"/>
    <p:sldLayoutId id="2147483786" r:id="rId9"/>
    <p:sldLayoutId id="2147483787" r:id="rId10"/>
    <p:sldLayoutId id="2147483788" r:id="rId11"/>
    <p:sldLayoutId id="2147483789" r:id="rId12"/>
    <p:sldLayoutId id="2147483790" r:id="rId13"/>
  </p:sldLayoutIdLst>
</p:sldMaster>
</file>

<file path=ppt/slideMasters/slideMaster1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1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PlaceHolder 3"/>
          <p:cNvSpPr>
            <a:spLocks noGrp="1"/>
          </p:cNvSpPr>
          <p:nvPr>
            <p:ph type="dt" idx="34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Arial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PlaceHolder 4"/>
          <p:cNvSpPr>
            <a:spLocks noGrp="1"/>
          </p:cNvSpPr>
          <p:nvPr>
            <p:ph type="ftr" idx="35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PlaceHolder 5"/>
          <p:cNvSpPr>
            <a:spLocks noGrp="1"/>
          </p:cNvSpPr>
          <p:nvPr>
            <p:ph type="sldNum" idx="36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7CFACA2-8169-41C5-9EA7-43B2EF4A6B41}" type="slidenum">
              <a:rPr b="0" lang="ja-JP" sz="9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92" r:id="rId2"/>
    <p:sldLayoutId id="2147483793" r:id="rId3"/>
    <p:sldLayoutId id="2147483794" r:id="rId4"/>
    <p:sldLayoutId id="2147483795" r:id="rId5"/>
    <p:sldLayoutId id="2147483796" r:id="rId6"/>
    <p:sldLayoutId id="2147483797" r:id="rId7"/>
    <p:sldLayoutId id="2147483798" r:id="rId8"/>
    <p:sldLayoutId id="2147483799" r:id="rId9"/>
    <p:sldLayoutId id="2147483800" r:id="rId10"/>
    <p:sldLayoutId id="2147483801" r:id="rId11"/>
    <p:sldLayoutId id="2147483802" r:id="rId12"/>
    <p:sldLayoutId id="2147483803" r:id="rId13"/>
  </p:sldLayoutIdLst>
</p:sldMaster>
</file>

<file path=ppt/slideMasters/slideMaster1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PlaceHolder 3"/>
          <p:cNvSpPr>
            <a:spLocks noGrp="1"/>
          </p:cNvSpPr>
          <p:nvPr>
            <p:ph type="dt" idx="37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Arial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5" name="PlaceHolder 4"/>
          <p:cNvSpPr>
            <a:spLocks noGrp="1"/>
          </p:cNvSpPr>
          <p:nvPr>
            <p:ph type="ftr" idx="38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PlaceHolder 5"/>
          <p:cNvSpPr>
            <a:spLocks noGrp="1"/>
          </p:cNvSpPr>
          <p:nvPr>
            <p:ph type="sldNum" idx="39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32A3FC1-940A-4FB8-B89D-A8B1D905DE4E}" type="slidenum">
              <a:rPr b="0" lang="ja-JP" sz="9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05" r:id="rId2"/>
    <p:sldLayoutId id="2147483806" r:id="rId3"/>
    <p:sldLayoutId id="2147483807" r:id="rId4"/>
    <p:sldLayoutId id="2147483808" r:id="rId5"/>
    <p:sldLayoutId id="2147483809" r:id="rId6"/>
    <p:sldLayoutId id="2147483810" r:id="rId7"/>
    <p:sldLayoutId id="2147483811" r:id="rId8"/>
    <p:sldLayoutId id="2147483812" r:id="rId9"/>
    <p:sldLayoutId id="2147483813" r:id="rId10"/>
    <p:sldLayoutId id="2147483814" r:id="rId11"/>
    <p:sldLayoutId id="2147483815" r:id="rId12"/>
    <p:sldLayoutId id="2147483816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Arial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6898F33-8B22-4897-ADFB-77AAF3FA71AD}" type="slidenum">
              <a:rPr b="0" lang="ja-JP" sz="9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 type="dt" idx="7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Arial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PlaceHolder 4"/>
          <p:cNvSpPr>
            <a:spLocks noGrp="1"/>
          </p:cNvSpPr>
          <p:nvPr>
            <p:ph type="ftr" idx="8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PlaceHolder 5"/>
          <p:cNvSpPr>
            <a:spLocks noGrp="1"/>
          </p:cNvSpPr>
          <p:nvPr>
            <p:ph type="sldNum" idx="9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71BDF49-F5A4-4AA4-993A-D62D9A335AD6}" type="slidenum">
              <a:rPr b="0" lang="ja-JP" sz="9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PlaceHolder 3"/>
          <p:cNvSpPr>
            <a:spLocks noGrp="1"/>
          </p:cNvSpPr>
          <p:nvPr>
            <p:ph type="dt" idx="10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Arial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PlaceHolder 4"/>
          <p:cNvSpPr>
            <a:spLocks noGrp="1"/>
          </p:cNvSpPr>
          <p:nvPr>
            <p:ph type="ftr" idx="11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PlaceHolder 5"/>
          <p:cNvSpPr>
            <a:spLocks noGrp="1"/>
          </p:cNvSpPr>
          <p:nvPr>
            <p:ph type="sldNum" idx="12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0F41B4F-79E2-4631-92C1-2C83615161AA}" type="slidenum">
              <a:rPr b="0" lang="ja-JP" sz="9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PlaceHolder 3"/>
          <p:cNvSpPr>
            <a:spLocks noGrp="1"/>
          </p:cNvSpPr>
          <p:nvPr>
            <p:ph type="dt" idx="13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Arial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PlaceHolder 4"/>
          <p:cNvSpPr>
            <a:spLocks noGrp="1"/>
          </p:cNvSpPr>
          <p:nvPr>
            <p:ph type="ftr" idx="14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PlaceHolder 5"/>
          <p:cNvSpPr>
            <a:spLocks noGrp="1"/>
          </p:cNvSpPr>
          <p:nvPr>
            <p:ph type="sldNum" idx="15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21DCEB0-F0AA-48F4-B1DE-40904CCD683E}" type="slidenum">
              <a:rPr b="0" lang="ja-JP" sz="9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PlaceHolder 3"/>
          <p:cNvSpPr>
            <a:spLocks noGrp="1"/>
          </p:cNvSpPr>
          <p:nvPr>
            <p:ph type="dt" idx="16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Arial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PlaceHolder 4"/>
          <p:cNvSpPr>
            <a:spLocks noGrp="1"/>
          </p:cNvSpPr>
          <p:nvPr>
            <p:ph type="ftr" idx="17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PlaceHolder 5"/>
          <p:cNvSpPr>
            <a:spLocks noGrp="1"/>
          </p:cNvSpPr>
          <p:nvPr>
            <p:ph type="sldNum" idx="18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AEE2C75-36BE-46A6-8BD6-1389F8908B70}" type="slidenum">
              <a:rPr b="0" lang="ja-JP" sz="9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PlaceHolder 3"/>
          <p:cNvSpPr>
            <a:spLocks noGrp="1"/>
          </p:cNvSpPr>
          <p:nvPr>
            <p:ph type="dt" idx="19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Arial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PlaceHolder 4"/>
          <p:cNvSpPr>
            <a:spLocks noGrp="1"/>
          </p:cNvSpPr>
          <p:nvPr>
            <p:ph type="ftr" idx="20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PlaceHolder 5"/>
          <p:cNvSpPr>
            <a:spLocks noGrp="1"/>
          </p:cNvSpPr>
          <p:nvPr>
            <p:ph type="sldNum" idx="21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012AF86-E203-4855-8357-41028BF70D26}" type="slidenum">
              <a:rPr b="0" lang="ja-JP" sz="9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PlaceHolder 3"/>
          <p:cNvSpPr>
            <a:spLocks noGrp="1"/>
          </p:cNvSpPr>
          <p:nvPr>
            <p:ph type="dt" idx="22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Arial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PlaceHolder 4"/>
          <p:cNvSpPr>
            <a:spLocks noGrp="1"/>
          </p:cNvSpPr>
          <p:nvPr>
            <p:ph type="ftr" idx="23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PlaceHolder 5"/>
          <p:cNvSpPr>
            <a:spLocks noGrp="1"/>
          </p:cNvSpPr>
          <p:nvPr>
            <p:ph type="sldNum" idx="24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F9FD7DE-4B3A-42F0-B25E-C952DF7C9AA9}" type="slidenum">
              <a:rPr b="0" lang="ja-JP" sz="9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50" r:id="rId12"/>
    <p:sldLayoutId id="2147483751" r:id="rId13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PlaceHolder 3"/>
          <p:cNvSpPr>
            <a:spLocks noGrp="1"/>
          </p:cNvSpPr>
          <p:nvPr>
            <p:ph type="dt" idx="25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Arial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PlaceHolder 4"/>
          <p:cNvSpPr>
            <a:spLocks noGrp="1"/>
          </p:cNvSpPr>
          <p:nvPr>
            <p:ph type="ftr" idx="26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PlaceHolder 5"/>
          <p:cNvSpPr>
            <a:spLocks noGrp="1"/>
          </p:cNvSpPr>
          <p:nvPr>
            <p:ph type="sldNum" idx="27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0115345-A70C-4116-B926-A67A2C9A103E}" type="slidenum">
              <a:rPr b="0" lang="ja-JP" sz="9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2"/>
    <p:sldLayoutId id="2147483754" r:id="rId3"/>
    <p:sldLayoutId id="2147483755" r:id="rId4"/>
    <p:sldLayoutId id="2147483756" r:id="rId5"/>
    <p:sldLayoutId id="2147483757" r:id="rId6"/>
    <p:sldLayoutId id="2147483758" r:id="rId7"/>
    <p:sldLayoutId id="2147483759" r:id="rId8"/>
    <p:sldLayoutId id="2147483760" r:id="rId9"/>
    <p:sldLayoutId id="2147483761" r:id="rId10"/>
    <p:sldLayoutId id="2147483762" r:id="rId11"/>
    <p:sldLayoutId id="2147483763" r:id="rId12"/>
    <p:sldLayoutId id="2147483764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image" Target="../media/image7.png"/><Relationship Id="rId8" Type="http://schemas.openxmlformats.org/officeDocument/2006/relationships/image" Target="../media/image8.jpeg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5" Type="http://schemas.openxmlformats.org/officeDocument/2006/relationships/image" Target="../media/image13.png"/><Relationship Id="rId6" Type="http://schemas.openxmlformats.org/officeDocument/2006/relationships/image" Target="../media/image14.png"/><Relationship Id="rId7" Type="http://schemas.openxmlformats.org/officeDocument/2006/relationships/image" Target="../media/image15.png"/><Relationship Id="rId8" Type="http://schemas.openxmlformats.org/officeDocument/2006/relationships/image" Target="../media/image16.png"/><Relationship Id="rId9" Type="http://schemas.openxmlformats.org/officeDocument/2006/relationships/image" Target="../media/image17.png"/><Relationship Id="rId10" Type="http://schemas.openxmlformats.org/officeDocument/2006/relationships/image" Target="../media/image18.png"/><Relationship Id="rId11" Type="http://schemas.openxmlformats.org/officeDocument/2006/relationships/image" Target="../media/image19.png"/><Relationship Id="rId12" Type="http://schemas.openxmlformats.org/officeDocument/2006/relationships/image" Target="../media/image20.png"/><Relationship Id="rId1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1.jpeg"/><Relationship Id="rId2" Type="http://schemas.openxmlformats.org/officeDocument/2006/relationships/image" Target="../media/image22.jpeg"/><Relationship Id="rId3" Type="http://schemas.openxmlformats.org/officeDocument/2006/relationships/image" Target="../media/image23.jpeg"/><Relationship Id="rId4" Type="http://schemas.openxmlformats.org/officeDocument/2006/relationships/image" Target="../media/image24.png"/><Relationship Id="rId5" Type="http://schemas.openxmlformats.org/officeDocument/2006/relationships/image" Target="../media/image25.png"/><Relationship Id="rId6" Type="http://schemas.openxmlformats.org/officeDocument/2006/relationships/image" Target="../media/image26.png"/><Relationship Id="rId7" Type="http://schemas.openxmlformats.org/officeDocument/2006/relationships/image" Target="../media/image27.png"/><Relationship Id="rId8" Type="http://schemas.openxmlformats.org/officeDocument/2006/relationships/image" Target="../media/image28.png"/><Relationship Id="rId9" Type="http://schemas.openxmlformats.org/officeDocument/2006/relationships/image" Target="../media/image29.png"/><Relationship Id="rId10" Type="http://schemas.openxmlformats.org/officeDocument/2006/relationships/slideLayout" Target="../slideLayouts/slideLayout1.xml"/><Relationship Id="rId11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0.png"/><Relationship Id="rId2" Type="http://schemas.openxmlformats.org/officeDocument/2006/relationships/image" Target="../media/image31.png"/><Relationship Id="rId3" Type="http://schemas.openxmlformats.org/officeDocument/2006/relationships/image" Target="../media/image32.png"/><Relationship Id="rId4" Type="http://schemas.openxmlformats.org/officeDocument/2006/relationships/image" Target="../media/image33.png"/><Relationship Id="rId5" Type="http://schemas.openxmlformats.org/officeDocument/2006/relationships/image" Target="../media/image34.png"/><Relationship Id="rId6" Type="http://schemas.openxmlformats.org/officeDocument/2006/relationships/image" Target="../media/image35.png"/><Relationship Id="rId7" Type="http://schemas.openxmlformats.org/officeDocument/2006/relationships/image" Target="../media/image36.png"/><Relationship Id="rId8" Type="http://schemas.openxmlformats.org/officeDocument/2006/relationships/image" Target="../media/image37.png"/><Relationship Id="rId9" Type="http://schemas.openxmlformats.org/officeDocument/2006/relationships/image" Target="../media/image38.png"/><Relationship Id="rId10" Type="http://schemas.openxmlformats.org/officeDocument/2006/relationships/image" Target="../media/image39.png"/><Relationship Id="rId11" Type="http://schemas.openxmlformats.org/officeDocument/2006/relationships/image" Target="../media/image40.png"/><Relationship Id="rId12" Type="http://schemas.openxmlformats.org/officeDocument/2006/relationships/image" Target="../media/image41.png"/><Relationship Id="rId13" Type="http://schemas.openxmlformats.org/officeDocument/2006/relationships/image" Target="../media/image42.png"/><Relationship Id="rId14" Type="http://schemas.openxmlformats.org/officeDocument/2006/relationships/image" Target="../media/image43.png"/><Relationship Id="rId15" Type="http://schemas.openxmlformats.org/officeDocument/2006/relationships/slideLayout" Target="../slideLayouts/slideLayout97.xml"/><Relationship Id="rId16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4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5.jpeg"/><Relationship Id="rId2" Type="http://schemas.openxmlformats.org/officeDocument/2006/relationships/image" Target="../media/image46.jpeg"/><Relationship Id="rId3" Type="http://schemas.openxmlformats.org/officeDocument/2006/relationships/image" Target="../media/image47.jpeg"/><Relationship Id="rId4" Type="http://schemas.openxmlformats.org/officeDocument/2006/relationships/image" Target="../media/image48.jpeg"/><Relationship Id="rId5" Type="http://schemas.openxmlformats.org/officeDocument/2006/relationships/image" Target="../media/image49.jpeg"/><Relationship Id="rId6" Type="http://schemas.openxmlformats.org/officeDocument/2006/relationships/image" Target="../media/image50.jpeg"/><Relationship Id="rId7" Type="http://schemas.openxmlformats.org/officeDocument/2006/relationships/image" Target="../media/image51.jpeg"/><Relationship Id="rId8" Type="http://schemas.openxmlformats.org/officeDocument/2006/relationships/image" Target="../media/image52.jpeg"/><Relationship Id="rId9" Type="http://schemas.openxmlformats.org/officeDocument/2006/relationships/image" Target="../media/image53.jpeg"/><Relationship Id="rId10" Type="http://schemas.openxmlformats.org/officeDocument/2006/relationships/image" Target="../media/image54.jpeg"/><Relationship Id="rId11" Type="http://schemas.openxmlformats.org/officeDocument/2006/relationships/image" Target="../media/image55.jpeg"/><Relationship Id="rId12" Type="http://schemas.openxmlformats.org/officeDocument/2006/relationships/image" Target="../media/image56.jpeg"/><Relationship Id="rId13" Type="http://schemas.openxmlformats.org/officeDocument/2006/relationships/image" Target="../media/image57.jpeg"/><Relationship Id="rId14" Type="http://schemas.openxmlformats.org/officeDocument/2006/relationships/image" Target="../media/image58.jpeg"/><Relationship Id="rId15" Type="http://schemas.openxmlformats.org/officeDocument/2006/relationships/image" Target="../media/image59.jpeg"/><Relationship Id="rId16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60.jpeg"/><Relationship Id="rId2" Type="http://schemas.openxmlformats.org/officeDocument/2006/relationships/image" Target="../media/image61.jpeg"/><Relationship Id="rId3" Type="http://schemas.openxmlformats.org/officeDocument/2006/relationships/image" Target="../media/image62.jpeg"/><Relationship Id="rId4" Type="http://schemas.openxmlformats.org/officeDocument/2006/relationships/image" Target="../media/image63.jpeg"/><Relationship Id="rId5" Type="http://schemas.openxmlformats.org/officeDocument/2006/relationships/image" Target="../media/image64.jpeg"/><Relationship Id="rId6" Type="http://schemas.openxmlformats.org/officeDocument/2006/relationships/image" Target="../media/image65.jpeg"/><Relationship Id="rId7" Type="http://schemas.openxmlformats.org/officeDocument/2006/relationships/image" Target="../media/image66.jpeg"/><Relationship Id="rId8" Type="http://schemas.openxmlformats.org/officeDocument/2006/relationships/image" Target="../media/image67.jpeg"/><Relationship Id="rId9" Type="http://schemas.openxmlformats.org/officeDocument/2006/relationships/image" Target="../media/image68.jpeg"/><Relationship Id="rId10" Type="http://schemas.openxmlformats.org/officeDocument/2006/relationships/image" Target="../media/image69.png"/><Relationship Id="rId11" Type="http://schemas.openxmlformats.org/officeDocument/2006/relationships/image" Target="../media/image70.png"/><Relationship Id="rId12" Type="http://schemas.openxmlformats.org/officeDocument/2006/relationships/image" Target="../media/image71.png"/><Relationship Id="rId13" Type="http://schemas.openxmlformats.org/officeDocument/2006/relationships/image" Target="../media/image72.png"/><Relationship Id="rId14" Type="http://schemas.openxmlformats.org/officeDocument/2006/relationships/image" Target="../media/image73.png"/><Relationship Id="rId15" Type="http://schemas.openxmlformats.org/officeDocument/2006/relationships/image" Target="../media/image74.jpeg"/><Relationship Id="rId16" Type="http://schemas.openxmlformats.org/officeDocument/2006/relationships/slideLayout" Target="../slideLayouts/slideLayout97.xml"/><Relationship Id="rId17" Type="http://schemas.openxmlformats.org/officeDocument/2006/relationships/notesSlide" Target="../notesSlides/notesSlide7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40" name="グループ化 1"/>
          <p:cNvGrpSpPr/>
          <p:nvPr/>
        </p:nvGrpSpPr>
        <p:grpSpPr>
          <a:xfrm>
            <a:off x="227160" y="736560"/>
            <a:ext cx="2874960" cy="4565520"/>
            <a:chOff x="227160" y="736560"/>
            <a:chExt cx="2874960" cy="4565520"/>
          </a:xfrm>
        </p:grpSpPr>
        <p:pic>
          <p:nvPicPr>
            <p:cNvPr id="541" name="Picture 11" descr="D:\工藤論文\130222 マイクロアレイ\再解析後\Ad 0.3 lo new"/>
            <p:cNvPicPr/>
            <p:nvPr/>
          </p:nvPicPr>
          <p:blipFill>
            <a:blip r:embed="rId1"/>
            <a:srcRect l="0" t="0" r="0" b="39576"/>
            <a:stretch/>
          </p:blipFill>
          <p:spPr>
            <a:xfrm rot="16200000">
              <a:off x="-346680" y="1310760"/>
              <a:ext cx="2942280" cy="1793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2" name="Picture 10" descr="D:\工藤論文\130222 マイクロアレイ\再解析後\Ad 3 hi"/>
            <p:cNvPicPr/>
            <p:nvPr/>
          </p:nvPicPr>
          <p:blipFill>
            <a:blip r:embed="rId2"/>
            <a:srcRect l="0" t="0" r="0" b="47498"/>
            <a:stretch/>
          </p:blipFill>
          <p:spPr>
            <a:xfrm rot="16200000">
              <a:off x="44280" y="2244240"/>
              <a:ext cx="4557600" cy="15580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543" name="Text Box 4"/>
          <p:cNvSpPr/>
          <p:nvPr/>
        </p:nvSpPr>
        <p:spPr>
          <a:xfrm>
            <a:off x="260280" y="5950080"/>
            <a:ext cx="3033720" cy="1769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, related to Figure 1. Additional data for characterization of ES-SC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 Heat maps from microarray analysis between ES-DCs and ES-SCs. (B-D) Gene expression analysis by microarray data between ES-SCs and ES-DCs were shown in scatter plots and heat maps. The expression of genes related to immunosuppressive function (B), house keeping (C) and T cell activation (D) was plotted according to its signal intensity. Dotted line is an auxiliary, indicates same expression level between ES-SCs and ES-DC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44" name="グループ化 93"/>
          <p:cNvGrpSpPr/>
          <p:nvPr/>
        </p:nvGrpSpPr>
        <p:grpSpPr>
          <a:xfrm>
            <a:off x="5826240" y="763560"/>
            <a:ext cx="662040" cy="2046240"/>
            <a:chOff x="5826240" y="763560"/>
            <a:chExt cx="662040" cy="2046240"/>
          </a:xfrm>
        </p:grpSpPr>
        <p:pic>
          <p:nvPicPr>
            <p:cNvPr id="545" name="図 87" descr=""/>
            <p:cNvPicPr/>
            <p:nvPr/>
          </p:nvPicPr>
          <p:blipFill>
            <a:blip r:embed="rId3"/>
            <a:stretch/>
          </p:blipFill>
          <p:spPr>
            <a:xfrm>
              <a:off x="5826240" y="763560"/>
              <a:ext cx="662040" cy="2046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6" name="正方形/長方形 26"/>
            <p:cNvSpPr/>
            <p:nvPr/>
          </p:nvSpPr>
          <p:spPr>
            <a:xfrm>
              <a:off x="5843520" y="811080"/>
              <a:ext cx="304920" cy="8856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68760" rIns="68760" tIns="34200" bIns="34200" anchor="ctr">
              <a:noAutofit/>
            </a:bodyPr>
            <a:p>
              <a:pPr algn="ctr">
                <a:tabLst>
                  <a:tab algn="l" pos="0"/>
                  <a:tab algn="l" pos="717480"/>
                  <a:tab algn="l" pos="1434960"/>
                  <a:tab algn="l" pos="2152800"/>
                  <a:tab algn="l" pos="2870280"/>
                  <a:tab algn="l" pos="3587760"/>
                  <a:tab algn="l" pos="4305240"/>
                  <a:tab algn="l" pos="5022720"/>
                  <a:tab algn="l" pos="5740560"/>
                  <a:tab algn="l" pos="6458040"/>
                  <a:tab algn="l" pos="7175520"/>
                  <a:tab algn="l" pos="7893000"/>
                  <a:tab algn="l" pos="8610480"/>
                  <a:tab algn="l" pos="9328320"/>
                  <a:tab algn="l" pos="10045800"/>
                  <a:tab algn="l" pos="1076328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47" name="テキスト ボックス 27"/>
          <p:cNvSpPr/>
          <p:nvPr/>
        </p:nvSpPr>
        <p:spPr>
          <a:xfrm rot="16200000">
            <a:off x="5730840" y="627840"/>
            <a:ext cx="2235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17480"/>
                <a:tab algn="l" pos="1434960"/>
                <a:tab algn="l" pos="2152800"/>
                <a:tab algn="l" pos="2870280"/>
                <a:tab algn="l" pos="3587760"/>
                <a:tab algn="l" pos="4305240"/>
                <a:tab algn="l" pos="5022720"/>
                <a:tab algn="l" pos="5740560"/>
                <a:tab algn="l" pos="6458040"/>
                <a:tab algn="l" pos="7175520"/>
                <a:tab algn="l" pos="7893000"/>
                <a:tab algn="l" pos="8610480"/>
                <a:tab algn="l" pos="9328320"/>
                <a:tab algn="l" pos="10045800"/>
                <a:tab algn="l" pos="107632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DotumChe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8" name="テキスト ボックス 28"/>
          <p:cNvSpPr/>
          <p:nvPr/>
        </p:nvSpPr>
        <p:spPr>
          <a:xfrm rot="16200000">
            <a:off x="5803200" y="61308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17480"/>
                <a:tab algn="l" pos="1434960"/>
                <a:tab algn="l" pos="2152800"/>
                <a:tab algn="l" pos="2870280"/>
                <a:tab algn="l" pos="3587760"/>
                <a:tab algn="l" pos="4305240"/>
                <a:tab algn="l" pos="5022720"/>
                <a:tab algn="l" pos="5740560"/>
                <a:tab algn="l" pos="6458040"/>
                <a:tab algn="l" pos="7175520"/>
                <a:tab algn="l" pos="7893000"/>
                <a:tab algn="l" pos="8610480"/>
                <a:tab algn="l" pos="9328320"/>
                <a:tab algn="l" pos="10045800"/>
                <a:tab algn="l" pos="107632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DotumChe"/>
              </a:rPr>
              <a:t>2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9" name="テキスト ボックス 29"/>
          <p:cNvSpPr/>
          <p:nvPr/>
        </p:nvSpPr>
        <p:spPr>
          <a:xfrm rot="16200000">
            <a:off x="5896800" y="61308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17480"/>
                <a:tab algn="l" pos="1434960"/>
                <a:tab algn="l" pos="2152800"/>
                <a:tab algn="l" pos="2870280"/>
                <a:tab algn="l" pos="3587760"/>
                <a:tab algn="l" pos="4305240"/>
                <a:tab algn="l" pos="5022720"/>
                <a:tab algn="l" pos="5740560"/>
                <a:tab algn="l" pos="6458040"/>
                <a:tab algn="l" pos="7175520"/>
                <a:tab algn="l" pos="7893000"/>
                <a:tab algn="l" pos="8610480"/>
                <a:tab algn="l" pos="9328320"/>
                <a:tab algn="l" pos="10045800"/>
                <a:tab algn="l" pos="107632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DotumChe"/>
              </a:rPr>
              <a:t>4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50" name="グループ化 8"/>
          <p:cNvGrpSpPr/>
          <p:nvPr/>
        </p:nvGrpSpPr>
        <p:grpSpPr>
          <a:xfrm>
            <a:off x="3411360" y="679320"/>
            <a:ext cx="2234880" cy="2034000"/>
            <a:chOff x="3411360" y="679320"/>
            <a:chExt cx="2234880" cy="2034000"/>
          </a:xfrm>
        </p:grpSpPr>
        <p:sp>
          <p:nvSpPr>
            <p:cNvPr id="551" name="直線コネクタ 84"/>
            <p:cNvSpPr/>
            <p:nvPr/>
          </p:nvSpPr>
          <p:spPr>
            <a:xfrm flipH="1">
              <a:off x="3850560" y="772920"/>
              <a:ext cx="1565640" cy="1544760"/>
            </a:xfrm>
            <a:prstGeom prst="line">
              <a:avLst/>
            </a:prstGeom>
            <a:ln w="12600">
              <a:solidFill>
                <a:srgbClr val="e6e6e6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52" name="図 1" descr=""/>
            <p:cNvPicPr/>
            <p:nvPr/>
          </p:nvPicPr>
          <p:blipFill>
            <a:blip r:embed="rId4"/>
            <a:stretch/>
          </p:blipFill>
          <p:spPr>
            <a:xfrm>
              <a:off x="3678120" y="704520"/>
              <a:ext cx="1854360" cy="17589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53" name="グループ化 83"/>
            <p:cNvGrpSpPr/>
            <p:nvPr/>
          </p:nvGrpSpPr>
          <p:grpSpPr>
            <a:xfrm>
              <a:off x="3612960" y="750600"/>
              <a:ext cx="1914840" cy="1684440"/>
              <a:chOff x="3612960" y="750600"/>
              <a:chExt cx="1914840" cy="1684440"/>
            </a:xfrm>
          </p:grpSpPr>
          <p:sp>
            <p:nvSpPr>
              <p:cNvPr id="554" name="正方形/長方形 6"/>
              <p:cNvSpPr/>
              <p:nvPr/>
            </p:nvSpPr>
            <p:spPr>
              <a:xfrm rot="16200000">
                <a:off x="2893320" y="1469880"/>
                <a:ext cx="1638720" cy="199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8760" rIns="68760" tIns="34200" bIns="34200" anchor="ctr">
                <a:noAutofit/>
              </a:bodyPr>
              <a:p>
                <a:pPr algn="ctr">
                  <a:tabLst>
                    <a:tab algn="l" pos="0"/>
                    <a:tab algn="l" pos="717480"/>
                    <a:tab algn="l" pos="1434960"/>
                    <a:tab algn="l" pos="2152800"/>
                    <a:tab algn="l" pos="2870280"/>
                    <a:tab algn="l" pos="3587760"/>
                    <a:tab algn="l" pos="4305240"/>
                    <a:tab algn="l" pos="5022720"/>
                    <a:tab algn="l" pos="5740560"/>
                    <a:tab algn="l" pos="6458040"/>
                    <a:tab algn="l" pos="7175520"/>
                    <a:tab algn="l" pos="7893000"/>
                    <a:tab algn="l" pos="8610480"/>
                    <a:tab algn="l" pos="9328320"/>
                    <a:tab algn="l" pos="10045800"/>
                    <a:tab algn="l" pos="1076328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5" name="正方形/長方形 7"/>
              <p:cNvSpPr/>
              <p:nvPr/>
            </p:nvSpPr>
            <p:spPr>
              <a:xfrm>
                <a:off x="3793680" y="2357280"/>
                <a:ext cx="1734120" cy="777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8760" rIns="68760" tIns="34200" bIns="34200" anchor="ctr">
                <a:noAutofit/>
              </a:bodyPr>
              <a:p>
                <a:pPr algn="ctr">
                  <a:tabLst>
                    <a:tab algn="l" pos="0"/>
                    <a:tab algn="l" pos="717480"/>
                    <a:tab algn="l" pos="1434960"/>
                    <a:tab algn="l" pos="2152800"/>
                    <a:tab algn="l" pos="2870280"/>
                    <a:tab algn="l" pos="3587760"/>
                    <a:tab algn="l" pos="4305240"/>
                    <a:tab algn="l" pos="5022720"/>
                    <a:tab algn="l" pos="5740560"/>
                    <a:tab algn="l" pos="6458040"/>
                    <a:tab algn="l" pos="7175520"/>
                    <a:tab algn="l" pos="7893000"/>
                    <a:tab algn="l" pos="8610480"/>
                    <a:tab algn="l" pos="9328320"/>
                    <a:tab algn="l" pos="10045800"/>
                    <a:tab algn="l" pos="1076328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56" name="グループ化 49"/>
            <p:cNvGrpSpPr/>
            <p:nvPr/>
          </p:nvGrpSpPr>
          <p:grpSpPr>
            <a:xfrm>
              <a:off x="3534480" y="679320"/>
              <a:ext cx="372600" cy="1761120"/>
              <a:chOff x="3534480" y="679320"/>
              <a:chExt cx="372600" cy="1761120"/>
            </a:xfrm>
          </p:grpSpPr>
          <p:sp>
            <p:nvSpPr>
              <p:cNvPr id="557" name="テキスト ボックス 37"/>
              <p:cNvSpPr/>
              <p:nvPr/>
            </p:nvSpPr>
            <p:spPr>
              <a:xfrm>
                <a:off x="3661560" y="2209320"/>
                <a:ext cx="2448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8" name="テキスト ボックス 38"/>
              <p:cNvSpPr/>
              <p:nvPr/>
            </p:nvSpPr>
            <p:spPr>
              <a:xfrm>
                <a:off x="3597840" y="1826640"/>
                <a:ext cx="308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9" name="テキスト ボックス 39"/>
              <p:cNvSpPr/>
              <p:nvPr/>
            </p:nvSpPr>
            <p:spPr>
              <a:xfrm>
                <a:off x="3597840" y="1444320"/>
                <a:ext cx="308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0" name="テキスト ボックス 40"/>
              <p:cNvSpPr/>
              <p:nvPr/>
            </p:nvSpPr>
            <p:spPr>
              <a:xfrm>
                <a:off x="3597840" y="1061640"/>
                <a:ext cx="308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9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1" name="テキスト ボックス 41"/>
              <p:cNvSpPr/>
              <p:nvPr/>
            </p:nvSpPr>
            <p:spPr>
              <a:xfrm>
                <a:off x="3534480" y="679320"/>
                <a:ext cx="3726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2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62" name="グループ化 43"/>
            <p:cNvGrpSpPr/>
            <p:nvPr/>
          </p:nvGrpSpPr>
          <p:grpSpPr>
            <a:xfrm>
              <a:off x="3774960" y="2306520"/>
              <a:ext cx="1871280" cy="231120"/>
              <a:chOff x="3774960" y="2306520"/>
              <a:chExt cx="1871280" cy="231120"/>
            </a:xfrm>
          </p:grpSpPr>
          <p:sp>
            <p:nvSpPr>
              <p:cNvPr id="563" name="テキスト ボックス 44"/>
              <p:cNvSpPr/>
              <p:nvPr/>
            </p:nvSpPr>
            <p:spPr>
              <a:xfrm>
                <a:off x="3774960" y="2306520"/>
                <a:ext cx="2448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4" name="テキスト ボックス 45"/>
              <p:cNvSpPr/>
              <p:nvPr/>
            </p:nvSpPr>
            <p:spPr>
              <a:xfrm>
                <a:off x="4135320" y="2306520"/>
                <a:ext cx="308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5" name="テキスト ボックス 46"/>
              <p:cNvSpPr/>
              <p:nvPr/>
            </p:nvSpPr>
            <p:spPr>
              <a:xfrm>
                <a:off x="4525920" y="2306520"/>
                <a:ext cx="308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6" name="テキスト ボックス 47"/>
              <p:cNvSpPr/>
              <p:nvPr/>
            </p:nvSpPr>
            <p:spPr>
              <a:xfrm>
                <a:off x="4908960" y="2306520"/>
                <a:ext cx="308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9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7" name="テキスト ボックス 48"/>
              <p:cNvSpPr/>
              <p:nvPr/>
            </p:nvSpPr>
            <p:spPr>
              <a:xfrm>
                <a:off x="5273640" y="2306520"/>
                <a:ext cx="3726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2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68" name="テキスト ボックス 71"/>
            <p:cNvSpPr/>
            <p:nvPr/>
          </p:nvSpPr>
          <p:spPr>
            <a:xfrm>
              <a:off x="3873960" y="2467080"/>
              <a:ext cx="1605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gnal intensity (ES-DCs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テキスト ボックス 72"/>
            <p:cNvSpPr/>
            <p:nvPr/>
          </p:nvSpPr>
          <p:spPr>
            <a:xfrm rot="16200000">
              <a:off x="2735280" y="1424520"/>
              <a:ext cx="1598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gnal intensity (ES-SCs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70" name="Text Box 28"/>
          <p:cNvSpPr/>
          <p:nvPr/>
        </p:nvSpPr>
        <p:spPr>
          <a:xfrm>
            <a:off x="3390120" y="344520"/>
            <a:ext cx="30888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71" name="グループ化 11"/>
          <p:cNvGrpSpPr/>
          <p:nvPr/>
        </p:nvGrpSpPr>
        <p:grpSpPr>
          <a:xfrm>
            <a:off x="3411360" y="3478320"/>
            <a:ext cx="2267280" cy="2044800"/>
            <a:chOff x="3411360" y="3478320"/>
            <a:chExt cx="2267280" cy="2044800"/>
          </a:xfrm>
        </p:grpSpPr>
        <p:sp>
          <p:nvSpPr>
            <p:cNvPr id="572" name="直線コネクタ 78"/>
            <p:cNvSpPr/>
            <p:nvPr/>
          </p:nvSpPr>
          <p:spPr>
            <a:xfrm flipH="1">
              <a:off x="3933360" y="3583080"/>
              <a:ext cx="1565640" cy="1544400"/>
            </a:xfrm>
            <a:prstGeom prst="line">
              <a:avLst/>
            </a:prstGeom>
            <a:ln w="12600">
              <a:solidFill>
                <a:srgbClr val="e6e6e6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73" name="図 7" descr=""/>
            <p:cNvPicPr/>
            <p:nvPr/>
          </p:nvPicPr>
          <p:blipFill>
            <a:blip r:embed="rId5"/>
            <a:stretch/>
          </p:blipFill>
          <p:spPr>
            <a:xfrm>
              <a:off x="3725640" y="3514680"/>
              <a:ext cx="1903680" cy="17539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74" name="グループ化 85"/>
            <p:cNvGrpSpPr/>
            <p:nvPr/>
          </p:nvGrpSpPr>
          <p:grpSpPr>
            <a:xfrm>
              <a:off x="3688920" y="3565080"/>
              <a:ext cx="1876680" cy="1679760"/>
              <a:chOff x="3688920" y="3565080"/>
              <a:chExt cx="1876680" cy="1679760"/>
            </a:xfrm>
          </p:grpSpPr>
          <p:sp>
            <p:nvSpPr>
              <p:cNvPr id="575" name="正方形/長方形 9"/>
              <p:cNvSpPr/>
              <p:nvPr/>
            </p:nvSpPr>
            <p:spPr>
              <a:xfrm rot="16200000">
                <a:off x="2969640" y="4284360"/>
                <a:ext cx="1638360" cy="199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8760" rIns="68760" tIns="34200" bIns="34200" anchor="ctr">
                <a:noAutofit/>
              </a:bodyPr>
              <a:p>
                <a:pPr algn="ctr">
                  <a:tabLst>
                    <a:tab algn="l" pos="0"/>
                    <a:tab algn="l" pos="717480"/>
                    <a:tab algn="l" pos="1434960"/>
                    <a:tab algn="l" pos="2152800"/>
                    <a:tab algn="l" pos="2870280"/>
                    <a:tab algn="l" pos="3587760"/>
                    <a:tab algn="l" pos="4305240"/>
                    <a:tab algn="l" pos="5022720"/>
                    <a:tab algn="l" pos="5740560"/>
                    <a:tab algn="l" pos="6458040"/>
                    <a:tab algn="l" pos="7175520"/>
                    <a:tab algn="l" pos="7893000"/>
                    <a:tab algn="l" pos="8610480"/>
                    <a:tab algn="l" pos="9328320"/>
                    <a:tab algn="l" pos="10045800"/>
                    <a:tab algn="l" pos="1076328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6" name="正方形/長方形 10"/>
              <p:cNvSpPr/>
              <p:nvPr/>
            </p:nvSpPr>
            <p:spPr>
              <a:xfrm>
                <a:off x="3831840" y="5167080"/>
                <a:ext cx="1733760" cy="777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8760" rIns="68760" tIns="34200" bIns="34200" anchor="ctr">
                <a:noAutofit/>
              </a:bodyPr>
              <a:p>
                <a:pPr algn="ctr">
                  <a:tabLst>
                    <a:tab algn="l" pos="0"/>
                    <a:tab algn="l" pos="717480"/>
                    <a:tab algn="l" pos="1434960"/>
                    <a:tab algn="l" pos="2152800"/>
                    <a:tab algn="l" pos="2870280"/>
                    <a:tab algn="l" pos="3587760"/>
                    <a:tab algn="l" pos="4305240"/>
                    <a:tab algn="l" pos="5022720"/>
                    <a:tab algn="l" pos="5740560"/>
                    <a:tab algn="l" pos="6458040"/>
                    <a:tab algn="l" pos="7175520"/>
                    <a:tab algn="l" pos="7893000"/>
                    <a:tab algn="l" pos="8610480"/>
                    <a:tab algn="l" pos="9328320"/>
                    <a:tab algn="l" pos="10045800"/>
                    <a:tab algn="l" pos="1076328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77" name="テキスト ボックス 51"/>
            <p:cNvSpPr/>
            <p:nvPr/>
          </p:nvSpPr>
          <p:spPr>
            <a:xfrm>
              <a:off x="3835800" y="5113440"/>
              <a:ext cx="244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テキスト ボックス 52"/>
            <p:cNvSpPr/>
            <p:nvPr/>
          </p:nvSpPr>
          <p:spPr>
            <a:xfrm>
              <a:off x="4146480" y="5113440"/>
              <a:ext cx="3726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テキスト ボックス 53"/>
            <p:cNvSpPr/>
            <p:nvPr/>
          </p:nvSpPr>
          <p:spPr>
            <a:xfrm>
              <a:off x="4480560" y="5113440"/>
              <a:ext cx="436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2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テキスト ボックス 54"/>
            <p:cNvSpPr/>
            <p:nvPr/>
          </p:nvSpPr>
          <p:spPr>
            <a:xfrm>
              <a:off x="4863240" y="5113440"/>
              <a:ext cx="436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8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テキスト ボックス 55"/>
            <p:cNvSpPr/>
            <p:nvPr/>
          </p:nvSpPr>
          <p:spPr>
            <a:xfrm>
              <a:off x="5241960" y="5113440"/>
              <a:ext cx="436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24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テキスト ボックス 56"/>
            <p:cNvSpPr/>
            <p:nvPr/>
          </p:nvSpPr>
          <p:spPr>
            <a:xfrm>
              <a:off x="3724560" y="5027760"/>
              <a:ext cx="244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テキスト ボックス 57"/>
            <p:cNvSpPr/>
            <p:nvPr/>
          </p:nvSpPr>
          <p:spPr>
            <a:xfrm>
              <a:off x="3597120" y="4640400"/>
              <a:ext cx="3726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テキスト ボックス 58"/>
            <p:cNvSpPr/>
            <p:nvPr/>
          </p:nvSpPr>
          <p:spPr>
            <a:xfrm>
              <a:off x="3532320" y="4253040"/>
              <a:ext cx="436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2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5" name="テキスト ボックス 59"/>
            <p:cNvSpPr/>
            <p:nvPr/>
          </p:nvSpPr>
          <p:spPr>
            <a:xfrm>
              <a:off x="3532320" y="3865680"/>
              <a:ext cx="436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8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テキスト ボックス 60"/>
            <p:cNvSpPr/>
            <p:nvPr/>
          </p:nvSpPr>
          <p:spPr>
            <a:xfrm>
              <a:off x="3532320" y="3478320"/>
              <a:ext cx="436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24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テキスト ボックス 73"/>
            <p:cNvSpPr/>
            <p:nvPr/>
          </p:nvSpPr>
          <p:spPr>
            <a:xfrm>
              <a:off x="3892680" y="5276880"/>
              <a:ext cx="1605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gnal intensity (ES-DCs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8" name="テキスト ボックス 74"/>
            <p:cNvSpPr/>
            <p:nvPr/>
          </p:nvSpPr>
          <p:spPr>
            <a:xfrm rot="16200000">
              <a:off x="2735280" y="4234680"/>
              <a:ext cx="1598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gnal intensity (ES-SCs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89" name="テキスト ボックス 14"/>
          <p:cNvSpPr/>
          <p:nvPr/>
        </p:nvSpPr>
        <p:spPr>
          <a:xfrm rot="16200000">
            <a:off x="5732280" y="3437640"/>
            <a:ext cx="2235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17480"/>
                <a:tab algn="l" pos="1434960"/>
                <a:tab algn="l" pos="2152800"/>
                <a:tab algn="l" pos="2870280"/>
                <a:tab algn="l" pos="3587760"/>
                <a:tab algn="l" pos="4305240"/>
                <a:tab algn="l" pos="5022720"/>
                <a:tab algn="l" pos="5740560"/>
                <a:tab algn="l" pos="6458040"/>
                <a:tab algn="l" pos="7175520"/>
                <a:tab algn="l" pos="7893000"/>
                <a:tab algn="l" pos="8610480"/>
                <a:tab algn="l" pos="9328320"/>
                <a:tab algn="l" pos="10045800"/>
                <a:tab algn="l" pos="107632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DotumChe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0" name="テキスト ボックス 15"/>
          <p:cNvSpPr/>
          <p:nvPr/>
        </p:nvSpPr>
        <p:spPr>
          <a:xfrm rot="16200000">
            <a:off x="5775480" y="3405960"/>
            <a:ext cx="30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17480"/>
                <a:tab algn="l" pos="1434960"/>
                <a:tab algn="l" pos="2152800"/>
                <a:tab algn="l" pos="2870280"/>
                <a:tab algn="l" pos="3587760"/>
                <a:tab algn="l" pos="4305240"/>
                <a:tab algn="l" pos="5022720"/>
                <a:tab algn="l" pos="5740560"/>
                <a:tab algn="l" pos="6458040"/>
                <a:tab algn="l" pos="7175520"/>
                <a:tab algn="l" pos="7893000"/>
                <a:tab algn="l" pos="8610480"/>
                <a:tab algn="l" pos="9328320"/>
                <a:tab algn="l" pos="10045800"/>
                <a:tab algn="l" pos="107632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DotumChe"/>
              </a:rPr>
              <a:t>5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1" name="テキスト ボックス 16"/>
          <p:cNvSpPr/>
          <p:nvPr/>
        </p:nvSpPr>
        <p:spPr>
          <a:xfrm rot="16200000">
            <a:off x="5851080" y="3390840"/>
            <a:ext cx="3513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17480"/>
                <a:tab algn="l" pos="1434960"/>
                <a:tab algn="l" pos="2152800"/>
                <a:tab algn="l" pos="2870280"/>
                <a:tab algn="l" pos="3587760"/>
                <a:tab algn="l" pos="4305240"/>
                <a:tab algn="l" pos="5022720"/>
                <a:tab algn="l" pos="5740560"/>
                <a:tab algn="l" pos="6458040"/>
                <a:tab algn="l" pos="7175520"/>
                <a:tab algn="l" pos="7893000"/>
                <a:tab algn="l" pos="8610480"/>
                <a:tab algn="l" pos="9328320"/>
                <a:tab algn="l" pos="10045800"/>
                <a:tab algn="l" pos="107632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DotumChe"/>
              </a:rPr>
              <a:t>10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92" name="グループ化 92"/>
          <p:cNvGrpSpPr/>
          <p:nvPr/>
        </p:nvGrpSpPr>
        <p:grpSpPr>
          <a:xfrm>
            <a:off x="5819760" y="3573360"/>
            <a:ext cx="557280" cy="1522440"/>
            <a:chOff x="5819760" y="3573360"/>
            <a:chExt cx="557280" cy="1522440"/>
          </a:xfrm>
        </p:grpSpPr>
        <p:pic>
          <p:nvPicPr>
            <p:cNvPr id="593" name="図 86" descr=""/>
            <p:cNvPicPr/>
            <p:nvPr/>
          </p:nvPicPr>
          <p:blipFill>
            <a:blip r:embed="rId6"/>
            <a:stretch/>
          </p:blipFill>
          <p:spPr>
            <a:xfrm>
              <a:off x="5824440" y="3573360"/>
              <a:ext cx="552600" cy="1522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94" name="正方形/長方形 89"/>
            <p:cNvSpPr/>
            <p:nvPr/>
          </p:nvSpPr>
          <p:spPr>
            <a:xfrm>
              <a:off x="5819760" y="3620880"/>
              <a:ext cx="304920" cy="889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68760" rIns="68760" tIns="34200" bIns="34200" anchor="ctr">
              <a:noAutofit/>
            </a:bodyPr>
            <a:p>
              <a:pPr algn="ctr">
                <a:tabLst>
                  <a:tab algn="l" pos="0"/>
                  <a:tab algn="l" pos="717480"/>
                  <a:tab algn="l" pos="1434960"/>
                  <a:tab algn="l" pos="2152800"/>
                  <a:tab algn="l" pos="2870280"/>
                  <a:tab algn="l" pos="3587760"/>
                  <a:tab algn="l" pos="4305240"/>
                  <a:tab algn="l" pos="5022720"/>
                  <a:tab algn="l" pos="5740560"/>
                  <a:tab algn="l" pos="6458040"/>
                  <a:tab algn="l" pos="7175520"/>
                  <a:tab algn="l" pos="7893000"/>
                  <a:tab algn="l" pos="8610480"/>
                  <a:tab algn="l" pos="9328320"/>
                  <a:tab algn="l" pos="10045800"/>
                  <a:tab algn="l" pos="1076328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95" name="Text Box 28"/>
          <p:cNvSpPr/>
          <p:nvPr/>
        </p:nvSpPr>
        <p:spPr>
          <a:xfrm>
            <a:off x="3390120" y="3094200"/>
            <a:ext cx="30888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96" name="グループ化 12"/>
          <p:cNvGrpSpPr/>
          <p:nvPr/>
        </p:nvGrpSpPr>
        <p:grpSpPr>
          <a:xfrm>
            <a:off x="3424320" y="6288120"/>
            <a:ext cx="2201040" cy="2035440"/>
            <a:chOff x="3424320" y="6288120"/>
            <a:chExt cx="2201040" cy="2035440"/>
          </a:xfrm>
        </p:grpSpPr>
        <p:sp>
          <p:nvSpPr>
            <p:cNvPr id="597" name="直線コネクタ 83"/>
            <p:cNvSpPr/>
            <p:nvPr/>
          </p:nvSpPr>
          <p:spPr>
            <a:xfrm flipH="1">
              <a:off x="3874680" y="6381720"/>
              <a:ext cx="1563480" cy="1544760"/>
            </a:xfrm>
            <a:prstGeom prst="line">
              <a:avLst/>
            </a:prstGeom>
            <a:ln w="12600">
              <a:solidFill>
                <a:srgbClr val="e6e6e6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98" name="図 11" descr=""/>
            <p:cNvPicPr/>
            <p:nvPr/>
          </p:nvPicPr>
          <p:blipFill>
            <a:blip r:embed="rId7"/>
            <a:stretch/>
          </p:blipFill>
          <p:spPr>
            <a:xfrm>
              <a:off x="3697200" y="6314760"/>
              <a:ext cx="1855800" cy="17542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99" name="グループ化 88"/>
            <p:cNvGrpSpPr/>
            <p:nvPr/>
          </p:nvGrpSpPr>
          <p:grpSpPr>
            <a:xfrm>
              <a:off x="3636720" y="6364080"/>
              <a:ext cx="1917720" cy="1679760"/>
              <a:chOff x="3636720" y="6364080"/>
              <a:chExt cx="1917720" cy="1679760"/>
            </a:xfrm>
          </p:grpSpPr>
          <p:sp>
            <p:nvSpPr>
              <p:cNvPr id="600" name="正方形/長方形 54"/>
              <p:cNvSpPr/>
              <p:nvPr/>
            </p:nvSpPr>
            <p:spPr>
              <a:xfrm rot="16200000">
                <a:off x="2918880" y="7081920"/>
                <a:ext cx="1638720" cy="2030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8760" rIns="68760" tIns="34200" bIns="34200" anchor="ctr">
                <a:noAutofit/>
              </a:bodyPr>
              <a:p>
                <a:pPr algn="ctr">
                  <a:tabLst>
                    <a:tab algn="l" pos="0"/>
                    <a:tab algn="l" pos="717480"/>
                    <a:tab algn="l" pos="1434960"/>
                    <a:tab algn="l" pos="2152800"/>
                    <a:tab algn="l" pos="2870280"/>
                    <a:tab algn="l" pos="3587760"/>
                    <a:tab algn="l" pos="4305240"/>
                    <a:tab algn="l" pos="5022720"/>
                    <a:tab algn="l" pos="5740560"/>
                    <a:tab algn="l" pos="6458040"/>
                    <a:tab algn="l" pos="7175520"/>
                    <a:tab algn="l" pos="7893000"/>
                    <a:tab algn="l" pos="8610480"/>
                    <a:tab algn="l" pos="9328320"/>
                    <a:tab algn="l" pos="10045800"/>
                    <a:tab algn="l" pos="1076328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1" name="正方形/長方形 55"/>
              <p:cNvSpPr/>
              <p:nvPr/>
            </p:nvSpPr>
            <p:spPr>
              <a:xfrm>
                <a:off x="3792240" y="7966080"/>
                <a:ext cx="1762200" cy="777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8760" rIns="68760" tIns="34200" bIns="34200" anchor="ctr">
                <a:noAutofit/>
              </a:bodyPr>
              <a:p>
                <a:pPr algn="ctr">
                  <a:tabLst>
                    <a:tab algn="l" pos="0"/>
                    <a:tab algn="l" pos="717480"/>
                    <a:tab algn="l" pos="1434960"/>
                    <a:tab algn="l" pos="2152800"/>
                    <a:tab algn="l" pos="2870280"/>
                    <a:tab algn="l" pos="3587760"/>
                    <a:tab algn="l" pos="4305240"/>
                    <a:tab algn="l" pos="5022720"/>
                    <a:tab algn="l" pos="5740560"/>
                    <a:tab algn="l" pos="6458040"/>
                    <a:tab algn="l" pos="7175520"/>
                    <a:tab algn="l" pos="7893000"/>
                    <a:tab algn="l" pos="8610480"/>
                    <a:tab algn="l" pos="9328320"/>
                    <a:tab algn="l" pos="10045800"/>
                    <a:tab algn="l" pos="1076328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02" name="グループ化 67"/>
            <p:cNvGrpSpPr/>
            <p:nvPr/>
          </p:nvGrpSpPr>
          <p:grpSpPr>
            <a:xfrm>
              <a:off x="3768840" y="7920000"/>
              <a:ext cx="1856520" cy="231120"/>
              <a:chOff x="3768840" y="7920000"/>
              <a:chExt cx="1856520" cy="231120"/>
            </a:xfrm>
          </p:grpSpPr>
          <p:sp>
            <p:nvSpPr>
              <p:cNvPr id="603" name="テキスト ボックス 62"/>
              <p:cNvSpPr/>
              <p:nvPr/>
            </p:nvSpPr>
            <p:spPr>
              <a:xfrm>
                <a:off x="3768840" y="7920000"/>
                <a:ext cx="2448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4" name="テキスト ボックス 63"/>
              <p:cNvSpPr/>
              <p:nvPr/>
            </p:nvSpPr>
            <p:spPr>
              <a:xfrm>
                <a:off x="4129200" y="7920000"/>
                <a:ext cx="308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5" name="テキスト ボックス 64"/>
              <p:cNvSpPr/>
              <p:nvPr/>
            </p:nvSpPr>
            <p:spPr>
              <a:xfrm>
                <a:off x="4512240" y="7920000"/>
                <a:ext cx="308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8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6" name="テキスト ボックス 65"/>
              <p:cNvSpPr/>
              <p:nvPr/>
            </p:nvSpPr>
            <p:spPr>
              <a:xfrm>
                <a:off x="4867200" y="7920000"/>
                <a:ext cx="3726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2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7" name="テキスト ボックス 66"/>
              <p:cNvSpPr/>
              <p:nvPr/>
            </p:nvSpPr>
            <p:spPr>
              <a:xfrm>
                <a:off x="5252760" y="7920000"/>
                <a:ext cx="3726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6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08" name="グループ化 91"/>
            <p:cNvGrpSpPr/>
            <p:nvPr/>
          </p:nvGrpSpPr>
          <p:grpSpPr>
            <a:xfrm>
              <a:off x="3535560" y="6288120"/>
              <a:ext cx="372600" cy="1762560"/>
              <a:chOff x="3535560" y="6288120"/>
              <a:chExt cx="372600" cy="1762560"/>
            </a:xfrm>
          </p:grpSpPr>
          <p:sp>
            <p:nvSpPr>
              <p:cNvPr id="609" name="テキスト ボックス 75"/>
              <p:cNvSpPr/>
              <p:nvPr/>
            </p:nvSpPr>
            <p:spPr>
              <a:xfrm>
                <a:off x="3662640" y="7819560"/>
                <a:ext cx="2448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0" name="テキスト ボックス 76"/>
              <p:cNvSpPr/>
              <p:nvPr/>
            </p:nvSpPr>
            <p:spPr>
              <a:xfrm>
                <a:off x="3598920" y="7436880"/>
                <a:ext cx="308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1" name="テキスト ボックス 77"/>
              <p:cNvSpPr/>
              <p:nvPr/>
            </p:nvSpPr>
            <p:spPr>
              <a:xfrm>
                <a:off x="3598920" y="7053840"/>
                <a:ext cx="308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8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2" name="テキスト ボックス 78"/>
              <p:cNvSpPr/>
              <p:nvPr/>
            </p:nvSpPr>
            <p:spPr>
              <a:xfrm>
                <a:off x="3535560" y="6670800"/>
                <a:ext cx="3726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2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3" name="テキスト ボックス 79"/>
              <p:cNvSpPr/>
              <p:nvPr/>
            </p:nvSpPr>
            <p:spPr>
              <a:xfrm>
                <a:off x="3535560" y="6288120"/>
                <a:ext cx="3726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6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14" name="テキスト ボックス 75"/>
            <p:cNvSpPr/>
            <p:nvPr/>
          </p:nvSpPr>
          <p:spPr>
            <a:xfrm>
              <a:off x="3847680" y="8077320"/>
              <a:ext cx="1605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gnal intensity (ES-DCs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5" name="テキスト ボックス 76"/>
            <p:cNvSpPr/>
            <p:nvPr/>
          </p:nvSpPr>
          <p:spPr>
            <a:xfrm rot="16200000">
              <a:off x="2748240" y="7035120"/>
              <a:ext cx="1598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gnal intensity (ES-SCs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16" name="テキスト ボックス 21"/>
          <p:cNvSpPr/>
          <p:nvPr/>
        </p:nvSpPr>
        <p:spPr>
          <a:xfrm rot="16200000">
            <a:off x="5732280" y="6231600"/>
            <a:ext cx="2235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17480"/>
                <a:tab algn="l" pos="1434960"/>
                <a:tab algn="l" pos="2152800"/>
                <a:tab algn="l" pos="2870280"/>
                <a:tab algn="l" pos="3587760"/>
                <a:tab algn="l" pos="4305240"/>
                <a:tab algn="l" pos="5022720"/>
                <a:tab algn="l" pos="5740560"/>
                <a:tab algn="l" pos="6458040"/>
                <a:tab algn="l" pos="7175520"/>
                <a:tab algn="l" pos="7893000"/>
                <a:tab algn="l" pos="8610480"/>
                <a:tab algn="l" pos="9328320"/>
                <a:tab algn="l" pos="10045800"/>
                <a:tab algn="l" pos="107632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DotumChe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7" name="テキスト ボックス 22"/>
          <p:cNvSpPr/>
          <p:nvPr/>
        </p:nvSpPr>
        <p:spPr>
          <a:xfrm rot="16200000">
            <a:off x="5806440" y="621684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17480"/>
                <a:tab algn="l" pos="1434960"/>
                <a:tab algn="l" pos="2152800"/>
                <a:tab algn="l" pos="2870280"/>
                <a:tab algn="l" pos="3587760"/>
                <a:tab algn="l" pos="4305240"/>
                <a:tab algn="l" pos="5022720"/>
                <a:tab algn="l" pos="5740560"/>
                <a:tab algn="l" pos="6458040"/>
                <a:tab algn="l" pos="7175520"/>
                <a:tab algn="l" pos="7893000"/>
                <a:tab algn="l" pos="8610480"/>
                <a:tab algn="l" pos="9328320"/>
                <a:tab algn="l" pos="10045800"/>
                <a:tab algn="l" pos="107632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DotumChe"/>
              </a:rPr>
              <a:t>1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8" name="テキスト ボックス 23"/>
          <p:cNvSpPr/>
          <p:nvPr/>
        </p:nvSpPr>
        <p:spPr>
          <a:xfrm rot="16200000">
            <a:off x="5895360" y="621684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17480"/>
                <a:tab algn="l" pos="1434960"/>
                <a:tab algn="l" pos="2152800"/>
                <a:tab algn="l" pos="2870280"/>
                <a:tab algn="l" pos="3587760"/>
                <a:tab algn="l" pos="4305240"/>
                <a:tab algn="l" pos="5022720"/>
                <a:tab algn="l" pos="5740560"/>
                <a:tab algn="l" pos="6458040"/>
                <a:tab algn="l" pos="7175520"/>
                <a:tab algn="l" pos="7893000"/>
                <a:tab algn="l" pos="8610480"/>
                <a:tab algn="l" pos="9328320"/>
                <a:tab algn="l" pos="10045800"/>
                <a:tab algn="l" pos="107632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DotumChe"/>
              </a:rPr>
              <a:t>3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19" name="グループ化 91"/>
          <p:cNvGrpSpPr/>
          <p:nvPr/>
        </p:nvGrpSpPr>
        <p:grpSpPr>
          <a:xfrm>
            <a:off x="5826240" y="6367320"/>
            <a:ext cx="617400" cy="2597400"/>
            <a:chOff x="5826240" y="6367320"/>
            <a:chExt cx="617400" cy="2597400"/>
          </a:xfrm>
        </p:grpSpPr>
        <p:pic>
          <p:nvPicPr>
            <p:cNvPr id="620" name="図 88" descr=""/>
            <p:cNvPicPr/>
            <p:nvPr/>
          </p:nvPicPr>
          <p:blipFill>
            <a:blip r:embed="rId8"/>
            <a:stretch/>
          </p:blipFill>
          <p:spPr>
            <a:xfrm>
              <a:off x="5826240" y="6367320"/>
              <a:ext cx="617400" cy="2597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21" name="正方形/長方形 90"/>
            <p:cNvSpPr/>
            <p:nvPr/>
          </p:nvSpPr>
          <p:spPr>
            <a:xfrm>
              <a:off x="5830920" y="6414840"/>
              <a:ext cx="304560" cy="889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68760" rIns="68760" tIns="34200" bIns="34200" anchor="ctr">
              <a:noAutofit/>
            </a:bodyPr>
            <a:p>
              <a:pPr algn="ctr">
                <a:tabLst>
                  <a:tab algn="l" pos="0"/>
                  <a:tab algn="l" pos="717480"/>
                  <a:tab algn="l" pos="1434960"/>
                  <a:tab algn="l" pos="2152800"/>
                  <a:tab algn="l" pos="2870280"/>
                  <a:tab algn="l" pos="3587760"/>
                  <a:tab algn="l" pos="4305240"/>
                  <a:tab algn="l" pos="5022720"/>
                  <a:tab algn="l" pos="5740560"/>
                  <a:tab algn="l" pos="6458040"/>
                  <a:tab algn="l" pos="7175520"/>
                  <a:tab algn="l" pos="7893000"/>
                  <a:tab algn="l" pos="8610480"/>
                  <a:tab algn="l" pos="9328320"/>
                  <a:tab algn="l" pos="10045800"/>
                  <a:tab algn="l" pos="1076328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22" name="Text Box 28"/>
          <p:cNvSpPr/>
          <p:nvPr/>
        </p:nvSpPr>
        <p:spPr>
          <a:xfrm>
            <a:off x="3390120" y="5951520"/>
            <a:ext cx="30888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3" name="正方形/長方形 106"/>
          <p:cNvSpPr/>
          <p:nvPr/>
        </p:nvSpPr>
        <p:spPr>
          <a:xfrm>
            <a:off x="264960" y="808200"/>
            <a:ext cx="622440" cy="30636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anchorCtr="1" vert="eaVert" rot="10800000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4" name="テキスト ボックス 15"/>
          <p:cNvSpPr/>
          <p:nvPr/>
        </p:nvSpPr>
        <p:spPr>
          <a:xfrm>
            <a:off x="172080" y="611280"/>
            <a:ext cx="2872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0.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5" name="テキスト ボックス 27"/>
          <p:cNvSpPr/>
          <p:nvPr/>
        </p:nvSpPr>
        <p:spPr>
          <a:xfrm>
            <a:off x="406440" y="611280"/>
            <a:ext cx="3301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1.1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6" name="テキスト ボックス 28"/>
          <p:cNvSpPr/>
          <p:nvPr/>
        </p:nvSpPr>
        <p:spPr>
          <a:xfrm>
            <a:off x="667440" y="611280"/>
            <a:ext cx="3301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4.4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7" name="テキスト ボックス 29"/>
          <p:cNvSpPr/>
          <p:nvPr/>
        </p:nvSpPr>
        <p:spPr>
          <a:xfrm rot="16200000">
            <a:off x="105120" y="897120"/>
            <a:ext cx="4611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Arial Unicode MS"/>
              </a:rPr>
              <a:t>ES-SCs 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8" name="テキスト ボックス 30"/>
          <p:cNvSpPr/>
          <p:nvPr/>
        </p:nvSpPr>
        <p:spPr>
          <a:xfrm rot="16200000">
            <a:off x="260640" y="897120"/>
            <a:ext cx="4611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Arial Unicode MS"/>
              </a:rPr>
              <a:t>ES-SCs 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9" name="テキスト ボックス 31"/>
          <p:cNvSpPr/>
          <p:nvPr/>
        </p:nvSpPr>
        <p:spPr>
          <a:xfrm rot="16200000">
            <a:off x="574920" y="897120"/>
            <a:ext cx="4611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Arial Unicode MS"/>
              </a:rPr>
              <a:t>ES DCs 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0" name="テキスト ボックス 32"/>
          <p:cNvSpPr/>
          <p:nvPr/>
        </p:nvSpPr>
        <p:spPr>
          <a:xfrm rot="16200000">
            <a:off x="416160" y="895680"/>
            <a:ext cx="464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Arial Unicode MS"/>
              </a:rPr>
              <a:t>ES-DCs 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1" name="正方形/長方形 115"/>
          <p:cNvSpPr/>
          <p:nvPr/>
        </p:nvSpPr>
        <p:spPr>
          <a:xfrm>
            <a:off x="1573200" y="797040"/>
            <a:ext cx="649440" cy="32220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anchorCtr="1" vert="eaVert" rot="10800000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2" name="テキスト ボックス 13"/>
          <p:cNvSpPr/>
          <p:nvPr/>
        </p:nvSpPr>
        <p:spPr>
          <a:xfrm rot="16200000">
            <a:off x="1424160" y="897120"/>
            <a:ext cx="4611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Arial Unicode MS"/>
              </a:rPr>
              <a:t>ES-SCs 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3" name="テキスト ボックス 14"/>
          <p:cNvSpPr/>
          <p:nvPr/>
        </p:nvSpPr>
        <p:spPr>
          <a:xfrm rot="16200000">
            <a:off x="1581480" y="897120"/>
            <a:ext cx="4611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Arial Unicode MS"/>
              </a:rPr>
              <a:t>ES-SCs 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4" name="テキスト ボックス 15"/>
          <p:cNvSpPr/>
          <p:nvPr/>
        </p:nvSpPr>
        <p:spPr>
          <a:xfrm rot="16200000">
            <a:off x="1892520" y="897120"/>
            <a:ext cx="4611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Arial Unicode MS"/>
              </a:rPr>
              <a:t>ES DCs 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5" name="テキスト ボックス 16"/>
          <p:cNvSpPr/>
          <p:nvPr/>
        </p:nvSpPr>
        <p:spPr>
          <a:xfrm rot="16200000">
            <a:off x="1734120" y="895680"/>
            <a:ext cx="464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Arial Unicode MS"/>
              </a:rPr>
              <a:t>ES-DCs 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6" name="テキスト ボックス 17"/>
          <p:cNvSpPr/>
          <p:nvPr/>
        </p:nvSpPr>
        <p:spPr>
          <a:xfrm>
            <a:off x="1477080" y="611280"/>
            <a:ext cx="2872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0.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7" name="テキスト ボックス 18"/>
          <p:cNvSpPr/>
          <p:nvPr/>
        </p:nvSpPr>
        <p:spPr>
          <a:xfrm>
            <a:off x="1729440" y="611280"/>
            <a:ext cx="3301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2.6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8" name="テキスト ボックス 19"/>
          <p:cNvSpPr/>
          <p:nvPr/>
        </p:nvSpPr>
        <p:spPr>
          <a:xfrm>
            <a:off x="1933560" y="611280"/>
            <a:ext cx="372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17.9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9" name="Text Box 28"/>
          <p:cNvSpPr/>
          <p:nvPr/>
        </p:nvSpPr>
        <p:spPr>
          <a:xfrm>
            <a:off x="120960" y="34452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0" name="テキスト ボックス 101"/>
          <p:cNvSpPr/>
          <p:nvPr/>
        </p:nvSpPr>
        <p:spPr>
          <a:xfrm>
            <a:off x="8280" y="-3240"/>
            <a:ext cx="953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Figure 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1" name="Text Box 4"/>
          <p:cNvSpPr/>
          <p:nvPr/>
        </p:nvSpPr>
        <p:spPr>
          <a:xfrm>
            <a:off x="496800" y="7094520"/>
            <a:ext cx="5862600" cy="131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, related to Figure 1. Additional data for characterization of ES-SC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E) Morphology of ES-DCs, ES-SCs and bone marrow-derived macrophages (BMM). Scale bars,</a:t>
            </a:r>
            <a:r>
              <a:rPr b="0" lang="ja-JP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0 </a:t>
            </a:r>
            <a:r>
              <a:rPr b="0" lang="el-G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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. (F) Endocytosis assay. Fluorescence-labeled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aphylococcus aureus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. aureus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or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scherichia coli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. coli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particles were incubated with the indicated cells. After incubation, cells were analyzed for the increase of cell-associated fluorescence (filled histograms). Open histograms represent untreated cells. (G) Gene expression analysis of bone marrow-derived macrophages (M0, M1 and M2a) and ES-SC.  M0, M1 and M2a cells were generated as previously described (Riquelme P.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t al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,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ol. Ther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21(2), 409-422.2013).</a:t>
            </a:r>
            <a:r>
              <a:rPr b="0" lang="ja-JP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alues are normalized to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prt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d shown as mean ± SE (*p&lt;0.05, **p&lt;0.01, unpaired Student’s t test)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2" name="図 1" descr=""/>
          <p:cNvPicPr/>
          <p:nvPr/>
        </p:nvPicPr>
        <p:blipFill>
          <a:blip r:embed="rId1"/>
          <a:stretch/>
        </p:blipFill>
        <p:spPr>
          <a:xfrm>
            <a:off x="893880" y="539640"/>
            <a:ext cx="5105160" cy="3009960"/>
          </a:xfrm>
          <a:prstGeom prst="rect">
            <a:avLst/>
          </a:prstGeom>
          <a:ln w="0">
            <a:noFill/>
          </a:ln>
        </p:spPr>
      </p:pic>
      <p:sp>
        <p:nvSpPr>
          <p:cNvPr id="643" name="テキスト ボックス 1"/>
          <p:cNvSpPr/>
          <p:nvPr/>
        </p:nvSpPr>
        <p:spPr>
          <a:xfrm>
            <a:off x="806760" y="1370160"/>
            <a:ext cx="68508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ES-DC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4" name="テキスト ボックス 23"/>
          <p:cNvSpPr/>
          <p:nvPr/>
        </p:nvSpPr>
        <p:spPr>
          <a:xfrm>
            <a:off x="810360" y="2009880"/>
            <a:ext cx="67752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ES-SC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5" name="テキスト ボックス 24"/>
          <p:cNvSpPr/>
          <p:nvPr/>
        </p:nvSpPr>
        <p:spPr>
          <a:xfrm>
            <a:off x="894960" y="2666880"/>
            <a:ext cx="50832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BMM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6" name="テキスト ボックス 25"/>
          <p:cNvSpPr/>
          <p:nvPr/>
        </p:nvSpPr>
        <p:spPr>
          <a:xfrm>
            <a:off x="3506040" y="1316160"/>
            <a:ext cx="68508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ES-DC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7" name="テキスト ボックス 26"/>
          <p:cNvSpPr/>
          <p:nvPr/>
        </p:nvSpPr>
        <p:spPr>
          <a:xfrm>
            <a:off x="3510000" y="2124000"/>
            <a:ext cx="67752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ES-SC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8" name="テキスト ボックス 27"/>
          <p:cNvSpPr/>
          <p:nvPr/>
        </p:nvSpPr>
        <p:spPr>
          <a:xfrm>
            <a:off x="3594600" y="2870280"/>
            <a:ext cx="50832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BMM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9" name="テキスト ボックス 2"/>
          <p:cNvSpPr/>
          <p:nvPr/>
        </p:nvSpPr>
        <p:spPr>
          <a:xfrm>
            <a:off x="4289040" y="822240"/>
            <a:ext cx="78120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S. aureu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0" name="テキスト ボックス 29"/>
          <p:cNvSpPr/>
          <p:nvPr/>
        </p:nvSpPr>
        <p:spPr>
          <a:xfrm>
            <a:off x="5255280" y="822240"/>
            <a:ext cx="56160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E. col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1" name="Text Box 28"/>
          <p:cNvSpPr/>
          <p:nvPr/>
        </p:nvSpPr>
        <p:spPr>
          <a:xfrm>
            <a:off x="837360" y="560520"/>
            <a:ext cx="29952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2" name="Text Box 28"/>
          <p:cNvSpPr/>
          <p:nvPr/>
        </p:nvSpPr>
        <p:spPr>
          <a:xfrm>
            <a:off x="3537360" y="560520"/>
            <a:ext cx="28908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3" name="テキスト ボックス 69"/>
          <p:cNvSpPr/>
          <p:nvPr/>
        </p:nvSpPr>
        <p:spPr>
          <a:xfrm>
            <a:off x="147600" y="6753240"/>
            <a:ext cx="5797440" cy="235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4" name="正方形/長方形 134"/>
          <p:cNvSpPr/>
          <p:nvPr/>
        </p:nvSpPr>
        <p:spPr>
          <a:xfrm>
            <a:off x="4915080" y="4289400"/>
            <a:ext cx="136440" cy="136440"/>
          </a:xfrm>
          <a:prstGeom prst="rect">
            <a:avLst/>
          </a:prstGeom>
          <a:solidFill>
            <a:srgbClr val="404040"/>
          </a:solidFill>
          <a:ln w="648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5" name="テキスト ボックス 60"/>
          <p:cNvSpPr/>
          <p:nvPr/>
        </p:nvSpPr>
        <p:spPr>
          <a:xfrm>
            <a:off x="5039640" y="4259160"/>
            <a:ext cx="3027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M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6" name="正方形/長方形 136"/>
          <p:cNvSpPr/>
          <p:nvPr/>
        </p:nvSpPr>
        <p:spPr>
          <a:xfrm>
            <a:off x="4915080" y="4489560"/>
            <a:ext cx="136440" cy="135000"/>
          </a:xfrm>
          <a:prstGeom prst="rect">
            <a:avLst/>
          </a:prstGeom>
          <a:solidFill>
            <a:srgbClr val="bfbfbf"/>
          </a:solidFill>
          <a:ln w="648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7" name="テキスト ボックス 61"/>
          <p:cNvSpPr/>
          <p:nvPr/>
        </p:nvSpPr>
        <p:spPr>
          <a:xfrm>
            <a:off x="5039640" y="4457880"/>
            <a:ext cx="3027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M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8" name="正方形/長方形 138"/>
          <p:cNvSpPr/>
          <p:nvPr/>
        </p:nvSpPr>
        <p:spPr>
          <a:xfrm>
            <a:off x="4915080" y="4691160"/>
            <a:ext cx="136440" cy="136440"/>
          </a:xfrm>
          <a:prstGeom prst="rect">
            <a:avLst/>
          </a:prstGeom>
          <a:solidFill>
            <a:srgbClr val="ffffff"/>
          </a:solidFill>
          <a:ln w="648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9" name="テキスト ボックス 62"/>
          <p:cNvSpPr/>
          <p:nvPr/>
        </p:nvSpPr>
        <p:spPr>
          <a:xfrm>
            <a:off x="5042520" y="4659480"/>
            <a:ext cx="351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M2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0" name="正方形/長方形 140"/>
          <p:cNvSpPr/>
          <p:nvPr/>
        </p:nvSpPr>
        <p:spPr>
          <a:xfrm>
            <a:off x="4915080" y="4890960"/>
            <a:ext cx="136440" cy="136800"/>
          </a:xfrm>
          <a:prstGeom prst="rect">
            <a:avLst/>
          </a:prstGeom>
          <a:blipFill rotWithShape="0">
            <a:blip r:embed="rId2"/>
            <a:srcRect/>
            <a:tile tx="0" ty="0" sx="100000" sy="100000" algn="ctr"/>
          </a:blipFill>
          <a:ln w="648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1" name="テキスト ボックス 63"/>
          <p:cNvSpPr/>
          <p:nvPr/>
        </p:nvSpPr>
        <p:spPr>
          <a:xfrm>
            <a:off x="5043600" y="4857840"/>
            <a:ext cx="452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ES-S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2" name="図 5" descr="Chi.png"/>
          <p:cNvPicPr/>
          <p:nvPr/>
        </p:nvPicPr>
        <p:blipFill>
          <a:blip r:embed="rId3"/>
          <a:srcRect l="0" t="10064" r="0" b="0"/>
          <a:stretch/>
        </p:blipFill>
        <p:spPr>
          <a:xfrm>
            <a:off x="3557520" y="4035600"/>
            <a:ext cx="1087560" cy="1062000"/>
          </a:xfrm>
          <a:prstGeom prst="rect">
            <a:avLst/>
          </a:prstGeom>
          <a:ln w="0">
            <a:noFill/>
          </a:ln>
        </p:spPr>
      </p:pic>
      <p:pic>
        <p:nvPicPr>
          <p:cNvPr id="663" name="図 13" descr="Arg.png"/>
          <p:cNvPicPr/>
          <p:nvPr/>
        </p:nvPicPr>
        <p:blipFill>
          <a:blip r:embed="rId4"/>
          <a:srcRect l="0" t="10896" r="0" b="0"/>
          <a:stretch/>
        </p:blipFill>
        <p:spPr>
          <a:xfrm>
            <a:off x="2406600" y="4035600"/>
            <a:ext cx="1100160" cy="1062000"/>
          </a:xfrm>
          <a:prstGeom prst="rect">
            <a:avLst/>
          </a:prstGeom>
          <a:ln w="0">
            <a:noFill/>
          </a:ln>
        </p:spPr>
      </p:pic>
      <p:grpSp>
        <p:nvGrpSpPr>
          <p:cNvPr id="664" name="図形グループ 50"/>
          <p:cNvGrpSpPr/>
          <p:nvPr/>
        </p:nvGrpSpPr>
        <p:grpSpPr>
          <a:xfrm>
            <a:off x="1265400" y="4035600"/>
            <a:ext cx="1087200" cy="1062000"/>
            <a:chOff x="1265400" y="4035600"/>
            <a:chExt cx="1087200" cy="1062000"/>
          </a:xfrm>
        </p:grpSpPr>
        <p:pic>
          <p:nvPicPr>
            <p:cNvPr id="665" name="図 10" descr="retu.png"/>
            <p:cNvPicPr/>
            <p:nvPr/>
          </p:nvPicPr>
          <p:blipFill>
            <a:blip r:embed="rId5"/>
            <a:srcRect l="0" t="9939" r="0" b="60760"/>
            <a:stretch/>
          </p:blipFill>
          <p:spPr>
            <a:xfrm>
              <a:off x="1265400" y="4035600"/>
              <a:ext cx="1087200" cy="345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6" name="図 11" descr="retl.png"/>
            <p:cNvPicPr/>
            <p:nvPr/>
          </p:nvPicPr>
          <p:blipFill>
            <a:blip r:embed="rId6"/>
            <a:srcRect l="0" t="44739" r="0" b="0"/>
            <a:stretch/>
          </p:blipFill>
          <p:spPr>
            <a:xfrm>
              <a:off x="1265400" y="4445640"/>
              <a:ext cx="1087200" cy="6519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667" name="図形グループ 32"/>
            <p:cNvGrpSpPr/>
            <p:nvPr/>
          </p:nvGrpSpPr>
          <p:grpSpPr>
            <a:xfrm>
              <a:off x="1416960" y="4382280"/>
              <a:ext cx="51840" cy="65160"/>
              <a:chOff x="1416960" y="4382280"/>
              <a:chExt cx="51840" cy="65160"/>
            </a:xfrm>
          </p:grpSpPr>
          <p:sp>
            <p:nvSpPr>
              <p:cNvPr id="668" name="直線コネクタ 132"/>
              <p:cNvSpPr/>
              <p:nvPr/>
            </p:nvSpPr>
            <p:spPr>
              <a:xfrm>
                <a:off x="1418760" y="4382280"/>
                <a:ext cx="48240" cy="0"/>
              </a:xfrm>
              <a:prstGeom prst="line">
                <a:avLst/>
              </a:prstGeom>
              <a:ln w="6480">
                <a:solidFill>
                  <a:srgbClr val="0d0d0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9" name="直線コネクタ 133"/>
              <p:cNvSpPr/>
              <p:nvPr/>
            </p:nvSpPr>
            <p:spPr>
              <a:xfrm>
                <a:off x="1416960" y="4447440"/>
                <a:ext cx="51840" cy="0"/>
              </a:xfrm>
              <a:prstGeom prst="line">
                <a:avLst/>
              </a:prstGeom>
              <a:ln w="6480">
                <a:solidFill>
                  <a:srgbClr val="0d0d0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670" name="テキスト ボックス 39"/>
          <p:cNvSpPr/>
          <p:nvPr/>
        </p:nvSpPr>
        <p:spPr>
          <a:xfrm>
            <a:off x="1631880" y="3730680"/>
            <a:ext cx="443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700" spc="-1" strike="noStrike">
                <a:solidFill>
                  <a:srgbClr val="000000"/>
                </a:solidFill>
                <a:latin typeface="Arial"/>
              </a:rPr>
              <a:t>Retnl</a:t>
            </a:r>
            <a:r>
              <a:rPr b="0" i="1" lang="en-US" sz="7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1" name="テキスト ボックス 40"/>
          <p:cNvSpPr/>
          <p:nvPr/>
        </p:nvSpPr>
        <p:spPr>
          <a:xfrm>
            <a:off x="2720520" y="3730680"/>
            <a:ext cx="577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700" spc="-1" strike="noStrike">
                <a:solidFill>
                  <a:srgbClr val="000000"/>
                </a:solidFill>
                <a:latin typeface="Arial"/>
              </a:rPr>
              <a:t>Arginase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2" name="テキスト ボックス 41"/>
          <p:cNvSpPr/>
          <p:nvPr/>
        </p:nvSpPr>
        <p:spPr>
          <a:xfrm>
            <a:off x="3931200" y="3730680"/>
            <a:ext cx="430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700" spc="-1" strike="noStrike">
                <a:solidFill>
                  <a:srgbClr val="000000"/>
                </a:solidFill>
                <a:latin typeface="Arial"/>
              </a:rPr>
              <a:t>Chi3l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3" name="テキスト ボックス 52"/>
          <p:cNvSpPr/>
          <p:nvPr/>
        </p:nvSpPr>
        <p:spPr>
          <a:xfrm rot="16200000">
            <a:off x="598320" y="4430520"/>
            <a:ext cx="10998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Relative expression to </a:t>
            </a:r>
            <a:r>
              <a:rPr b="0" i="1" lang="en-US" sz="600" spc="-1" strike="noStrike">
                <a:solidFill>
                  <a:srgbClr val="000000"/>
                </a:solidFill>
                <a:latin typeface="Arial"/>
              </a:rPr>
              <a:t>Hpr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74" name="図形グループ 28"/>
          <p:cNvGrpSpPr/>
          <p:nvPr/>
        </p:nvGrpSpPr>
        <p:grpSpPr>
          <a:xfrm>
            <a:off x="3833640" y="3905280"/>
            <a:ext cx="668520" cy="271080"/>
            <a:chOff x="3833640" y="3905280"/>
            <a:chExt cx="668520" cy="271080"/>
          </a:xfrm>
        </p:grpSpPr>
        <p:grpSp>
          <p:nvGrpSpPr>
            <p:cNvPr id="675" name="図形グループ 25"/>
            <p:cNvGrpSpPr/>
            <p:nvPr/>
          </p:nvGrpSpPr>
          <p:grpSpPr>
            <a:xfrm>
              <a:off x="4273200" y="4021560"/>
              <a:ext cx="228960" cy="154800"/>
              <a:chOff x="4273200" y="4021560"/>
              <a:chExt cx="228960" cy="154800"/>
            </a:xfrm>
          </p:grpSpPr>
          <p:sp>
            <p:nvSpPr>
              <p:cNvPr id="676" name="テキスト ボックス 24"/>
              <p:cNvSpPr/>
              <p:nvPr/>
            </p:nvSpPr>
            <p:spPr>
              <a:xfrm>
                <a:off x="4273200" y="4021560"/>
                <a:ext cx="228960" cy="154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400" spc="-1" strike="noStrike">
                    <a:solidFill>
                      <a:srgbClr val="000000"/>
                    </a:solidFill>
                    <a:latin typeface="Arial"/>
                  </a:rPr>
                  <a:t>**</a:t>
                </a:r>
                <a:endParaRPr b="0" lang="en-US" sz="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7" name="直線コネクタ 128"/>
              <p:cNvSpPr/>
              <p:nvPr/>
            </p:nvSpPr>
            <p:spPr>
              <a:xfrm>
                <a:off x="4279320" y="4118040"/>
                <a:ext cx="214920" cy="0"/>
              </a:xfrm>
              <a:prstGeom prst="line">
                <a:avLst/>
              </a:prstGeom>
              <a:ln w="6480">
                <a:solidFill>
                  <a:srgbClr val="0d0d0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78" name="図形グループ 26"/>
            <p:cNvGrpSpPr/>
            <p:nvPr/>
          </p:nvGrpSpPr>
          <p:grpSpPr>
            <a:xfrm>
              <a:off x="4053960" y="3963240"/>
              <a:ext cx="437760" cy="154800"/>
              <a:chOff x="4053960" y="3963240"/>
              <a:chExt cx="437760" cy="154800"/>
            </a:xfrm>
          </p:grpSpPr>
          <p:sp>
            <p:nvSpPr>
              <p:cNvPr id="679" name="テキスト ボックス 80"/>
              <p:cNvSpPr/>
              <p:nvPr/>
            </p:nvSpPr>
            <p:spPr>
              <a:xfrm>
                <a:off x="4159080" y="3963240"/>
                <a:ext cx="229320" cy="154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400" spc="-1" strike="noStrike">
                    <a:solidFill>
                      <a:srgbClr val="000000"/>
                    </a:solidFill>
                    <a:latin typeface="Arial"/>
                  </a:rPr>
                  <a:t>**</a:t>
                </a:r>
                <a:endParaRPr b="0" lang="en-US" sz="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0" name="直線コネクタ 126"/>
              <p:cNvSpPr/>
              <p:nvPr/>
            </p:nvSpPr>
            <p:spPr>
              <a:xfrm>
                <a:off x="4053960" y="4063680"/>
                <a:ext cx="437760" cy="0"/>
              </a:xfrm>
              <a:prstGeom prst="line">
                <a:avLst/>
              </a:prstGeom>
              <a:ln w="6480">
                <a:solidFill>
                  <a:srgbClr val="0d0d0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81" name="図形グループ 27"/>
            <p:cNvGrpSpPr/>
            <p:nvPr/>
          </p:nvGrpSpPr>
          <p:grpSpPr>
            <a:xfrm>
              <a:off x="3833640" y="3905280"/>
              <a:ext cx="658080" cy="154800"/>
              <a:chOff x="3833640" y="3905280"/>
              <a:chExt cx="658080" cy="154800"/>
            </a:xfrm>
          </p:grpSpPr>
          <p:sp>
            <p:nvSpPr>
              <p:cNvPr id="682" name="テキスト ボックス 81"/>
              <p:cNvSpPr/>
              <p:nvPr/>
            </p:nvSpPr>
            <p:spPr>
              <a:xfrm>
                <a:off x="4049640" y="3905280"/>
                <a:ext cx="228960" cy="154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400" spc="-1" strike="noStrike">
                    <a:solidFill>
                      <a:srgbClr val="000000"/>
                    </a:solidFill>
                    <a:latin typeface="Arial"/>
                  </a:rPr>
                  <a:t>**</a:t>
                </a:r>
                <a:endParaRPr b="0" lang="en-US" sz="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3" name="直線コネクタ 124"/>
              <p:cNvSpPr/>
              <p:nvPr/>
            </p:nvSpPr>
            <p:spPr>
              <a:xfrm>
                <a:off x="3833640" y="4006800"/>
                <a:ext cx="658080" cy="0"/>
              </a:xfrm>
              <a:prstGeom prst="line">
                <a:avLst/>
              </a:prstGeom>
              <a:ln w="6480">
                <a:solidFill>
                  <a:srgbClr val="0d0d0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684" name="図形グループ 83"/>
          <p:cNvGrpSpPr/>
          <p:nvPr/>
        </p:nvGrpSpPr>
        <p:grpSpPr>
          <a:xfrm>
            <a:off x="3135240" y="4021200"/>
            <a:ext cx="227160" cy="154800"/>
            <a:chOff x="3135240" y="4021200"/>
            <a:chExt cx="227160" cy="154800"/>
          </a:xfrm>
        </p:grpSpPr>
        <p:sp>
          <p:nvSpPr>
            <p:cNvPr id="685" name="テキスト ボックス 90"/>
            <p:cNvSpPr/>
            <p:nvPr/>
          </p:nvSpPr>
          <p:spPr>
            <a:xfrm>
              <a:off x="3135240" y="4021200"/>
              <a:ext cx="227160" cy="154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6" name="直線コネクタ 119"/>
            <p:cNvSpPr/>
            <p:nvPr/>
          </p:nvSpPr>
          <p:spPr>
            <a:xfrm>
              <a:off x="3141360" y="4118040"/>
              <a:ext cx="213120" cy="0"/>
            </a:xfrm>
            <a:prstGeom prst="line">
              <a:avLst/>
            </a:prstGeom>
            <a:ln w="6480">
              <a:solidFill>
                <a:srgbClr val="0d0d0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87" name="図形グループ 84"/>
          <p:cNvGrpSpPr/>
          <p:nvPr/>
        </p:nvGrpSpPr>
        <p:grpSpPr>
          <a:xfrm>
            <a:off x="2916360" y="3963960"/>
            <a:ext cx="506160" cy="154800"/>
            <a:chOff x="2916360" y="3963960"/>
            <a:chExt cx="506160" cy="154800"/>
          </a:xfrm>
        </p:grpSpPr>
        <p:sp>
          <p:nvSpPr>
            <p:cNvPr id="688" name="テキスト ボックス 88"/>
            <p:cNvSpPr/>
            <p:nvPr/>
          </p:nvSpPr>
          <p:spPr>
            <a:xfrm>
              <a:off x="3038400" y="3963960"/>
              <a:ext cx="263520" cy="154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9" name="直線コネクタ 117"/>
            <p:cNvSpPr/>
            <p:nvPr/>
          </p:nvSpPr>
          <p:spPr>
            <a:xfrm>
              <a:off x="2916360" y="4061880"/>
              <a:ext cx="506160" cy="0"/>
            </a:xfrm>
            <a:prstGeom prst="line">
              <a:avLst/>
            </a:prstGeom>
            <a:ln w="6480">
              <a:solidFill>
                <a:srgbClr val="0d0d0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90" name="図形グループ 85"/>
          <p:cNvGrpSpPr/>
          <p:nvPr/>
        </p:nvGrpSpPr>
        <p:grpSpPr>
          <a:xfrm>
            <a:off x="2695680" y="3905280"/>
            <a:ext cx="657000" cy="154800"/>
            <a:chOff x="2695680" y="3905280"/>
            <a:chExt cx="657000" cy="154800"/>
          </a:xfrm>
        </p:grpSpPr>
        <p:sp>
          <p:nvSpPr>
            <p:cNvPr id="691" name="テキスト ボックス 86"/>
            <p:cNvSpPr/>
            <p:nvPr/>
          </p:nvSpPr>
          <p:spPr>
            <a:xfrm>
              <a:off x="2909880" y="3905280"/>
              <a:ext cx="228600" cy="154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2" name="直線コネクタ 115"/>
            <p:cNvSpPr/>
            <p:nvPr/>
          </p:nvSpPr>
          <p:spPr>
            <a:xfrm>
              <a:off x="2695680" y="4006800"/>
              <a:ext cx="657000" cy="0"/>
            </a:xfrm>
            <a:prstGeom prst="line">
              <a:avLst/>
            </a:prstGeom>
            <a:ln w="6480">
              <a:solidFill>
                <a:srgbClr val="0d0d0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93" name="図形グループ 93"/>
          <p:cNvGrpSpPr/>
          <p:nvPr/>
        </p:nvGrpSpPr>
        <p:grpSpPr>
          <a:xfrm>
            <a:off x="1981080" y="4021200"/>
            <a:ext cx="228600" cy="154800"/>
            <a:chOff x="1981080" y="4021200"/>
            <a:chExt cx="228600" cy="154800"/>
          </a:xfrm>
        </p:grpSpPr>
        <p:sp>
          <p:nvSpPr>
            <p:cNvPr id="694" name="テキスト ボックス 100"/>
            <p:cNvSpPr/>
            <p:nvPr/>
          </p:nvSpPr>
          <p:spPr>
            <a:xfrm>
              <a:off x="1981080" y="4021200"/>
              <a:ext cx="228600" cy="154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5" name="直線コネクタ 110"/>
            <p:cNvSpPr/>
            <p:nvPr/>
          </p:nvSpPr>
          <p:spPr>
            <a:xfrm>
              <a:off x="1987200" y="4118040"/>
              <a:ext cx="214560" cy="0"/>
            </a:xfrm>
            <a:prstGeom prst="line">
              <a:avLst/>
            </a:prstGeom>
            <a:ln w="6480">
              <a:solidFill>
                <a:srgbClr val="0d0d0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96" name="図形グループ 94"/>
          <p:cNvGrpSpPr/>
          <p:nvPr/>
        </p:nvGrpSpPr>
        <p:grpSpPr>
          <a:xfrm>
            <a:off x="1762200" y="3963960"/>
            <a:ext cx="501480" cy="154800"/>
            <a:chOff x="1762200" y="3963960"/>
            <a:chExt cx="501480" cy="154800"/>
          </a:xfrm>
        </p:grpSpPr>
        <p:sp>
          <p:nvSpPr>
            <p:cNvPr id="697" name="テキスト ボックス 98"/>
            <p:cNvSpPr/>
            <p:nvPr/>
          </p:nvSpPr>
          <p:spPr>
            <a:xfrm>
              <a:off x="1881000" y="3963960"/>
              <a:ext cx="261720" cy="154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8" name="直線コネクタ 108"/>
            <p:cNvSpPr/>
            <p:nvPr/>
          </p:nvSpPr>
          <p:spPr>
            <a:xfrm>
              <a:off x="1762200" y="4061880"/>
              <a:ext cx="501480" cy="0"/>
            </a:xfrm>
            <a:prstGeom prst="line">
              <a:avLst/>
            </a:prstGeom>
            <a:ln w="6480">
              <a:solidFill>
                <a:srgbClr val="0d0d0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99" name="図形グループ 95"/>
          <p:cNvGrpSpPr/>
          <p:nvPr/>
        </p:nvGrpSpPr>
        <p:grpSpPr>
          <a:xfrm>
            <a:off x="1542960" y="3905280"/>
            <a:ext cx="720720" cy="154800"/>
            <a:chOff x="1542960" y="3905280"/>
            <a:chExt cx="720720" cy="154800"/>
          </a:xfrm>
        </p:grpSpPr>
        <p:sp>
          <p:nvSpPr>
            <p:cNvPr id="700" name="テキスト ボックス 96"/>
            <p:cNvSpPr/>
            <p:nvPr/>
          </p:nvSpPr>
          <p:spPr>
            <a:xfrm>
              <a:off x="1777680" y="3905280"/>
              <a:ext cx="249120" cy="154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1" name="直線コネクタ 106"/>
            <p:cNvSpPr/>
            <p:nvPr/>
          </p:nvSpPr>
          <p:spPr>
            <a:xfrm>
              <a:off x="1542960" y="4006800"/>
              <a:ext cx="720720" cy="0"/>
            </a:xfrm>
            <a:prstGeom prst="line">
              <a:avLst/>
            </a:prstGeom>
            <a:ln w="6480">
              <a:solidFill>
                <a:srgbClr val="0d0d0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702" name="図 3" descr="Ho.png"/>
          <p:cNvPicPr/>
          <p:nvPr/>
        </p:nvPicPr>
        <p:blipFill>
          <a:blip r:embed="rId7"/>
          <a:srcRect l="0" t="10987" r="0" b="0"/>
          <a:stretch/>
        </p:blipFill>
        <p:spPr>
          <a:xfrm>
            <a:off x="3559320" y="5446800"/>
            <a:ext cx="1082520" cy="1060200"/>
          </a:xfrm>
          <a:prstGeom prst="rect">
            <a:avLst/>
          </a:prstGeom>
          <a:ln w="0">
            <a:noFill/>
          </a:ln>
        </p:spPr>
      </p:pic>
      <p:pic>
        <p:nvPicPr>
          <p:cNvPr id="703" name="図 12" descr="tgf.png"/>
          <p:cNvPicPr/>
          <p:nvPr/>
        </p:nvPicPr>
        <p:blipFill>
          <a:blip r:embed="rId8"/>
          <a:srcRect l="0" t="11789" r="0" b="0"/>
          <a:stretch/>
        </p:blipFill>
        <p:spPr>
          <a:xfrm>
            <a:off x="4689360" y="5446800"/>
            <a:ext cx="1092240" cy="1054080"/>
          </a:xfrm>
          <a:prstGeom prst="rect">
            <a:avLst/>
          </a:prstGeom>
          <a:ln w="0">
            <a:noFill/>
          </a:ln>
        </p:spPr>
      </p:pic>
      <p:grpSp>
        <p:nvGrpSpPr>
          <p:cNvPr id="704" name="図形グループ 49"/>
          <p:cNvGrpSpPr/>
          <p:nvPr/>
        </p:nvGrpSpPr>
        <p:grpSpPr>
          <a:xfrm>
            <a:off x="1260360" y="5446800"/>
            <a:ext cx="1095480" cy="1054080"/>
            <a:chOff x="1260360" y="5446800"/>
            <a:chExt cx="1095480" cy="1054080"/>
          </a:xfrm>
        </p:grpSpPr>
        <p:pic>
          <p:nvPicPr>
            <p:cNvPr id="705" name="図 8" descr="il10u.png"/>
            <p:cNvPicPr/>
            <p:nvPr/>
          </p:nvPicPr>
          <p:blipFill>
            <a:blip r:embed="rId9"/>
            <a:srcRect l="0" t="11953" r="0" b="59734"/>
            <a:stretch/>
          </p:blipFill>
          <p:spPr>
            <a:xfrm>
              <a:off x="1261080" y="5446800"/>
              <a:ext cx="1094040" cy="338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6" name="図 16" descr="il10l.png"/>
            <p:cNvPicPr/>
            <p:nvPr/>
          </p:nvPicPr>
          <p:blipFill>
            <a:blip r:embed="rId10"/>
            <a:srcRect l="0" t="45023" r="0" b="0"/>
            <a:stretch/>
          </p:blipFill>
          <p:spPr>
            <a:xfrm>
              <a:off x="1260360" y="5842440"/>
              <a:ext cx="1095480" cy="6584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707" name="図形グループ 33"/>
            <p:cNvGrpSpPr/>
            <p:nvPr/>
          </p:nvGrpSpPr>
          <p:grpSpPr>
            <a:xfrm>
              <a:off x="1414080" y="5782320"/>
              <a:ext cx="51840" cy="62280"/>
              <a:chOff x="1414080" y="5782320"/>
              <a:chExt cx="51840" cy="62280"/>
            </a:xfrm>
          </p:grpSpPr>
          <p:sp>
            <p:nvSpPr>
              <p:cNvPr id="708" name="直線コネクタ 90"/>
              <p:cNvSpPr/>
              <p:nvPr/>
            </p:nvSpPr>
            <p:spPr>
              <a:xfrm>
                <a:off x="1415520" y="5782320"/>
                <a:ext cx="48960" cy="0"/>
              </a:xfrm>
              <a:prstGeom prst="line">
                <a:avLst/>
              </a:prstGeom>
              <a:ln w="6480">
                <a:solidFill>
                  <a:srgbClr val="0d0d0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9" name="直線コネクタ 91"/>
              <p:cNvSpPr/>
              <p:nvPr/>
            </p:nvSpPr>
            <p:spPr>
              <a:xfrm>
                <a:off x="1414080" y="5844600"/>
                <a:ext cx="51840" cy="0"/>
              </a:xfrm>
              <a:prstGeom prst="line">
                <a:avLst/>
              </a:prstGeom>
              <a:ln w="6480">
                <a:solidFill>
                  <a:srgbClr val="0d0d0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710" name="テキスト ボックス 42"/>
          <p:cNvSpPr/>
          <p:nvPr/>
        </p:nvSpPr>
        <p:spPr>
          <a:xfrm>
            <a:off x="1689480" y="5122800"/>
            <a:ext cx="351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700" spc="-1" strike="noStrike">
                <a:solidFill>
                  <a:srgbClr val="000000"/>
                </a:solidFill>
                <a:latin typeface="Arial"/>
              </a:rPr>
              <a:t>Il-1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1" name="テキスト ボックス 43"/>
          <p:cNvSpPr/>
          <p:nvPr/>
        </p:nvSpPr>
        <p:spPr>
          <a:xfrm>
            <a:off x="2820600" y="5122800"/>
            <a:ext cx="3866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700" spc="-1" strike="noStrike">
                <a:solidFill>
                  <a:srgbClr val="000000"/>
                </a:solidFill>
                <a:latin typeface="Arial"/>
              </a:rPr>
              <a:t>Nos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2" name="テキスト ボックス 44"/>
          <p:cNvSpPr/>
          <p:nvPr/>
        </p:nvSpPr>
        <p:spPr>
          <a:xfrm>
            <a:off x="3972960" y="5122800"/>
            <a:ext cx="371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700" spc="-1" strike="noStrike">
                <a:solidFill>
                  <a:srgbClr val="000000"/>
                </a:solidFill>
                <a:latin typeface="Arial"/>
              </a:rPr>
              <a:t>Ho-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3" name="テキスト ボックス 45"/>
          <p:cNvSpPr/>
          <p:nvPr/>
        </p:nvSpPr>
        <p:spPr>
          <a:xfrm>
            <a:off x="5090400" y="5122800"/>
            <a:ext cx="404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700" spc="-1" strike="noStrike">
                <a:solidFill>
                  <a:srgbClr val="000000"/>
                </a:solidFill>
                <a:latin typeface="Arial"/>
              </a:rPr>
              <a:t>Tgf</a:t>
            </a:r>
            <a:r>
              <a:rPr b="0" i="1" lang="en-US" sz="7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i="1" lang="en-US" sz="7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14" name="図形グループ 48"/>
          <p:cNvGrpSpPr/>
          <p:nvPr/>
        </p:nvGrpSpPr>
        <p:grpSpPr>
          <a:xfrm>
            <a:off x="2405160" y="5446800"/>
            <a:ext cx="1103040" cy="1054080"/>
            <a:chOff x="2405160" y="5446800"/>
            <a:chExt cx="1103040" cy="1054080"/>
          </a:xfrm>
        </p:grpSpPr>
        <p:pic>
          <p:nvPicPr>
            <p:cNvPr id="715" name="図 18" descr="Nosl.png"/>
            <p:cNvPicPr/>
            <p:nvPr/>
          </p:nvPicPr>
          <p:blipFill>
            <a:blip r:embed="rId11"/>
            <a:srcRect l="0" t="47699" r="0" b="0"/>
            <a:stretch/>
          </p:blipFill>
          <p:spPr>
            <a:xfrm>
              <a:off x="2405160" y="5874840"/>
              <a:ext cx="1103040" cy="626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16" name="図 17" descr="Nosu.png"/>
            <p:cNvPicPr/>
            <p:nvPr/>
          </p:nvPicPr>
          <p:blipFill>
            <a:blip r:embed="rId12"/>
            <a:srcRect l="0" t="7278" r="0" b="61263"/>
            <a:stretch/>
          </p:blipFill>
          <p:spPr>
            <a:xfrm>
              <a:off x="2405160" y="5446800"/>
              <a:ext cx="1101960" cy="3769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717" name="図形グループ 36"/>
            <p:cNvGrpSpPr/>
            <p:nvPr/>
          </p:nvGrpSpPr>
          <p:grpSpPr>
            <a:xfrm>
              <a:off x="2557080" y="5822640"/>
              <a:ext cx="51840" cy="53640"/>
              <a:chOff x="2557080" y="5822640"/>
              <a:chExt cx="51840" cy="53640"/>
            </a:xfrm>
          </p:grpSpPr>
          <p:sp>
            <p:nvSpPr>
              <p:cNvPr id="718" name="直線コネクタ 85"/>
              <p:cNvSpPr/>
              <p:nvPr/>
            </p:nvSpPr>
            <p:spPr>
              <a:xfrm>
                <a:off x="2558520" y="5822640"/>
                <a:ext cx="48960" cy="0"/>
              </a:xfrm>
              <a:prstGeom prst="line">
                <a:avLst/>
              </a:prstGeom>
              <a:ln w="6480">
                <a:solidFill>
                  <a:srgbClr val="0d0d0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9" name="直線コネクタ 86"/>
              <p:cNvSpPr/>
              <p:nvPr/>
            </p:nvSpPr>
            <p:spPr>
              <a:xfrm>
                <a:off x="2557080" y="5876280"/>
                <a:ext cx="51840" cy="0"/>
              </a:xfrm>
              <a:prstGeom prst="line">
                <a:avLst/>
              </a:prstGeom>
              <a:ln w="6480">
                <a:solidFill>
                  <a:srgbClr val="0d0d0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20" name="正方形/長方形 84"/>
            <p:cNvSpPr/>
            <p:nvPr/>
          </p:nvSpPr>
          <p:spPr>
            <a:xfrm>
              <a:off x="2405160" y="5843520"/>
              <a:ext cx="139680" cy="759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21" name="テキスト ボックス 51"/>
          <p:cNvSpPr/>
          <p:nvPr/>
        </p:nvSpPr>
        <p:spPr>
          <a:xfrm rot="16200000">
            <a:off x="598320" y="5830560"/>
            <a:ext cx="10998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Relative expression to </a:t>
            </a:r>
            <a:r>
              <a:rPr b="0" i="1" lang="en-US" sz="600" spc="-1" strike="noStrike">
                <a:solidFill>
                  <a:srgbClr val="000000"/>
                </a:solidFill>
                <a:latin typeface="Arial"/>
              </a:rPr>
              <a:t>Hpr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22" name="図形グループ 30"/>
          <p:cNvGrpSpPr/>
          <p:nvPr/>
        </p:nvGrpSpPr>
        <p:grpSpPr>
          <a:xfrm>
            <a:off x="1569960" y="5302080"/>
            <a:ext cx="4060800" cy="271080"/>
            <a:chOff x="1569960" y="5302080"/>
            <a:chExt cx="4060800" cy="271080"/>
          </a:xfrm>
        </p:grpSpPr>
        <p:grpSp>
          <p:nvGrpSpPr>
            <p:cNvPr id="723" name="図形グループ 102"/>
            <p:cNvGrpSpPr/>
            <p:nvPr/>
          </p:nvGrpSpPr>
          <p:grpSpPr>
            <a:xfrm>
              <a:off x="3859560" y="5302080"/>
              <a:ext cx="668880" cy="271080"/>
              <a:chOff x="3859560" y="5302080"/>
              <a:chExt cx="668880" cy="271080"/>
            </a:xfrm>
          </p:grpSpPr>
          <p:grpSp>
            <p:nvGrpSpPr>
              <p:cNvPr id="724" name="図形グループ 103"/>
              <p:cNvGrpSpPr/>
              <p:nvPr/>
            </p:nvGrpSpPr>
            <p:grpSpPr>
              <a:xfrm>
                <a:off x="4300200" y="5418360"/>
                <a:ext cx="228240" cy="154800"/>
                <a:chOff x="4300200" y="5418360"/>
                <a:chExt cx="228240" cy="154800"/>
              </a:xfrm>
            </p:grpSpPr>
            <p:sp>
              <p:nvSpPr>
                <p:cNvPr id="725" name="テキスト ボックス 110"/>
                <p:cNvSpPr/>
                <p:nvPr/>
              </p:nvSpPr>
              <p:spPr>
                <a:xfrm>
                  <a:off x="4300200" y="5418360"/>
                  <a:ext cx="228240" cy="154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400" spc="-1" strike="noStrike">
                      <a:solidFill>
                        <a:srgbClr val="000000"/>
                      </a:solidFill>
                      <a:latin typeface="Arial"/>
                    </a:rPr>
                    <a:t>**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6" name="直線コネクタ 80"/>
                <p:cNvSpPr/>
                <p:nvPr/>
              </p:nvSpPr>
              <p:spPr>
                <a:xfrm>
                  <a:off x="4308120" y="5518440"/>
                  <a:ext cx="214200" cy="0"/>
                </a:xfrm>
                <a:prstGeom prst="line">
                  <a:avLst/>
                </a:prstGeom>
                <a:ln w="6480">
                  <a:solidFill>
                    <a:srgbClr val="0d0d0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27" name="図形グループ 104"/>
              <p:cNvGrpSpPr/>
              <p:nvPr/>
            </p:nvGrpSpPr>
            <p:grpSpPr>
              <a:xfrm>
                <a:off x="4079160" y="5360040"/>
                <a:ext cx="439560" cy="154800"/>
                <a:chOff x="4079160" y="5360040"/>
                <a:chExt cx="439560" cy="154800"/>
              </a:xfrm>
            </p:grpSpPr>
            <p:sp>
              <p:nvSpPr>
                <p:cNvPr id="728" name="テキスト ボックス 108"/>
                <p:cNvSpPr/>
                <p:nvPr/>
              </p:nvSpPr>
              <p:spPr>
                <a:xfrm>
                  <a:off x="4185360" y="5360040"/>
                  <a:ext cx="228600" cy="154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400" spc="-1" strike="noStrike">
                      <a:solidFill>
                        <a:srgbClr val="000000"/>
                      </a:solidFill>
                      <a:latin typeface="Arial"/>
                    </a:rPr>
                    <a:t>**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9" name="直線コネクタ 78"/>
                <p:cNvSpPr/>
                <p:nvPr/>
              </p:nvSpPr>
              <p:spPr>
                <a:xfrm>
                  <a:off x="4079160" y="5459760"/>
                  <a:ext cx="439560" cy="0"/>
                </a:xfrm>
                <a:prstGeom prst="line">
                  <a:avLst/>
                </a:prstGeom>
                <a:ln w="6480">
                  <a:solidFill>
                    <a:srgbClr val="0d0d0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30" name="図形グループ 105"/>
              <p:cNvGrpSpPr/>
              <p:nvPr/>
            </p:nvGrpSpPr>
            <p:grpSpPr>
              <a:xfrm>
                <a:off x="3859560" y="5302080"/>
                <a:ext cx="659160" cy="154800"/>
                <a:chOff x="3859560" y="5302080"/>
                <a:chExt cx="659160" cy="154800"/>
              </a:xfrm>
            </p:grpSpPr>
            <p:sp>
              <p:nvSpPr>
                <p:cNvPr id="731" name="テキスト ボックス 106"/>
                <p:cNvSpPr/>
                <p:nvPr/>
              </p:nvSpPr>
              <p:spPr>
                <a:xfrm>
                  <a:off x="4075560" y="5302080"/>
                  <a:ext cx="227160" cy="154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400" spc="-1" strike="noStrike">
                      <a:solidFill>
                        <a:srgbClr val="000000"/>
                      </a:solidFill>
                      <a:latin typeface="Arial"/>
                    </a:rPr>
                    <a:t>**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2" name="直線コネクタ 76"/>
                <p:cNvSpPr/>
                <p:nvPr/>
              </p:nvSpPr>
              <p:spPr>
                <a:xfrm>
                  <a:off x="3859560" y="5405400"/>
                  <a:ext cx="659160" cy="0"/>
                </a:xfrm>
                <a:prstGeom prst="line">
                  <a:avLst/>
                </a:prstGeom>
                <a:ln w="6480">
                  <a:solidFill>
                    <a:srgbClr val="0d0d0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733" name="図形グループ 112"/>
            <p:cNvGrpSpPr/>
            <p:nvPr/>
          </p:nvGrpSpPr>
          <p:grpSpPr>
            <a:xfrm>
              <a:off x="2722680" y="5302080"/>
              <a:ext cx="667440" cy="271080"/>
              <a:chOff x="2722680" y="5302080"/>
              <a:chExt cx="667440" cy="271080"/>
            </a:xfrm>
          </p:grpSpPr>
          <p:grpSp>
            <p:nvGrpSpPr>
              <p:cNvPr id="734" name="図形グループ 113"/>
              <p:cNvGrpSpPr/>
              <p:nvPr/>
            </p:nvGrpSpPr>
            <p:grpSpPr>
              <a:xfrm>
                <a:off x="3161880" y="5418360"/>
                <a:ext cx="228240" cy="154800"/>
                <a:chOff x="3161880" y="5418360"/>
                <a:chExt cx="228240" cy="154800"/>
              </a:xfrm>
            </p:grpSpPr>
            <p:sp>
              <p:nvSpPr>
                <p:cNvPr id="735" name="テキスト ボックス 120"/>
                <p:cNvSpPr/>
                <p:nvPr/>
              </p:nvSpPr>
              <p:spPr>
                <a:xfrm>
                  <a:off x="3161880" y="5418360"/>
                  <a:ext cx="228240" cy="154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400" spc="-1" strike="noStrike">
                      <a:solidFill>
                        <a:srgbClr val="000000"/>
                      </a:solidFill>
                      <a:latin typeface="Arial"/>
                    </a:rPr>
                    <a:t>**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6" name="直線コネクタ 71"/>
                <p:cNvSpPr/>
                <p:nvPr/>
              </p:nvSpPr>
              <p:spPr>
                <a:xfrm>
                  <a:off x="3166560" y="5518440"/>
                  <a:ext cx="214200" cy="0"/>
                </a:xfrm>
                <a:prstGeom prst="line">
                  <a:avLst/>
                </a:prstGeom>
                <a:ln w="6480">
                  <a:solidFill>
                    <a:srgbClr val="0d0d0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37" name="図形グループ 114"/>
              <p:cNvGrpSpPr/>
              <p:nvPr/>
            </p:nvGrpSpPr>
            <p:grpSpPr>
              <a:xfrm>
                <a:off x="2942280" y="5360040"/>
                <a:ext cx="436680" cy="154800"/>
                <a:chOff x="2942280" y="5360040"/>
                <a:chExt cx="436680" cy="154800"/>
              </a:xfrm>
            </p:grpSpPr>
            <p:sp>
              <p:nvSpPr>
                <p:cNvPr id="738" name="テキスト ボックス 118"/>
                <p:cNvSpPr/>
                <p:nvPr/>
              </p:nvSpPr>
              <p:spPr>
                <a:xfrm>
                  <a:off x="3048120" y="5360040"/>
                  <a:ext cx="227880" cy="154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400" spc="-1" strike="noStrike">
                      <a:solidFill>
                        <a:srgbClr val="000000"/>
                      </a:solidFill>
                      <a:latin typeface="Arial"/>
                    </a:rPr>
                    <a:t>*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9" name="直線コネクタ 69"/>
                <p:cNvSpPr/>
                <p:nvPr/>
              </p:nvSpPr>
              <p:spPr>
                <a:xfrm>
                  <a:off x="2942280" y="5459760"/>
                  <a:ext cx="436680" cy="0"/>
                </a:xfrm>
                <a:prstGeom prst="line">
                  <a:avLst/>
                </a:prstGeom>
                <a:ln w="6480">
                  <a:solidFill>
                    <a:srgbClr val="0d0d0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40" name="図形グループ 115"/>
              <p:cNvGrpSpPr/>
              <p:nvPr/>
            </p:nvGrpSpPr>
            <p:grpSpPr>
              <a:xfrm>
                <a:off x="2722680" y="5302080"/>
                <a:ext cx="656640" cy="154800"/>
                <a:chOff x="2722680" y="5302080"/>
                <a:chExt cx="656640" cy="154800"/>
              </a:xfrm>
            </p:grpSpPr>
            <p:sp>
              <p:nvSpPr>
                <p:cNvPr id="741" name="テキスト ボックス 116"/>
                <p:cNvSpPr/>
                <p:nvPr/>
              </p:nvSpPr>
              <p:spPr>
                <a:xfrm>
                  <a:off x="2938320" y="5302080"/>
                  <a:ext cx="231480" cy="154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400" spc="-1" strike="noStrike">
                      <a:solidFill>
                        <a:srgbClr val="000000"/>
                      </a:solidFill>
                      <a:latin typeface="Arial"/>
                    </a:rPr>
                    <a:t>**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2" name="直線コネクタ 67"/>
                <p:cNvSpPr/>
                <p:nvPr/>
              </p:nvSpPr>
              <p:spPr>
                <a:xfrm>
                  <a:off x="2722680" y="5405400"/>
                  <a:ext cx="656640" cy="0"/>
                </a:xfrm>
                <a:prstGeom prst="line">
                  <a:avLst/>
                </a:prstGeom>
                <a:ln w="6480">
                  <a:solidFill>
                    <a:srgbClr val="0d0d0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743" name="図形グループ 122"/>
            <p:cNvGrpSpPr/>
            <p:nvPr/>
          </p:nvGrpSpPr>
          <p:grpSpPr>
            <a:xfrm>
              <a:off x="1569960" y="5302080"/>
              <a:ext cx="667440" cy="271080"/>
              <a:chOff x="1569960" y="5302080"/>
              <a:chExt cx="667440" cy="271080"/>
            </a:xfrm>
          </p:grpSpPr>
          <p:grpSp>
            <p:nvGrpSpPr>
              <p:cNvPr id="744" name="図形グループ 123"/>
              <p:cNvGrpSpPr/>
              <p:nvPr/>
            </p:nvGrpSpPr>
            <p:grpSpPr>
              <a:xfrm>
                <a:off x="2009160" y="5418360"/>
                <a:ext cx="228240" cy="154800"/>
                <a:chOff x="2009160" y="5418360"/>
                <a:chExt cx="228240" cy="154800"/>
              </a:xfrm>
            </p:grpSpPr>
            <p:sp>
              <p:nvSpPr>
                <p:cNvPr id="745" name="テキスト ボックス 130"/>
                <p:cNvSpPr/>
                <p:nvPr/>
              </p:nvSpPr>
              <p:spPr>
                <a:xfrm>
                  <a:off x="2009160" y="5418360"/>
                  <a:ext cx="228240" cy="154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400" spc="-1" strike="noStrike">
                      <a:solidFill>
                        <a:srgbClr val="000000"/>
                      </a:solidFill>
                      <a:latin typeface="Arial"/>
                    </a:rPr>
                    <a:t>**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6" name="直線コネクタ 62"/>
                <p:cNvSpPr/>
                <p:nvPr/>
              </p:nvSpPr>
              <p:spPr>
                <a:xfrm>
                  <a:off x="2013480" y="5518440"/>
                  <a:ext cx="214560" cy="0"/>
                </a:xfrm>
                <a:prstGeom prst="line">
                  <a:avLst/>
                </a:prstGeom>
                <a:ln w="6480">
                  <a:solidFill>
                    <a:srgbClr val="0d0d0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47" name="図形グループ 124"/>
              <p:cNvGrpSpPr/>
              <p:nvPr/>
            </p:nvGrpSpPr>
            <p:grpSpPr>
              <a:xfrm>
                <a:off x="1789560" y="5360040"/>
                <a:ext cx="436680" cy="154800"/>
                <a:chOff x="1789560" y="5360040"/>
                <a:chExt cx="436680" cy="154800"/>
              </a:xfrm>
            </p:grpSpPr>
            <p:sp>
              <p:nvSpPr>
                <p:cNvPr id="748" name="テキスト ボックス 128"/>
                <p:cNvSpPr/>
                <p:nvPr/>
              </p:nvSpPr>
              <p:spPr>
                <a:xfrm>
                  <a:off x="1894320" y="5360040"/>
                  <a:ext cx="228600" cy="154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400" spc="-1" strike="noStrike">
                      <a:solidFill>
                        <a:srgbClr val="000000"/>
                      </a:solidFill>
                      <a:latin typeface="Arial"/>
                    </a:rPr>
                    <a:t>**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9" name="直線コネクタ 60"/>
                <p:cNvSpPr/>
                <p:nvPr/>
              </p:nvSpPr>
              <p:spPr>
                <a:xfrm>
                  <a:off x="1789560" y="5459760"/>
                  <a:ext cx="436680" cy="0"/>
                </a:xfrm>
                <a:prstGeom prst="line">
                  <a:avLst/>
                </a:prstGeom>
                <a:ln w="6480">
                  <a:solidFill>
                    <a:srgbClr val="0d0d0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50" name="図形グループ 125"/>
              <p:cNvGrpSpPr/>
              <p:nvPr/>
            </p:nvGrpSpPr>
            <p:grpSpPr>
              <a:xfrm>
                <a:off x="1569960" y="5302080"/>
                <a:ext cx="656640" cy="154800"/>
                <a:chOff x="1569960" y="5302080"/>
                <a:chExt cx="656640" cy="154800"/>
              </a:xfrm>
            </p:grpSpPr>
            <p:sp>
              <p:nvSpPr>
                <p:cNvPr id="751" name="テキスト ボックス 126"/>
                <p:cNvSpPr/>
                <p:nvPr/>
              </p:nvSpPr>
              <p:spPr>
                <a:xfrm>
                  <a:off x="1783080" y="5302080"/>
                  <a:ext cx="228960" cy="154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400" spc="-1" strike="noStrike">
                      <a:solidFill>
                        <a:srgbClr val="000000"/>
                      </a:solidFill>
                      <a:latin typeface="Arial"/>
                    </a:rPr>
                    <a:t>*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2" name="直線コネクタ 58"/>
                <p:cNvSpPr/>
                <p:nvPr/>
              </p:nvSpPr>
              <p:spPr>
                <a:xfrm>
                  <a:off x="1569960" y="5405400"/>
                  <a:ext cx="656640" cy="0"/>
                </a:xfrm>
                <a:prstGeom prst="line">
                  <a:avLst/>
                </a:prstGeom>
                <a:ln w="6480">
                  <a:solidFill>
                    <a:srgbClr val="0d0d0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753" name="図形グループ 135"/>
            <p:cNvGrpSpPr/>
            <p:nvPr/>
          </p:nvGrpSpPr>
          <p:grpSpPr>
            <a:xfrm>
              <a:off x="4974480" y="5302080"/>
              <a:ext cx="656280" cy="154800"/>
              <a:chOff x="4974480" y="5302080"/>
              <a:chExt cx="656280" cy="154800"/>
            </a:xfrm>
          </p:grpSpPr>
          <p:sp>
            <p:nvSpPr>
              <p:cNvPr id="754" name="テキスト ボックス 136"/>
              <p:cNvSpPr/>
              <p:nvPr/>
            </p:nvSpPr>
            <p:spPr>
              <a:xfrm>
                <a:off x="5185800" y="5302080"/>
                <a:ext cx="227160" cy="154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4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5" name="直線コネクタ 53"/>
              <p:cNvSpPr/>
              <p:nvPr/>
            </p:nvSpPr>
            <p:spPr>
              <a:xfrm>
                <a:off x="4974480" y="5405400"/>
                <a:ext cx="656280" cy="0"/>
              </a:xfrm>
              <a:prstGeom prst="line">
                <a:avLst/>
              </a:prstGeom>
              <a:ln w="6480">
                <a:solidFill>
                  <a:srgbClr val="0d0d0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756" name="Text Box 28"/>
          <p:cNvSpPr/>
          <p:nvPr/>
        </p:nvSpPr>
        <p:spPr>
          <a:xfrm>
            <a:off x="832320" y="3516480"/>
            <a:ext cx="31932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7" name="テキスト ボックス 120"/>
          <p:cNvSpPr/>
          <p:nvPr/>
        </p:nvSpPr>
        <p:spPr>
          <a:xfrm>
            <a:off x="8280" y="-3240"/>
            <a:ext cx="953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Figure 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58" name="グループ化 1"/>
          <p:cNvGrpSpPr/>
          <p:nvPr/>
        </p:nvGrpSpPr>
        <p:grpSpPr>
          <a:xfrm>
            <a:off x="1130040" y="631440"/>
            <a:ext cx="4599360" cy="2143440"/>
            <a:chOff x="1130040" y="631440"/>
            <a:chExt cx="4599360" cy="2143440"/>
          </a:xfrm>
        </p:grpSpPr>
        <p:grpSp>
          <p:nvGrpSpPr>
            <p:cNvPr id="759" name="グループ化 58"/>
            <p:cNvGrpSpPr/>
            <p:nvPr/>
          </p:nvGrpSpPr>
          <p:grpSpPr>
            <a:xfrm>
              <a:off x="1130040" y="693000"/>
              <a:ext cx="4525560" cy="2081880"/>
              <a:chOff x="1130040" y="693000"/>
              <a:chExt cx="4525560" cy="2081880"/>
            </a:xfrm>
          </p:grpSpPr>
          <p:pic>
            <p:nvPicPr>
              <p:cNvPr id="760" name="図 24" descr=""/>
              <p:cNvPicPr/>
              <p:nvPr/>
            </p:nvPicPr>
            <p:blipFill>
              <a:blip r:embed="rId1"/>
              <a:stretch/>
            </p:blipFill>
            <p:spPr>
              <a:xfrm rot="5400000">
                <a:off x="2586960" y="-763560"/>
                <a:ext cx="1430640" cy="434376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761" name="グループ化 40"/>
              <p:cNvGrpSpPr/>
              <p:nvPr/>
            </p:nvGrpSpPr>
            <p:grpSpPr>
              <a:xfrm>
                <a:off x="1130040" y="2043720"/>
                <a:ext cx="4525560" cy="731160"/>
                <a:chOff x="1130040" y="2043720"/>
                <a:chExt cx="4525560" cy="731160"/>
              </a:xfrm>
            </p:grpSpPr>
            <p:pic>
              <p:nvPicPr>
                <p:cNvPr id="762" name="図 37" descr=""/>
                <p:cNvPicPr/>
                <p:nvPr/>
              </p:nvPicPr>
              <p:blipFill>
                <a:blip r:embed="rId2"/>
                <a:stretch/>
              </p:blipFill>
              <p:spPr>
                <a:xfrm rot="5400000">
                  <a:off x="3027240" y="146160"/>
                  <a:ext cx="731160" cy="45255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763" name="正方形/長方形 38"/>
                <p:cNvSpPr/>
                <p:nvPr/>
              </p:nvSpPr>
              <p:spPr>
                <a:xfrm rot="5400000">
                  <a:off x="5432400" y="2037960"/>
                  <a:ext cx="204840" cy="233280"/>
                </a:xfrm>
                <a:prstGeom prst="rect">
                  <a:avLst/>
                </a:prstGeom>
                <a:solidFill>
                  <a:srgbClr val="ffffff"/>
                </a:solidFill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84240" rIns="84240" tIns="42120" bIns="4212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4" name="正方形/長方形 39"/>
                <p:cNvSpPr/>
                <p:nvPr/>
              </p:nvSpPr>
              <p:spPr>
                <a:xfrm rot="5400000">
                  <a:off x="2765880" y="601920"/>
                  <a:ext cx="473040" cy="3745080"/>
                </a:xfrm>
                <a:prstGeom prst="rect">
                  <a:avLst/>
                </a:prstGeom>
                <a:solidFill>
                  <a:srgbClr val="ffffff"/>
                </a:solidFill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84240" rIns="84240" tIns="42120" bIns="4212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765" name="正方形/長方形 36"/>
            <p:cNvSpPr/>
            <p:nvPr/>
          </p:nvSpPr>
          <p:spPr>
            <a:xfrm rot="5400000">
              <a:off x="4876560" y="1065240"/>
              <a:ext cx="934920" cy="1854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84240" rIns="84240" tIns="42120" bIns="4212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66" name="図 29" descr=""/>
            <p:cNvPicPr/>
            <p:nvPr/>
          </p:nvPicPr>
          <p:blipFill>
            <a:blip r:embed="rId3"/>
            <a:srcRect l="1848" t="-40" r="38046" b="98570"/>
            <a:stretch/>
          </p:blipFill>
          <p:spPr>
            <a:xfrm rot="5400000">
              <a:off x="4698360" y="1437840"/>
              <a:ext cx="1543320" cy="69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67" name="テキスト ボックス 31"/>
            <p:cNvSpPr/>
            <p:nvPr/>
          </p:nvSpPr>
          <p:spPr>
            <a:xfrm rot="5400000">
              <a:off x="5428080" y="68616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8" name="テキスト ボックス 32"/>
            <p:cNvSpPr/>
            <p:nvPr/>
          </p:nvSpPr>
          <p:spPr>
            <a:xfrm rot="5400000">
              <a:off x="5428080" y="136152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9" name="テキスト ボックス 33"/>
            <p:cNvSpPr/>
            <p:nvPr/>
          </p:nvSpPr>
          <p:spPr>
            <a:xfrm rot="5400000">
              <a:off x="5428080" y="199512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70" name="テキスト ボックス 49"/>
          <p:cNvSpPr/>
          <p:nvPr/>
        </p:nvSpPr>
        <p:spPr>
          <a:xfrm>
            <a:off x="277920" y="7229520"/>
            <a:ext cx="6319800" cy="118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, related to Figure 1. Additional data for characterization of ES-SCs.</a:t>
            </a:r>
            <a:r>
              <a:rPr b="0" lang="ja-JP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expression of genes related to M1, M2 and macrophage markers were analyzed based on microarray data between ES-SCs and bone marrow macrophages (data from Riquelme et al., GEO Series accession number: GSE32690). To normalize the data between Riquelme et al.’s data and our data, signal intensity of ES-SCs were normalized by following formula : Adjusted value =Log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{ (Original signal intensity value)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0.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}. The results were shown in heat maps (H) and scatter plots (I-N). Linear regression was performed to evaluate the gene expression similarity between ES-SCs and macrophages (M0, M1, M2a, M2b, M2c and Mreg). R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values shown on the top of each figures (I-N)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71" name="グループ化 1"/>
          <p:cNvGrpSpPr/>
          <p:nvPr/>
        </p:nvGrpSpPr>
        <p:grpSpPr>
          <a:xfrm>
            <a:off x="463680" y="2662200"/>
            <a:ext cx="1909800" cy="1920960"/>
            <a:chOff x="463680" y="2662200"/>
            <a:chExt cx="1909800" cy="1920960"/>
          </a:xfrm>
        </p:grpSpPr>
        <p:pic>
          <p:nvPicPr>
            <p:cNvPr id="772" name="図 7" descr=""/>
            <p:cNvPicPr/>
            <p:nvPr/>
          </p:nvPicPr>
          <p:blipFill>
            <a:blip r:embed="rId4"/>
            <a:stretch/>
          </p:blipFill>
          <p:spPr>
            <a:xfrm>
              <a:off x="647280" y="2662200"/>
              <a:ext cx="1693080" cy="1782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73" name="テキスト ボックス 11"/>
            <p:cNvSpPr/>
            <p:nvPr/>
          </p:nvSpPr>
          <p:spPr>
            <a:xfrm>
              <a:off x="708120" y="4336920"/>
              <a:ext cx="1665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ignal intensity (M0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4" name="テキスト ボックス 12"/>
            <p:cNvSpPr/>
            <p:nvPr/>
          </p:nvSpPr>
          <p:spPr>
            <a:xfrm rot="16200000">
              <a:off x="-245520" y="3489120"/>
              <a:ext cx="1665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ignal intensity (ES-SCs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5" name="正方形/長方形 50"/>
            <p:cNvSpPr/>
            <p:nvPr/>
          </p:nvSpPr>
          <p:spPr>
            <a:xfrm>
              <a:off x="1013040" y="2725560"/>
              <a:ext cx="1168560" cy="2743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84240" rIns="84240" tIns="42120" bIns="4212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76" name="グループ化 2"/>
          <p:cNvGrpSpPr/>
          <p:nvPr/>
        </p:nvGrpSpPr>
        <p:grpSpPr>
          <a:xfrm>
            <a:off x="2471760" y="2662200"/>
            <a:ext cx="1909800" cy="1920960"/>
            <a:chOff x="2471760" y="2662200"/>
            <a:chExt cx="1909800" cy="1920960"/>
          </a:xfrm>
        </p:grpSpPr>
        <p:pic>
          <p:nvPicPr>
            <p:cNvPr id="777" name="図 8" descr=""/>
            <p:cNvPicPr/>
            <p:nvPr/>
          </p:nvPicPr>
          <p:blipFill>
            <a:blip r:embed="rId5"/>
            <a:stretch/>
          </p:blipFill>
          <p:spPr>
            <a:xfrm>
              <a:off x="2656080" y="2662200"/>
              <a:ext cx="1693080" cy="1782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78" name="テキスト ボックス 13"/>
            <p:cNvSpPr/>
            <p:nvPr/>
          </p:nvSpPr>
          <p:spPr>
            <a:xfrm>
              <a:off x="2716200" y="4336920"/>
              <a:ext cx="1665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ignal intensity (M1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9" name="テキスト ボックス 14"/>
            <p:cNvSpPr/>
            <p:nvPr/>
          </p:nvSpPr>
          <p:spPr>
            <a:xfrm rot="16200000">
              <a:off x="1762200" y="3489120"/>
              <a:ext cx="1665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ignal intensity (ES-SCs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0" name="正方形/長方形 51"/>
            <p:cNvSpPr/>
            <p:nvPr/>
          </p:nvSpPr>
          <p:spPr>
            <a:xfrm>
              <a:off x="2986200" y="2725560"/>
              <a:ext cx="1170000" cy="2379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84240" rIns="84240" tIns="42120" bIns="4212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81" name="グループ化 3"/>
          <p:cNvGrpSpPr/>
          <p:nvPr/>
        </p:nvGrpSpPr>
        <p:grpSpPr>
          <a:xfrm>
            <a:off x="4479840" y="2662200"/>
            <a:ext cx="1909800" cy="1920960"/>
            <a:chOff x="4479840" y="2662200"/>
            <a:chExt cx="1909800" cy="1920960"/>
          </a:xfrm>
        </p:grpSpPr>
        <p:pic>
          <p:nvPicPr>
            <p:cNvPr id="782" name="図 4" descr=""/>
            <p:cNvPicPr/>
            <p:nvPr/>
          </p:nvPicPr>
          <p:blipFill>
            <a:blip r:embed="rId6"/>
            <a:stretch/>
          </p:blipFill>
          <p:spPr>
            <a:xfrm>
              <a:off x="4664520" y="2662200"/>
              <a:ext cx="1693080" cy="1782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83" name="テキスト ボックス 15"/>
            <p:cNvSpPr/>
            <p:nvPr/>
          </p:nvSpPr>
          <p:spPr>
            <a:xfrm>
              <a:off x="4724280" y="4336920"/>
              <a:ext cx="1665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ignal intensity (M2a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4" name="テキスト ボックス 16"/>
            <p:cNvSpPr/>
            <p:nvPr/>
          </p:nvSpPr>
          <p:spPr>
            <a:xfrm rot="16200000">
              <a:off x="3770280" y="3489120"/>
              <a:ext cx="1665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ignal intensity (ES-SCs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5" name="正方形/長方形 52"/>
            <p:cNvSpPr/>
            <p:nvPr/>
          </p:nvSpPr>
          <p:spPr>
            <a:xfrm>
              <a:off x="5070240" y="2719080"/>
              <a:ext cx="1170000" cy="2394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84240" rIns="84240" tIns="42120" bIns="4212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786" name="図 5" descr=""/>
          <p:cNvPicPr/>
          <p:nvPr/>
        </p:nvPicPr>
        <p:blipFill>
          <a:blip r:embed="rId7"/>
          <a:stretch/>
        </p:blipFill>
        <p:spPr>
          <a:xfrm>
            <a:off x="647640" y="4908600"/>
            <a:ext cx="1692360" cy="1778040"/>
          </a:xfrm>
          <a:prstGeom prst="rect">
            <a:avLst/>
          </a:prstGeom>
          <a:ln w="0">
            <a:noFill/>
          </a:ln>
        </p:spPr>
      </p:pic>
      <p:sp>
        <p:nvSpPr>
          <p:cNvPr id="787" name="テキスト ボックス 17"/>
          <p:cNvSpPr/>
          <p:nvPr/>
        </p:nvSpPr>
        <p:spPr>
          <a:xfrm>
            <a:off x="708120" y="6578640"/>
            <a:ext cx="1665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ignal intensity (M2b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8" name="テキスト ボックス 18"/>
          <p:cNvSpPr/>
          <p:nvPr/>
        </p:nvSpPr>
        <p:spPr>
          <a:xfrm rot="16200000">
            <a:off x="-245520" y="5732280"/>
            <a:ext cx="1665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ignal intensity (ES-SC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9" name="正方形/長方形 53"/>
          <p:cNvSpPr/>
          <p:nvPr/>
        </p:nvSpPr>
        <p:spPr>
          <a:xfrm>
            <a:off x="973080" y="4941720"/>
            <a:ext cx="1268640" cy="265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4240" rIns="8424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90" name="図 6" descr=""/>
          <p:cNvPicPr/>
          <p:nvPr/>
        </p:nvPicPr>
        <p:blipFill>
          <a:blip r:embed="rId8"/>
          <a:stretch/>
        </p:blipFill>
        <p:spPr>
          <a:xfrm>
            <a:off x="2655720" y="4903920"/>
            <a:ext cx="1692360" cy="1782720"/>
          </a:xfrm>
          <a:prstGeom prst="rect">
            <a:avLst/>
          </a:prstGeom>
          <a:ln w="0">
            <a:noFill/>
          </a:ln>
        </p:spPr>
      </p:pic>
      <p:sp>
        <p:nvSpPr>
          <p:cNvPr id="791" name="テキスト ボックス 19"/>
          <p:cNvSpPr/>
          <p:nvPr/>
        </p:nvSpPr>
        <p:spPr>
          <a:xfrm>
            <a:off x="2716200" y="6578640"/>
            <a:ext cx="1665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ignal intensity (M2c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2" name="テキスト ボックス 20"/>
          <p:cNvSpPr/>
          <p:nvPr/>
        </p:nvSpPr>
        <p:spPr>
          <a:xfrm rot="16200000">
            <a:off x="1762200" y="5732280"/>
            <a:ext cx="1665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ignal intensity (ES-SC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3" name="正方形/長方形 54"/>
          <p:cNvSpPr/>
          <p:nvPr/>
        </p:nvSpPr>
        <p:spPr>
          <a:xfrm>
            <a:off x="3054240" y="4943520"/>
            <a:ext cx="1266840" cy="263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4240" rIns="8424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94" name="図 3" descr=""/>
          <p:cNvPicPr/>
          <p:nvPr/>
        </p:nvPicPr>
        <p:blipFill>
          <a:blip r:embed="rId9"/>
          <a:stretch/>
        </p:blipFill>
        <p:spPr>
          <a:xfrm>
            <a:off x="4665600" y="4906800"/>
            <a:ext cx="1692360" cy="1778040"/>
          </a:xfrm>
          <a:prstGeom prst="rect">
            <a:avLst/>
          </a:prstGeom>
          <a:ln w="0">
            <a:noFill/>
          </a:ln>
        </p:spPr>
      </p:pic>
      <p:sp>
        <p:nvSpPr>
          <p:cNvPr id="795" name="テキスト ボックス 21"/>
          <p:cNvSpPr/>
          <p:nvPr/>
        </p:nvSpPr>
        <p:spPr>
          <a:xfrm>
            <a:off x="4724280" y="6578640"/>
            <a:ext cx="1665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ignal intensity (Mreg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6" name="テキスト ボックス 22"/>
          <p:cNvSpPr/>
          <p:nvPr/>
        </p:nvSpPr>
        <p:spPr>
          <a:xfrm rot="16200000">
            <a:off x="3770280" y="5769000"/>
            <a:ext cx="1665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ignal intensity (ES-SC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7" name="正方形/長方形 55"/>
          <p:cNvSpPr/>
          <p:nvPr/>
        </p:nvSpPr>
        <p:spPr>
          <a:xfrm>
            <a:off x="5052960" y="4959360"/>
            <a:ext cx="1266840" cy="282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4240" rIns="8424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8" name="Text Box 28"/>
          <p:cNvSpPr/>
          <p:nvPr/>
        </p:nvSpPr>
        <p:spPr>
          <a:xfrm>
            <a:off x="655200" y="384120"/>
            <a:ext cx="30888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9" name="Text Box 28"/>
          <p:cNvSpPr/>
          <p:nvPr/>
        </p:nvSpPr>
        <p:spPr>
          <a:xfrm>
            <a:off x="279000" y="2583000"/>
            <a:ext cx="23112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0" name="Text Box 28"/>
          <p:cNvSpPr/>
          <p:nvPr/>
        </p:nvSpPr>
        <p:spPr>
          <a:xfrm>
            <a:off x="2276280" y="2583000"/>
            <a:ext cx="27972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J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1" name="Text Box 28"/>
          <p:cNvSpPr/>
          <p:nvPr/>
        </p:nvSpPr>
        <p:spPr>
          <a:xfrm>
            <a:off x="4324680" y="2583000"/>
            <a:ext cx="30888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2" name="Text Box 28"/>
          <p:cNvSpPr/>
          <p:nvPr/>
        </p:nvSpPr>
        <p:spPr>
          <a:xfrm>
            <a:off x="280080" y="4756320"/>
            <a:ext cx="28908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3" name="Text Box 28"/>
          <p:cNvSpPr/>
          <p:nvPr/>
        </p:nvSpPr>
        <p:spPr>
          <a:xfrm>
            <a:off x="2282760" y="4756320"/>
            <a:ext cx="328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4" name="Text Box 28"/>
          <p:cNvSpPr/>
          <p:nvPr/>
        </p:nvSpPr>
        <p:spPr>
          <a:xfrm>
            <a:off x="4324680" y="4756320"/>
            <a:ext cx="30888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5" name="テキスト ボックス 7"/>
          <p:cNvSpPr/>
          <p:nvPr/>
        </p:nvSpPr>
        <p:spPr>
          <a:xfrm>
            <a:off x="1500840" y="2825640"/>
            <a:ext cx="771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=0.157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6" name="テキスト ボックス 56"/>
          <p:cNvSpPr/>
          <p:nvPr/>
        </p:nvSpPr>
        <p:spPr>
          <a:xfrm>
            <a:off x="3507480" y="2825640"/>
            <a:ext cx="771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=0.298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7" name="テキスト ボックス 57"/>
          <p:cNvSpPr/>
          <p:nvPr/>
        </p:nvSpPr>
        <p:spPr>
          <a:xfrm>
            <a:off x="5526720" y="2825640"/>
            <a:ext cx="771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=0.192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8" name="テキスト ボックス 58"/>
          <p:cNvSpPr/>
          <p:nvPr/>
        </p:nvSpPr>
        <p:spPr>
          <a:xfrm>
            <a:off x="1500840" y="5040360"/>
            <a:ext cx="771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=0.149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9" name="テキスト ボックス 59"/>
          <p:cNvSpPr/>
          <p:nvPr/>
        </p:nvSpPr>
        <p:spPr>
          <a:xfrm>
            <a:off x="3507480" y="5040360"/>
            <a:ext cx="771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=0.157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0" name="テキスト ボックス 60"/>
          <p:cNvSpPr/>
          <p:nvPr/>
        </p:nvSpPr>
        <p:spPr>
          <a:xfrm>
            <a:off x="5514120" y="5040360"/>
            <a:ext cx="771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=0.187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1" name="テキスト ボックス 57"/>
          <p:cNvSpPr/>
          <p:nvPr/>
        </p:nvSpPr>
        <p:spPr>
          <a:xfrm>
            <a:off x="8280" y="-3240"/>
            <a:ext cx="953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Figure 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12" name="グループ化 25"/>
          <p:cNvGrpSpPr/>
          <p:nvPr/>
        </p:nvGrpSpPr>
        <p:grpSpPr>
          <a:xfrm>
            <a:off x="2060640" y="3546360"/>
            <a:ext cx="1182600" cy="1224000"/>
            <a:chOff x="2060640" y="3546360"/>
            <a:chExt cx="1182600" cy="1224000"/>
          </a:xfrm>
        </p:grpSpPr>
        <p:pic>
          <p:nvPicPr>
            <p:cNvPr id="813" name="図 3" descr=""/>
            <p:cNvPicPr/>
            <p:nvPr/>
          </p:nvPicPr>
          <p:blipFill>
            <a:blip r:embed="rId1"/>
            <a:stretch/>
          </p:blipFill>
          <p:spPr>
            <a:xfrm>
              <a:off x="2060640" y="3546360"/>
              <a:ext cx="1182600" cy="1224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14" name="正方形/長方形 8"/>
            <p:cNvSpPr/>
            <p:nvPr/>
          </p:nvSpPr>
          <p:spPr>
            <a:xfrm>
              <a:off x="2381040" y="4637160"/>
              <a:ext cx="731880" cy="133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5" name="正方形/長方形 11"/>
            <p:cNvSpPr/>
            <p:nvPr/>
          </p:nvSpPr>
          <p:spPr>
            <a:xfrm rot="16200000">
              <a:off x="1898280" y="4041000"/>
              <a:ext cx="730440" cy="133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16" name="テキスト ボックス 27"/>
          <p:cNvSpPr/>
          <p:nvPr/>
        </p:nvSpPr>
        <p:spPr>
          <a:xfrm>
            <a:off x="2597760" y="3678120"/>
            <a:ext cx="430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.1%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7" name="正方形/長方形 30"/>
          <p:cNvSpPr/>
          <p:nvPr/>
        </p:nvSpPr>
        <p:spPr>
          <a:xfrm>
            <a:off x="2519280" y="4238640"/>
            <a:ext cx="217440" cy="88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18" name="グループ化 22"/>
          <p:cNvGrpSpPr/>
          <p:nvPr/>
        </p:nvGrpSpPr>
        <p:grpSpPr>
          <a:xfrm>
            <a:off x="2060640" y="4554360"/>
            <a:ext cx="1182600" cy="1224000"/>
            <a:chOff x="2060640" y="4554360"/>
            <a:chExt cx="1182600" cy="1224000"/>
          </a:xfrm>
        </p:grpSpPr>
        <p:pic>
          <p:nvPicPr>
            <p:cNvPr id="819" name="図 5" descr=""/>
            <p:cNvPicPr/>
            <p:nvPr/>
          </p:nvPicPr>
          <p:blipFill>
            <a:blip r:embed="rId2"/>
            <a:stretch/>
          </p:blipFill>
          <p:spPr>
            <a:xfrm>
              <a:off x="2060640" y="4554360"/>
              <a:ext cx="1182600" cy="1224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20" name="正方形/長方形 12"/>
            <p:cNvSpPr/>
            <p:nvPr/>
          </p:nvSpPr>
          <p:spPr>
            <a:xfrm>
              <a:off x="2371680" y="5632560"/>
              <a:ext cx="731880" cy="133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1" name="正方形/長方形 13"/>
            <p:cNvSpPr/>
            <p:nvPr/>
          </p:nvSpPr>
          <p:spPr>
            <a:xfrm rot="16200000">
              <a:off x="1889640" y="5036040"/>
              <a:ext cx="728640" cy="133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22" name="グループ化 35"/>
          <p:cNvGrpSpPr/>
          <p:nvPr/>
        </p:nvGrpSpPr>
        <p:grpSpPr>
          <a:xfrm>
            <a:off x="2511360" y="4686480"/>
            <a:ext cx="500040" cy="730080"/>
            <a:chOff x="2511360" y="4686480"/>
            <a:chExt cx="500040" cy="730080"/>
          </a:xfrm>
        </p:grpSpPr>
        <p:sp>
          <p:nvSpPr>
            <p:cNvPr id="823" name="テキスト ボックス 28"/>
            <p:cNvSpPr/>
            <p:nvPr/>
          </p:nvSpPr>
          <p:spPr>
            <a:xfrm>
              <a:off x="2629440" y="4686480"/>
              <a:ext cx="381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7.8%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4" name="正方形/長方形 31"/>
            <p:cNvSpPr/>
            <p:nvPr/>
          </p:nvSpPr>
          <p:spPr>
            <a:xfrm>
              <a:off x="2511360" y="5274000"/>
              <a:ext cx="217440" cy="142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825" name="図 7" descr=""/>
          <p:cNvPicPr/>
          <p:nvPr/>
        </p:nvPicPr>
        <p:blipFill>
          <a:blip r:embed="rId3"/>
          <a:stretch/>
        </p:blipFill>
        <p:spPr>
          <a:xfrm>
            <a:off x="2060640" y="5562720"/>
            <a:ext cx="1182600" cy="1224000"/>
          </a:xfrm>
          <a:prstGeom prst="rect">
            <a:avLst/>
          </a:prstGeom>
          <a:ln w="0">
            <a:noFill/>
          </a:ln>
        </p:spPr>
      </p:pic>
      <p:grpSp>
        <p:nvGrpSpPr>
          <p:cNvPr id="826" name="グループ化 21"/>
          <p:cNvGrpSpPr/>
          <p:nvPr/>
        </p:nvGrpSpPr>
        <p:grpSpPr>
          <a:xfrm>
            <a:off x="2197080" y="5768640"/>
            <a:ext cx="915840" cy="1028880"/>
            <a:chOff x="2197080" y="5768640"/>
            <a:chExt cx="915840" cy="1028880"/>
          </a:xfrm>
        </p:grpSpPr>
        <p:sp>
          <p:nvSpPr>
            <p:cNvPr id="827" name="正方形/長方形 14"/>
            <p:cNvSpPr/>
            <p:nvPr/>
          </p:nvSpPr>
          <p:spPr>
            <a:xfrm>
              <a:off x="2381040" y="6664320"/>
              <a:ext cx="731880" cy="133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8" name="正方形/長方形 15"/>
            <p:cNvSpPr/>
            <p:nvPr/>
          </p:nvSpPr>
          <p:spPr>
            <a:xfrm rot="16200000">
              <a:off x="1897560" y="6067800"/>
              <a:ext cx="731880" cy="133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29" name="テキスト ボックス 29"/>
          <p:cNvSpPr/>
          <p:nvPr/>
        </p:nvSpPr>
        <p:spPr>
          <a:xfrm>
            <a:off x="2630160" y="5703840"/>
            <a:ext cx="381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6.4%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0" name="正方形/長方形 32"/>
          <p:cNvSpPr/>
          <p:nvPr/>
        </p:nvSpPr>
        <p:spPr>
          <a:xfrm>
            <a:off x="2543040" y="6229440"/>
            <a:ext cx="217800" cy="90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31" name="グループ化 26"/>
          <p:cNvGrpSpPr/>
          <p:nvPr/>
        </p:nvGrpSpPr>
        <p:grpSpPr>
          <a:xfrm>
            <a:off x="3330720" y="3543480"/>
            <a:ext cx="1179360" cy="1226880"/>
            <a:chOff x="3330720" y="3543480"/>
            <a:chExt cx="1179360" cy="1226880"/>
          </a:xfrm>
        </p:grpSpPr>
        <p:pic>
          <p:nvPicPr>
            <p:cNvPr id="832" name="図 2" descr=""/>
            <p:cNvPicPr/>
            <p:nvPr/>
          </p:nvPicPr>
          <p:blipFill>
            <a:blip r:embed="rId4"/>
            <a:stretch/>
          </p:blipFill>
          <p:spPr>
            <a:xfrm>
              <a:off x="3330720" y="3543480"/>
              <a:ext cx="1179360" cy="1224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33" name="正方形/長方形 9"/>
            <p:cNvSpPr/>
            <p:nvPr/>
          </p:nvSpPr>
          <p:spPr>
            <a:xfrm>
              <a:off x="3668760" y="4637160"/>
              <a:ext cx="730080" cy="133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4" name="正方形/長方形 10"/>
            <p:cNvSpPr/>
            <p:nvPr/>
          </p:nvSpPr>
          <p:spPr>
            <a:xfrm rot="16200000">
              <a:off x="3150000" y="4026240"/>
              <a:ext cx="731880" cy="133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35" name="テキスト ボックス 38"/>
          <p:cNvSpPr/>
          <p:nvPr/>
        </p:nvSpPr>
        <p:spPr>
          <a:xfrm>
            <a:off x="3758760" y="3726000"/>
            <a:ext cx="381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.7%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6" name="正方形/長方形 39"/>
          <p:cNvSpPr/>
          <p:nvPr/>
        </p:nvSpPr>
        <p:spPr>
          <a:xfrm>
            <a:off x="3738600" y="3701880"/>
            <a:ext cx="222120" cy="70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3400" bIns="234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37" name="図 4" descr=""/>
          <p:cNvPicPr/>
          <p:nvPr/>
        </p:nvPicPr>
        <p:blipFill>
          <a:blip r:embed="rId5"/>
          <a:stretch/>
        </p:blipFill>
        <p:spPr>
          <a:xfrm>
            <a:off x="3330720" y="4554360"/>
            <a:ext cx="1179360" cy="1224000"/>
          </a:xfrm>
          <a:prstGeom prst="rect">
            <a:avLst/>
          </a:prstGeom>
          <a:ln w="0">
            <a:noFill/>
          </a:ln>
        </p:spPr>
      </p:pic>
      <p:sp>
        <p:nvSpPr>
          <p:cNvPr id="838" name="正方形/長方形 18"/>
          <p:cNvSpPr/>
          <p:nvPr/>
        </p:nvSpPr>
        <p:spPr>
          <a:xfrm>
            <a:off x="3676680" y="5621400"/>
            <a:ext cx="731880" cy="133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9" name="正方形/長方形 19"/>
          <p:cNvSpPr/>
          <p:nvPr/>
        </p:nvSpPr>
        <p:spPr>
          <a:xfrm rot="16200000">
            <a:off x="3155040" y="5031000"/>
            <a:ext cx="733320" cy="131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0" name="テキスト ボックス 40"/>
          <p:cNvSpPr/>
          <p:nvPr/>
        </p:nvSpPr>
        <p:spPr>
          <a:xfrm>
            <a:off x="3758760" y="4732200"/>
            <a:ext cx="381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7.4%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1" name="正方形/長方形 41"/>
          <p:cNvSpPr/>
          <p:nvPr/>
        </p:nvSpPr>
        <p:spPr>
          <a:xfrm>
            <a:off x="3770280" y="4718160"/>
            <a:ext cx="222120" cy="50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42" name="図 6" descr=""/>
          <p:cNvPicPr/>
          <p:nvPr/>
        </p:nvPicPr>
        <p:blipFill>
          <a:blip r:embed="rId6"/>
          <a:stretch/>
        </p:blipFill>
        <p:spPr>
          <a:xfrm>
            <a:off x="3330720" y="5562720"/>
            <a:ext cx="1179360" cy="1224000"/>
          </a:xfrm>
          <a:prstGeom prst="rect">
            <a:avLst/>
          </a:prstGeom>
          <a:ln w="0">
            <a:noFill/>
          </a:ln>
        </p:spPr>
      </p:pic>
      <p:sp>
        <p:nvSpPr>
          <p:cNvPr id="843" name="正方形/長方形 16"/>
          <p:cNvSpPr/>
          <p:nvPr/>
        </p:nvSpPr>
        <p:spPr>
          <a:xfrm>
            <a:off x="3668760" y="6653160"/>
            <a:ext cx="730080" cy="133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4" name="正方形/長方形 17"/>
          <p:cNvSpPr/>
          <p:nvPr/>
        </p:nvSpPr>
        <p:spPr>
          <a:xfrm rot="16200000">
            <a:off x="3174840" y="6057360"/>
            <a:ext cx="730440" cy="133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5" name="テキスト ボックス 48"/>
          <p:cNvSpPr/>
          <p:nvPr/>
        </p:nvSpPr>
        <p:spPr>
          <a:xfrm>
            <a:off x="3758760" y="5742000"/>
            <a:ext cx="381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6.4%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6" name="正方形/長方形 49"/>
          <p:cNvSpPr/>
          <p:nvPr/>
        </p:nvSpPr>
        <p:spPr>
          <a:xfrm>
            <a:off x="3772080" y="5722920"/>
            <a:ext cx="223560" cy="61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47" name="グループ化 63"/>
          <p:cNvGrpSpPr/>
          <p:nvPr/>
        </p:nvGrpSpPr>
        <p:grpSpPr>
          <a:xfrm>
            <a:off x="1998720" y="3696840"/>
            <a:ext cx="1177920" cy="3220200"/>
            <a:chOff x="1998720" y="3696840"/>
            <a:chExt cx="1177920" cy="3220200"/>
          </a:xfrm>
        </p:grpSpPr>
        <p:grpSp>
          <p:nvGrpSpPr>
            <p:cNvPr id="848" name="グループ化 62"/>
            <p:cNvGrpSpPr/>
            <p:nvPr/>
          </p:nvGrpSpPr>
          <p:grpSpPr>
            <a:xfrm>
              <a:off x="2208240" y="3696840"/>
              <a:ext cx="968400" cy="2970720"/>
              <a:chOff x="2208240" y="3696840"/>
              <a:chExt cx="968400" cy="2970720"/>
            </a:xfrm>
          </p:grpSpPr>
          <p:cxnSp>
            <p:nvCxnSpPr>
              <p:cNvPr id="849" name="直線矢印コネクタ 54"/>
              <p:cNvCxnSpPr/>
              <p:nvPr/>
            </p:nvCxnSpPr>
            <p:spPr>
              <a:xfrm>
                <a:off x="2208240" y="6666840"/>
                <a:ext cx="968760" cy="1080"/>
              </a:xfrm>
              <a:prstGeom prst="straightConnector1">
                <a:avLst/>
              </a:prstGeom>
              <a:ln w="6480">
                <a:solidFill>
                  <a:srgbClr val="000000"/>
                </a:solidFill>
                <a:miter/>
                <a:tailEnd len="med" type="triangle" w="med"/>
              </a:ln>
            </p:spPr>
          </p:cxnSp>
          <p:cxnSp>
            <p:nvCxnSpPr>
              <p:cNvPr id="850" name="直線矢印コネクタ 56"/>
              <p:cNvCxnSpPr/>
              <p:nvPr/>
            </p:nvCxnSpPr>
            <p:spPr>
              <a:xfrm flipV="1">
                <a:off x="2208240" y="3696840"/>
                <a:ext cx="1080" cy="2970720"/>
              </a:xfrm>
              <a:prstGeom prst="straightConnector1">
                <a:avLst/>
              </a:prstGeom>
              <a:ln w="6480">
                <a:solidFill>
                  <a:srgbClr val="000000"/>
                </a:solidFill>
                <a:miter/>
                <a:tailEnd len="med" type="triangle" w="med"/>
              </a:ln>
            </p:spPr>
          </p:cxnSp>
        </p:grpSp>
        <p:sp>
          <p:nvSpPr>
            <p:cNvPr id="851" name="テキスト ボックス 60"/>
            <p:cNvSpPr/>
            <p:nvPr/>
          </p:nvSpPr>
          <p:spPr>
            <a:xfrm>
              <a:off x="2484360" y="6670800"/>
              <a:ext cx="43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D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2" name="テキスト ボックス 61"/>
            <p:cNvSpPr/>
            <p:nvPr/>
          </p:nvSpPr>
          <p:spPr>
            <a:xfrm rot="16200000">
              <a:off x="1848600" y="4989600"/>
              <a:ext cx="54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FoxP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53" name="グループ化 71"/>
          <p:cNvGrpSpPr/>
          <p:nvPr/>
        </p:nvGrpSpPr>
        <p:grpSpPr>
          <a:xfrm>
            <a:off x="3481200" y="3696480"/>
            <a:ext cx="968400" cy="2971440"/>
            <a:chOff x="3481200" y="3696480"/>
            <a:chExt cx="968400" cy="2971440"/>
          </a:xfrm>
        </p:grpSpPr>
        <p:cxnSp>
          <p:nvCxnSpPr>
            <p:cNvPr id="854" name="直線矢印コネクタ 74"/>
            <p:cNvCxnSpPr/>
            <p:nvPr/>
          </p:nvCxnSpPr>
          <p:spPr>
            <a:xfrm>
              <a:off x="3481200" y="6667200"/>
              <a:ext cx="968760" cy="1080"/>
            </a:xfrm>
            <a:prstGeom prst="straightConnector1">
              <a:avLst/>
            </a:prstGeom>
            <a:ln w="648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855" name="直線矢印コネクタ 75"/>
            <p:cNvCxnSpPr/>
            <p:nvPr/>
          </p:nvCxnSpPr>
          <p:spPr>
            <a:xfrm flipV="1">
              <a:off x="3481200" y="3696480"/>
              <a:ext cx="1080" cy="2971080"/>
            </a:xfrm>
            <a:prstGeom prst="straightConnector1">
              <a:avLst/>
            </a:prstGeom>
            <a:ln w="6480">
              <a:solidFill>
                <a:srgbClr val="000000"/>
              </a:solidFill>
              <a:miter/>
              <a:tailEnd len="med" type="triangle" w="med"/>
            </a:ln>
          </p:spPr>
        </p:cxnSp>
      </p:grpSp>
      <p:sp>
        <p:nvSpPr>
          <p:cNvPr id="856" name="テキスト ボックス 72"/>
          <p:cNvSpPr/>
          <p:nvPr/>
        </p:nvSpPr>
        <p:spPr>
          <a:xfrm>
            <a:off x="3744000" y="667080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D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7" name="テキスト ボックス 73"/>
          <p:cNvSpPr/>
          <p:nvPr/>
        </p:nvSpPr>
        <p:spPr>
          <a:xfrm rot="16200000">
            <a:off x="3121560" y="499104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oxP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8" name="テキスト ボックス 76"/>
          <p:cNvSpPr/>
          <p:nvPr/>
        </p:nvSpPr>
        <p:spPr>
          <a:xfrm>
            <a:off x="4503600" y="3852720"/>
            <a:ext cx="19501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"/>
              </a:rPr>
              <a:t>Ａ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ti-CD3 antibody coated pla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TGF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IL-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9" name="テキスト ボックス 77"/>
          <p:cNvSpPr/>
          <p:nvPr/>
        </p:nvSpPr>
        <p:spPr>
          <a:xfrm>
            <a:off x="4476960" y="4927680"/>
            <a:ext cx="9396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Untreat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Culture only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0" name="テキスト ボックス 78"/>
          <p:cNvSpPr/>
          <p:nvPr/>
        </p:nvSpPr>
        <p:spPr>
          <a:xfrm>
            <a:off x="4478040" y="5942160"/>
            <a:ext cx="8895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-cultur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ith ES-SC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1" name="テキスト ボックス 1"/>
          <p:cNvSpPr/>
          <p:nvPr/>
        </p:nvSpPr>
        <p:spPr>
          <a:xfrm>
            <a:off x="255600" y="7237440"/>
            <a:ext cx="634680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</a:t>
            </a:r>
            <a:r>
              <a:rPr b="1" lang="ja-JP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2</a:t>
            </a:r>
            <a:r>
              <a:rPr b="1" lang="ja-JP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nlike contribution</a:t>
            </a:r>
            <a:r>
              <a:rPr b="1" lang="ja-JP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f</a:t>
            </a:r>
            <a:r>
              <a:rPr b="1" lang="ja-JP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gulatory</a:t>
            </a:r>
            <a:r>
              <a:rPr b="1" lang="ja-JP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</a:t>
            </a:r>
            <a:r>
              <a:rPr b="1" lang="ja-JP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ells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 ES-SCs were stained by mAbs for T cells markers, and analyzed using flow cytometer (Upper panel). Splenocytes were used as positive control (Lower Panel).</a:t>
            </a:r>
            <a:r>
              <a:rPr b="0" lang="ja-JP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 Capacity of regulatory T cell induction. CD4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 cells were isolated from splenocytes and cultured for 72 hours in anti-CD3 mAb-coated plate with TGF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 and IL-2 (Top column, positive control), medium alone (middle column, negative control) or co-cultured with ES-SCs (bottom column). Generated cells were analyzed for the expression of FoxP3 and CD4 or CD25 using flow cytometry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2" name="テキスト ボックス 17"/>
          <p:cNvSpPr/>
          <p:nvPr/>
        </p:nvSpPr>
        <p:spPr>
          <a:xfrm>
            <a:off x="757080" y="49536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3" name="テキスト ボックス 18"/>
          <p:cNvSpPr/>
          <p:nvPr/>
        </p:nvSpPr>
        <p:spPr>
          <a:xfrm>
            <a:off x="1544760" y="335448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4" name="テキスト ボックス 4"/>
          <p:cNvSpPr/>
          <p:nvPr/>
        </p:nvSpPr>
        <p:spPr>
          <a:xfrm>
            <a:off x="5060880" y="1222200"/>
            <a:ext cx="881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S-SC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5" name="テキスト ボックス 5"/>
          <p:cNvSpPr/>
          <p:nvPr/>
        </p:nvSpPr>
        <p:spPr>
          <a:xfrm>
            <a:off x="1973160" y="741240"/>
            <a:ext cx="590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D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66" name="Picture 2" descr=""/>
          <p:cNvPicPr/>
          <p:nvPr/>
        </p:nvPicPr>
        <p:blipFill>
          <a:blip r:embed="rId7"/>
          <a:srcRect l="54456" t="10083" r="5659" b="22314"/>
          <a:stretch/>
        </p:blipFill>
        <p:spPr>
          <a:xfrm>
            <a:off x="1886040" y="1009800"/>
            <a:ext cx="744480" cy="738000"/>
          </a:xfrm>
          <a:prstGeom prst="rect">
            <a:avLst/>
          </a:prstGeom>
          <a:ln w="0">
            <a:noFill/>
          </a:ln>
        </p:spPr>
      </p:pic>
      <p:pic>
        <p:nvPicPr>
          <p:cNvPr id="867" name="Picture 2" descr=""/>
          <p:cNvPicPr/>
          <p:nvPr/>
        </p:nvPicPr>
        <p:blipFill>
          <a:blip r:embed="rId8"/>
          <a:srcRect l="56978" t="9950" r="3407" b="22446"/>
          <a:stretch/>
        </p:blipFill>
        <p:spPr>
          <a:xfrm>
            <a:off x="2674800" y="1009800"/>
            <a:ext cx="739800" cy="738000"/>
          </a:xfrm>
          <a:prstGeom prst="rect">
            <a:avLst/>
          </a:prstGeom>
          <a:ln w="0">
            <a:noFill/>
          </a:ln>
        </p:spPr>
      </p:pic>
      <p:pic>
        <p:nvPicPr>
          <p:cNvPr id="868" name="Picture 2" descr=""/>
          <p:cNvPicPr/>
          <p:nvPr/>
        </p:nvPicPr>
        <p:blipFill>
          <a:blip r:embed="rId9"/>
          <a:srcRect l="55894" t="9933" r="3564" b="21739"/>
          <a:stretch/>
        </p:blipFill>
        <p:spPr>
          <a:xfrm>
            <a:off x="3448080" y="1009800"/>
            <a:ext cx="733320" cy="738000"/>
          </a:xfrm>
          <a:prstGeom prst="rect">
            <a:avLst/>
          </a:prstGeom>
          <a:ln w="0">
            <a:noFill/>
          </a:ln>
        </p:spPr>
      </p:pic>
      <p:pic>
        <p:nvPicPr>
          <p:cNvPr id="869" name="Picture 2" descr=""/>
          <p:cNvPicPr/>
          <p:nvPr/>
        </p:nvPicPr>
        <p:blipFill>
          <a:blip r:embed="rId10"/>
          <a:srcRect l="56726" t="10248" r="3407" b="22248"/>
          <a:stretch/>
        </p:blipFill>
        <p:spPr>
          <a:xfrm>
            <a:off x="4214880" y="1009800"/>
            <a:ext cx="738000" cy="738000"/>
          </a:xfrm>
          <a:prstGeom prst="rect">
            <a:avLst/>
          </a:prstGeom>
          <a:ln w="0">
            <a:noFill/>
          </a:ln>
        </p:spPr>
      </p:pic>
      <p:pic>
        <p:nvPicPr>
          <p:cNvPr id="870" name="Picture 5" descr=""/>
          <p:cNvPicPr/>
          <p:nvPr/>
        </p:nvPicPr>
        <p:blipFill>
          <a:blip r:embed="rId11"/>
          <a:srcRect l="13623" t="37839" r="44490" b="15409"/>
          <a:stretch/>
        </p:blipFill>
        <p:spPr>
          <a:xfrm>
            <a:off x="3448080" y="1913040"/>
            <a:ext cx="741240" cy="736560"/>
          </a:xfrm>
          <a:prstGeom prst="rect">
            <a:avLst/>
          </a:prstGeom>
          <a:ln w="0">
            <a:noFill/>
          </a:ln>
        </p:spPr>
      </p:pic>
      <p:pic>
        <p:nvPicPr>
          <p:cNvPr id="871" name="Picture 2" descr=""/>
          <p:cNvPicPr/>
          <p:nvPr/>
        </p:nvPicPr>
        <p:blipFill>
          <a:blip r:embed="rId12"/>
          <a:srcRect l="23066" t="10281" r="5844" b="22017"/>
          <a:stretch/>
        </p:blipFill>
        <p:spPr>
          <a:xfrm>
            <a:off x="2674800" y="1913040"/>
            <a:ext cx="746280" cy="736560"/>
          </a:xfrm>
          <a:prstGeom prst="rect">
            <a:avLst/>
          </a:prstGeom>
          <a:ln w="0">
            <a:noFill/>
          </a:ln>
        </p:spPr>
      </p:pic>
      <p:pic>
        <p:nvPicPr>
          <p:cNvPr id="872" name="Picture 3" descr=""/>
          <p:cNvPicPr/>
          <p:nvPr/>
        </p:nvPicPr>
        <p:blipFill>
          <a:blip r:embed="rId13"/>
          <a:srcRect l="57063" t="9599" r="3255" b="22007"/>
          <a:stretch/>
        </p:blipFill>
        <p:spPr>
          <a:xfrm>
            <a:off x="4214880" y="1913040"/>
            <a:ext cx="738000" cy="736560"/>
          </a:xfrm>
          <a:prstGeom prst="rect">
            <a:avLst/>
          </a:prstGeom>
          <a:ln w="0">
            <a:noFill/>
          </a:ln>
        </p:spPr>
      </p:pic>
      <p:sp>
        <p:nvSpPr>
          <p:cNvPr id="873" name="テキスト ボックス 19"/>
          <p:cNvSpPr/>
          <p:nvPr/>
        </p:nvSpPr>
        <p:spPr>
          <a:xfrm>
            <a:off x="2749680" y="741240"/>
            <a:ext cx="590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D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4" name="テキスト ボックス 20"/>
          <p:cNvSpPr/>
          <p:nvPr/>
        </p:nvSpPr>
        <p:spPr>
          <a:xfrm>
            <a:off x="4287960" y="741240"/>
            <a:ext cx="590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CR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5" name="テキスト ボックス 21"/>
          <p:cNvSpPr/>
          <p:nvPr/>
        </p:nvSpPr>
        <p:spPr>
          <a:xfrm>
            <a:off x="3524400" y="741240"/>
            <a:ext cx="590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D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6" name="テキスト ボックス 22"/>
          <p:cNvSpPr/>
          <p:nvPr/>
        </p:nvSpPr>
        <p:spPr>
          <a:xfrm>
            <a:off x="5060880" y="2125800"/>
            <a:ext cx="1055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plenocyt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77" name="Picture 2" descr=""/>
          <p:cNvPicPr/>
          <p:nvPr/>
        </p:nvPicPr>
        <p:blipFill>
          <a:blip r:embed="rId14"/>
          <a:srcRect l="20749" t="9658" r="12817" b="22303"/>
          <a:stretch/>
        </p:blipFill>
        <p:spPr>
          <a:xfrm>
            <a:off x="1889280" y="1913040"/>
            <a:ext cx="750600" cy="736560"/>
          </a:xfrm>
          <a:prstGeom prst="rect">
            <a:avLst/>
          </a:prstGeom>
          <a:ln w="0">
            <a:noFill/>
          </a:ln>
        </p:spPr>
      </p:pic>
      <p:cxnSp>
        <p:nvCxnSpPr>
          <p:cNvPr id="878" name="直線矢印コネクタ 4"/>
          <p:cNvCxnSpPr/>
          <p:nvPr/>
        </p:nvCxnSpPr>
        <p:spPr>
          <a:xfrm>
            <a:off x="1895040" y="2738160"/>
            <a:ext cx="305676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879" name="テキスト ボックス 5"/>
          <p:cNvSpPr/>
          <p:nvPr/>
        </p:nvSpPr>
        <p:spPr>
          <a:xfrm>
            <a:off x="2575080" y="2747880"/>
            <a:ext cx="1701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luorescense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ntensit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80" name="直線矢印コネクタ 4"/>
          <p:cNvCxnSpPr/>
          <p:nvPr/>
        </p:nvCxnSpPr>
        <p:spPr>
          <a:xfrm flipV="1">
            <a:off x="1790280" y="978840"/>
            <a:ext cx="2520" cy="16563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881" name="テキスト ボックス 22"/>
          <p:cNvSpPr/>
          <p:nvPr/>
        </p:nvSpPr>
        <p:spPr>
          <a:xfrm rot="16200000">
            <a:off x="1085400" y="1694520"/>
            <a:ext cx="1055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ell numb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2" name="テキスト ボックス 71"/>
          <p:cNvSpPr/>
          <p:nvPr/>
        </p:nvSpPr>
        <p:spPr>
          <a:xfrm>
            <a:off x="8280" y="-3240"/>
            <a:ext cx="953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Figure S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83" name="図 4" descr=""/>
          <p:cNvPicPr/>
          <p:nvPr/>
        </p:nvPicPr>
        <p:blipFill>
          <a:blip r:embed="rId1"/>
          <a:stretch/>
        </p:blipFill>
        <p:spPr>
          <a:xfrm>
            <a:off x="620640" y="900000"/>
            <a:ext cx="5334120" cy="2581560"/>
          </a:xfrm>
          <a:prstGeom prst="rect">
            <a:avLst/>
          </a:prstGeom>
          <a:ln w="0">
            <a:noFill/>
          </a:ln>
        </p:spPr>
      </p:pic>
      <p:sp>
        <p:nvSpPr>
          <p:cNvPr id="884" name="Text Box 5"/>
          <p:cNvSpPr/>
          <p:nvPr/>
        </p:nvSpPr>
        <p:spPr>
          <a:xfrm>
            <a:off x="530280" y="4100400"/>
            <a:ext cx="57960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3, related to Table 1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d Table 2.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hotography of the grafts transplanted under kidney capsules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arrows indicate the transplanted sites. After taking these photos, the incisions were closed, and the recipient mice were kept alive until at least day 28.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5" name="テキスト ボックス 2"/>
          <p:cNvSpPr/>
          <p:nvPr/>
        </p:nvSpPr>
        <p:spPr>
          <a:xfrm>
            <a:off x="3074040" y="826920"/>
            <a:ext cx="160704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Recipients (Treatment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6" name="テキスト ボックス 3"/>
          <p:cNvSpPr/>
          <p:nvPr/>
        </p:nvSpPr>
        <p:spPr>
          <a:xfrm>
            <a:off x="1921320" y="1187280"/>
            <a:ext cx="762840" cy="398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29 (PB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ccept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7" name="テキスト ボックス 6"/>
          <p:cNvSpPr/>
          <p:nvPr/>
        </p:nvSpPr>
        <p:spPr>
          <a:xfrm>
            <a:off x="2930760" y="1187280"/>
            <a:ext cx="805680" cy="398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3H (PB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eject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8" name="テキスト ボックス 7"/>
          <p:cNvSpPr/>
          <p:nvPr/>
        </p:nvSpPr>
        <p:spPr>
          <a:xfrm>
            <a:off x="3873240" y="1187280"/>
            <a:ext cx="1003680" cy="398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3H (ES-SC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ccept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9" name="テキスト ボックス 8"/>
          <p:cNvSpPr/>
          <p:nvPr/>
        </p:nvSpPr>
        <p:spPr>
          <a:xfrm>
            <a:off x="4927680" y="1187280"/>
            <a:ext cx="1011240" cy="398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3H (ES-DC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eject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0" name="テキスト ボックス 9"/>
          <p:cNvSpPr/>
          <p:nvPr/>
        </p:nvSpPr>
        <p:spPr>
          <a:xfrm>
            <a:off x="757800" y="1801800"/>
            <a:ext cx="997560" cy="398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E14 E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grafts (day 14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1" name="テキスト ボックス 10"/>
          <p:cNvSpPr/>
          <p:nvPr/>
        </p:nvSpPr>
        <p:spPr>
          <a:xfrm>
            <a:off x="205920" y="2763720"/>
            <a:ext cx="1561320" cy="398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ESCs-deriv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ardiomyocytes (day 14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2" name="テキスト ボックス 10"/>
          <p:cNvSpPr/>
          <p:nvPr/>
        </p:nvSpPr>
        <p:spPr>
          <a:xfrm>
            <a:off x="8280" y="-3240"/>
            <a:ext cx="953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Figure S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93" name="Picture 2" descr="I:\E14 cardio-ES\biorad 2013-01-28 13hr 02min Oct3.jpg"/>
          <p:cNvPicPr/>
          <p:nvPr/>
        </p:nvPicPr>
        <p:blipFill>
          <a:blip r:embed="rId1"/>
          <a:stretch/>
        </p:blipFill>
        <p:spPr>
          <a:xfrm>
            <a:off x="1397160" y="1235160"/>
            <a:ext cx="502920" cy="199800"/>
          </a:xfrm>
          <a:prstGeom prst="rect">
            <a:avLst/>
          </a:prstGeom>
          <a:ln w="0">
            <a:noFill/>
          </a:ln>
        </p:spPr>
      </p:pic>
      <p:pic>
        <p:nvPicPr>
          <p:cNvPr id="894" name="Picture 3" descr="I:\E14 cardio-ES\biorad 2013-01-28 20hr 57min Tbx5 good.jpg"/>
          <p:cNvPicPr/>
          <p:nvPr/>
        </p:nvPicPr>
        <p:blipFill>
          <a:blip r:embed="rId2"/>
          <a:stretch/>
        </p:blipFill>
        <p:spPr>
          <a:xfrm>
            <a:off x="1397160" y="1731960"/>
            <a:ext cx="502920" cy="200160"/>
          </a:xfrm>
          <a:prstGeom prst="rect">
            <a:avLst/>
          </a:prstGeom>
          <a:ln w="0">
            <a:noFill/>
          </a:ln>
        </p:spPr>
      </p:pic>
      <p:sp>
        <p:nvSpPr>
          <p:cNvPr id="895" name="テキスト ボックス 3"/>
          <p:cNvSpPr/>
          <p:nvPr/>
        </p:nvSpPr>
        <p:spPr>
          <a:xfrm>
            <a:off x="816120" y="1173960"/>
            <a:ext cx="5760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Oct3/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6" name="テキスト ボックス 4"/>
          <p:cNvSpPr/>
          <p:nvPr/>
        </p:nvSpPr>
        <p:spPr>
          <a:xfrm>
            <a:off x="816120" y="1672560"/>
            <a:ext cx="5760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bx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7" name="テキスト ボックス 5"/>
          <p:cNvSpPr/>
          <p:nvPr/>
        </p:nvSpPr>
        <p:spPr>
          <a:xfrm>
            <a:off x="1407960" y="1023840"/>
            <a:ext cx="27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98" name="Picture 2" descr="C:\Users\Kudo\Desktop\大学院論文関連\最新　論文関連\論文データ\130204 TEF MLC2v aMHC BNP GAP ES-E14cardio.jpg"/>
          <p:cNvPicPr/>
          <p:nvPr/>
        </p:nvPicPr>
        <p:blipFill>
          <a:blip r:embed="rId3"/>
          <a:stretch/>
        </p:blipFill>
        <p:spPr>
          <a:xfrm>
            <a:off x="1397160" y="1482840"/>
            <a:ext cx="502920" cy="199800"/>
          </a:xfrm>
          <a:prstGeom prst="rect">
            <a:avLst/>
          </a:prstGeom>
          <a:ln w="0">
            <a:noFill/>
          </a:ln>
        </p:spPr>
      </p:pic>
      <p:sp>
        <p:nvSpPr>
          <p:cNvPr id="899" name="テキスト ボックス 7"/>
          <p:cNvSpPr/>
          <p:nvPr/>
        </p:nvSpPr>
        <p:spPr>
          <a:xfrm>
            <a:off x="816120" y="1423440"/>
            <a:ext cx="5760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ef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0" name="テキスト ボックス 8"/>
          <p:cNvSpPr/>
          <p:nvPr/>
        </p:nvSpPr>
        <p:spPr>
          <a:xfrm>
            <a:off x="816120" y="1921680"/>
            <a:ext cx="5760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lc2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01" name="Picture 4" descr="C:\Users\Kudo\Desktop\大学院論文関連\最新　論文関連\論文データ\130204 TEF MLC2v aMHC BNP GAP ES-E14cardio.jpg"/>
          <p:cNvPicPr/>
          <p:nvPr/>
        </p:nvPicPr>
        <p:blipFill>
          <a:blip r:embed="rId4"/>
          <a:stretch/>
        </p:blipFill>
        <p:spPr>
          <a:xfrm>
            <a:off x="1397160" y="1981080"/>
            <a:ext cx="502920" cy="200160"/>
          </a:xfrm>
          <a:prstGeom prst="rect">
            <a:avLst/>
          </a:prstGeom>
          <a:ln w="0">
            <a:noFill/>
          </a:ln>
        </p:spPr>
      </p:pic>
      <p:sp>
        <p:nvSpPr>
          <p:cNvPr id="902" name="テキスト ボックス 10"/>
          <p:cNvSpPr/>
          <p:nvPr/>
        </p:nvSpPr>
        <p:spPr>
          <a:xfrm>
            <a:off x="816120" y="2171160"/>
            <a:ext cx="5760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h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03" name="Picture 5" descr="C:\Users\Kudo\Desktop\大学院論文関連\最新　論文関連\論文データ\130204 TEF MLC2v aMHC BNP GAP ES-E14cardio.jpg"/>
          <p:cNvPicPr/>
          <p:nvPr/>
        </p:nvPicPr>
        <p:blipFill>
          <a:blip r:embed="rId5"/>
          <a:stretch/>
        </p:blipFill>
        <p:spPr>
          <a:xfrm>
            <a:off x="1397160" y="2478240"/>
            <a:ext cx="502920" cy="198360"/>
          </a:xfrm>
          <a:prstGeom prst="rect">
            <a:avLst/>
          </a:prstGeom>
          <a:ln w="0">
            <a:noFill/>
          </a:ln>
        </p:spPr>
      </p:pic>
      <p:sp>
        <p:nvSpPr>
          <p:cNvPr id="904" name="テキスト ボックス 12"/>
          <p:cNvSpPr/>
          <p:nvPr/>
        </p:nvSpPr>
        <p:spPr>
          <a:xfrm>
            <a:off x="816120" y="2420280"/>
            <a:ext cx="5760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Bn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05" name="Picture 6" descr="C:\Users\Kudo\Desktop\大学院論文関連\最新　論文関連\論文データ\130204 TEF MLC2v aMHC BNP GAP ES-E14cardio.jpg"/>
          <p:cNvPicPr/>
          <p:nvPr/>
        </p:nvPicPr>
        <p:blipFill>
          <a:blip r:embed="rId6"/>
          <a:stretch/>
        </p:blipFill>
        <p:spPr>
          <a:xfrm>
            <a:off x="1397160" y="2725560"/>
            <a:ext cx="502920" cy="198720"/>
          </a:xfrm>
          <a:prstGeom prst="rect">
            <a:avLst/>
          </a:prstGeom>
          <a:ln w="0">
            <a:noFill/>
          </a:ln>
        </p:spPr>
      </p:pic>
      <p:sp>
        <p:nvSpPr>
          <p:cNvPr id="906" name="テキスト ボックス 14"/>
          <p:cNvSpPr/>
          <p:nvPr/>
        </p:nvSpPr>
        <p:spPr>
          <a:xfrm>
            <a:off x="816120" y="2667960"/>
            <a:ext cx="5760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Gapd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07" name="Picture 4" descr="C:\Users\Kudo\Desktop\大学院論文関連\最新　論文関連\論文データ\130204 TEF MLC2v aMHC BNP GAP ES-E14cardio.jpg"/>
          <p:cNvPicPr/>
          <p:nvPr/>
        </p:nvPicPr>
        <p:blipFill>
          <a:blip r:embed="rId7"/>
          <a:stretch/>
        </p:blipFill>
        <p:spPr>
          <a:xfrm>
            <a:off x="1397160" y="2228760"/>
            <a:ext cx="502920" cy="198360"/>
          </a:xfrm>
          <a:prstGeom prst="rect">
            <a:avLst/>
          </a:prstGeom>
          <a:ln w="0">
            <a:noFill/>
          </a:ln>
        </p:spPr>
      </p:pic>
      <p:sp>
        <p:nvSpPr>
          <p:cNvPr id="908" name="テキスト ボックス 16"/>
          <p:cNvSpPr/>
          <p:nvPr/>
        </p:nvSpPr>
        <p:spPr>
          <a:xfrm>
            <a:off x="852480" y="3105000"/>
            <a:ext cx="1901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E: ESC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C: ESCs-derived cardiomyocyte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9" name="テキスト ボックス 17"/>
          <p:cNvSpPr/>
          <p:nvPr/>
        </p:nvSpPr>
        <p:spPr>
          <a:xfrm>
            <a:off x="744480" y="59544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0" name="テキスト ボックス 21"/>
          <p:cNvSpPr/>
          <p:nvPr/>
        </p:nvSpPr>
        <p:spPr>
          <a:xfrm>
            <a:off x="1644480" y="1023840"/>
            <a:ext cx="27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1" name="テキスト ボックス 18"/>
          <p:cNvSpPr/>
          <p:nvPr/>
        </p:nvSpPr>
        <p:spPr>
          <a:xfrm>
            <a:off x="2495520" y="57780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2" name="テキスト ボックス 19"/>
          <p:cNvSpPr/>
          <p:nvPr/>
        </p:nvSpPr>
        <p:spPr>
          <a:xfrm>
            <a:off x="4421160" y="728640"/>
            <a:ext cx="8380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sotype cont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3" name="テキスト ボックス 20"/>
          <p:cNvSpPr/>
          <p:nvPr/>
        </p:nvSpPr>
        <p:spPr>
          <a:xfrm>
            <a:off x="3576600" y="800280"/>
            <a:ext cx="838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tain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14" name="図 22" descr=""/>
          <p:cNvPicPr/>
          <p:nvPr/>
        </p:nvPicPr>
        <p:blipFill>
          <a:blip r:embed="rId8"/>
          <a:stretch/>
        </p:blipFill>
        <p:spPr>
          <a:xfrm>
            <a:off x="3568680" y="1063800"/>
            <a:ext cx="846000" cy="585720"/>
          </a:xfrm>
          <a:prstGeom prst="rect">
            <a:avLst/>
          </a:prstGeom>
          <a:ln w="0">
            <a:noFill/>
          </a:ln>
        </p:spPr>
      </p:pic>
      <p:pic>
        <p:nvPicPr>
          <p:cNvPr id="915" name="図 23" descr=""/>
          <p:cNvPicPr/>
          <p:nvPr/>
        </p:nvPicPr>
        <p:blipFill>
          <a:blip r:embed="rId9"/>
          <a:stretch/>
        </p:blipFill>
        <p:spPr>
          <a:xfrm>
            <a:off x="4425840" y="1063800"/>
            <a:ext cx="846360" cy="585720"/>
          </a:xfrm>
          <a:prstGeom prst="rect">
            <a:avLst/>
          </a:prstGeom>
          <a:ln w="0">
            <a:noFill/>
          </a:ln>
        </p:spPr>
      </p:pic>
      <p:pic>
        <p:nvPicPr>
          <p:cNvPr id="916" name="図 24" descr=""/>
          <p:cNvPicPr/>
          <p:nvPr/>
        </p:nvPicPr>
        <p:blipFill>
          <a:blip r:embed="rId10"/>
          <a:stretch/>
        </p:blipFill>
        <p:spPr>
          <a:xfrm>
            <a:off x="3568680" y="1654200"/>
            <a:ext cx="846000" cy="585720"/>
          </a:xfrm>
          <a:prstGeom prst="rect">
            <a:avLst/>
          </a:prstGeom>
          <a:ln w="0">
            <a:noFill/>
          </a:ln>
        </p:spPr>
      </p:pic>
      <p:pic>
        <p:nvPicPr>
          <p:cNvPr id="917" name="図 25" descr=""/>
          <p:cNvPicPr/>
          <p:nvPr/>
        </p:nvPicPr>
        <p:blipFill>
          <a:blip r:embed="rId11"/>
          <a:stretch/>
        </p:blipFill>
        <p:spPr>
          <a:xfrm>
            <a:off x="4425840" y="1654200"/>
            <a:ext cx="846360" cy="585720"/>
          </a:xfrm>
          <a:prstGeom prst="rect">
            <a:avLst/>
          </a:prstGeom>
          <a:ln w="0">
            <a:noFill/>
          </a:ln>
        </p:spPr>
      </p:pic>
      <p:pic>
        <p:nvPicPr>
          <p:cNvPr id="918" name="図 26" descr=""/>
          <p:cNvPicPr/>
          <p:nvPr/>
        </p:nvPicPr>
        <p:blipFill>
          <a:blip r:embed="rId12"/>
          <a:stretch/>
        </p:blipFill>
        <p:spPr>
          <a:xfrm>
            <a:off x="3568680" y="2246400"/>
            <a:ext cx="846000" cy="584280"/>
          </a:xfrm>
          <a:prstGeom prst="rect">
            <a:avLst/>
          </a:prstGeom>
          <a:ln w="0">
            <a:noFill/>
          </a:ln>
        </p:spPr>
      </p:pic>
      <p:pic>
        <p:nvPicPr>
          <p:cNvPr id="919" name="図 27" descr=""/>
          <p:cNvPicPr/>
          <p:nvPr/>
        </p:nvPicPr>
        <p:blipFill>
          <a:blip r:embed="rId13"/>
          <a:stretch/>
        </p:blipFill>
        <p:spPr>
          <a:xfrm>
            <a:off x="4425840" y="2246400"/>
            <a:ext cx="846360" cy="584280"/>
          </a:xfrm>
          <a:prstGeom prst="rect">
            <a:avLst/>
          </a:prstGeom>
          <a:ln w="0">
            <a:noFill/>
          </a:ln>
        </p:spPr>
      </p:pic>
      <p:pic>
        <p:nvPicPr>
          <p:cNvPr id="920" name="図 28" descr=""/>
          <p:cNvPicPr/>
          <p:nvPr/>
        </p:nvPicPr>
        <p:blipFill>
          <a:blip r:embed="rId14"/>
          <a:stretch/>
        </p:blipFill>
        <p:spPr>
          <a:xfrm>
            <a:off x="3568680" y="2838600"/>
            <a:ext cx="846000" cy="583920"/>
          </a:xfrm>
          <a:prstGeom prst="rect">
            <a:avLst/>
          </a:prstGeom>
          <a:ln w="0">
            <a:noFill/>
          </a:ln>
        </p:spPr>
      </p:pic>
      <p:pic>
        <p:nvPicPr>
          <p:cNvPr id="921" name="図 29" descr=""/>
          <p:cNvPicPr/>
          <p:nvPr/>
        </p:nvPicPr>
        <p:blipFill>
          <a:blip r:embed="rId15"/>
          <a:stretch/>
        </p:blipFill>
        <p:spPr>
          <a:xfrm>
            <a:off x="4425840" y="2838600"/>
            <a:ext cx="846360" cy="583920"/>
          </a:xfrm>
          <a:prstGeom prst="rect">
            <a:avLst/>
          </a:prstGeom>
          <a:ln w="0">
            <a:noFill/>
          </a:ln>
        </p:spPr>
      </p:pic>
      <p:sp>
        <p:nvSpPr>
          <p:cNvPr id="922" name="テキスト ボックス 11"/>
          <p:cNvSpPr/>
          <p:nvPr/>
        </p:nvSpPr>
        <p:spPr>
          <a:xfrm>
            <a:off x="2544840" y="2432160"/>
            <a:ext cx="1033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ropomyos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3" name="テキスト ボックス 31"/>
          <p:cNvSpPr/>
          <p:nvPr/>
        </p:nvSpPr>
        <p:spPr>
          <a:xfrm>
            <a:off x="2970360" y="1836720"/>
            <a:ext cx="608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ctin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4" name="テキスト ボックス 32"/>
          <p:cNvSpPr/>
          <p:nvPr/>
        </p:nvSpPr>
        <p:spPr>
          <a:xfrm>
            <a:off x="3098880" y="3029040"/>
            <a:ext cx="479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N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5" name="テキスト ボックス 33"/>
          <p:cNvSpPr/>
          <p:nvPr/>
        </p:nvSpPr>
        <p:spPr>
          <a:xfrm>
            <a:off x="2800440" y="1238400"/>
            <a:ext cx="777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roponin 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6" name="直線コネクタ 34"/>
          <p:cNvSpPr/>
          <p:nvPr/>
        </p:nvSpPr>
        <p:spPr>
          <a:xfrm>
            <a:off x="5049720" y="1098720"/>
            <a:ext cx="190440" cy="0"/>
          </a:xfrm>
          <a:prstGeom prst="line">
            <a:avLst/>
          </a:prstGeom>
          <a:ln w="64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7" name="直線コネクタ 35"/>
          <p:cNvSpPr/>
          <p:nvPr/>
        </p:nvSpPr>
        <p:spPr>
          <a:xfrm>
            <a:off x="4191120" y="1098720"/>
            <a:ext cx="190440" cy="0"/>
          </a:xfrm>
          <a:prstGeom prst="line">
            <a:avLst/>
          </a:prstGeom>
          <a:ln w="64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8" name="直線コネクタ 36"/>
          <p:cNvSpPr/>
          <p:nvPr/>
        </p:nvSpPr>
        <p:spPr>
          <a:xfrm>
            <a:off x="5049720" y="1689120"/>
            <a:ext cx="190440" cy="0"/>
          </a:xfrm>
          <a:prstGeom prst="line">
            <a:avLst/>
          </a:prstGeom>
          <a:ln w="64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9" name="直線コネクタ 37"/>
          <p:cNvSpPr/>
          <p:nvPr/>
        </p:nvSpPr>
        <p:spPr>
          <a:xfrm>
            <a:off x="4191120" y="1682640"/>
            <a:ext cx="190440" cy="0"/>
          </a:xfrm>
          <a:prstGeom prst="line">
            <a:avLst/>
          </a:prstGeom>
          <a:ln w="64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0" name="直線コネクタ 38"/>
          <p:cNvSpPr/>
          <p:nvPr/>
        </p:nvSpPr>
        <p:spPr>
          <a:xfrm>
            <a:off x="5049720" y="2279520"/>
            <a:ext cx="190440" cy="0"/>
          </a:xfrm>
          <a:prstGeom prst="line">
            <a:avLst/>
          </a:prstGeom>
          <a:ln w="64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1" name="直線コネクタ 39"/>
          <p:cNvSpPr/>
          <p:nvPr/>
        </p:nvSpPr>
        <p:spPr>
          <a:xfrm>
            <a:off x="4191120" y="2278080"/>
            <a:ext cx="190440" cy="0"/>
          </a:xfrm>
          <a:prstGeom prst="line">
            <a:avLst/>
          </a:prstGeom>
          <a:ln w="64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2" name="直線コネクタ 40"/>
          <p:cNvSpPr/>
          <p:nvPr/>
        </p:nvSpPr>
        <p:spPr>
          <a:xfrm>
            <a:off x="5049720" y="2871720"/>
            <a:ext cx="190440" cy="0"/>
          </a:xfrm>
          <a:prstGeom prst="line">
            <a:avLst/>
          </a:prstGeom>
          <a:ln w="64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3" name="直線コネクタ 41"/>
          <p:cNvSpPr/>
          <p:nvPr/>
        </p:nvSpPr>
        <p:spPr>
          <a:xfrm>
            <a:off x="4191120" y="2871720"/>
            <a:ext cx="190440" cy="0"/>
          </a:xfrm>
          <a:prstGeom prst="line">
            <a:avLst/>
          </a:prstGeom>
          <a:ln w="64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4" name="Text Box 45"/>
          <p:cNvSpPr/>
          <p:nvPr/>
        </p:nvSpPr>
        <p:spPr>
          <a:xfrm>
            <a:off x="295200" y="4067280"/>
            <a:ext cx="6302520" cy="103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Figure S4,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related to Fig. 3 and Table 1 and 2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(A) Expression of stem cell marker and cardiac transcription factors in ESCs and ES-SCs detected by RT-PCR. Representative data from two experiments. (B) Immunostaining for Troponin I, Actinin, Tropomyosin and ANP. ESCs-derived cardiomyocyes were attached to gelatin-coated tissue culture plate and stained with the cardiomyocyte-specific antibodies. All the samples were counter-stained with DAPI. Representative data from three experiments.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cale bars, 100 </a:t>
            </a:r>
            <a:r>
              <a:rPr b="0" lang="el-G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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5" name="テキスト ボックス 43"/>
          <p:cNvSpPr/>
          <p:nvPr/>
        </p:nvSpPr>
        <p:spPr>
          <a:xfrm>
            <a:off x="8280" y="-3240"/>
            <a:ext cx="953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Figure S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36" name="図 1" descr=""/>
          <p:cNvPicPr/>
          <p:nvPr/>
        </p:nvPicPr>
        <p:blipFill>
          <a:blip r:embed="rId1"/>
          <a:stretch/>
        </p:blipFill>
        <p:spPr>
          <a:xfrm>
            <a:off x="4672080" y="3573360"/>
            <a:ext cx="1861920" cy="1395360"/>
          </a:xfrm>
          <a:prstGeom prst="rect">
            <a:avLst/>
          </a:prstGeom>
          <a:ln w="0">
            <a:noFill/>
          </a:ln>
        </p:spPr>
      </p:pic>
      <p:pic>
        <p:nvPicPr>
          <p:cNvPr id="937" name="図 2" descr=""/>
          <p:cNvPicPr/>
          <p:nvPr/>
        </p:nvPicPr>
        <p:blipFill>
          <a:blip r:embed="rId2"/>
          <a:stretch/>
        </p:blipFill>
        <p:spPr>
          <a:xfrm>
            <a:off x="4672080" y="6419880"/>
            <a:ext cx="1861920" cy="1393920"/>
          </a:xfrm>
          <a:prstGeom prst="rect">
            <a:avLst/>
          </a:prstGeom>
          <a:ln w="0">
            <a:noFill/>
          </a:ln>
        </p:spPr>
      </p:pic>
      <p:pic>
        <p:nvPicPr>
          <p:cNvPr id="938" name="図 6" descr=""/>
          <p:cNvPicPr/>
          <p:nvPr/>
        </p:nvPicPr>
        <p:blipFill>
          <a:blip r:embed="rId3"/>
          <a:stretch/>
        </p:blipFill>
        <p:spPr>
          <a:xfrm>
            <a:off x="4672080" y="4995720"/>
            <a:ext cx="1861920" cy="1393920"/>
          </a:xfrm>
          <a:prstGeom prst="rect">
            <a:avLst/>
          </a:prstGeom>
          <a:ln w="0">
            <a:noFill/>
          </a:ln>
        </p:spPr>
      </p:pic>
      <p:pic>
        <p:nvPicPr>
          <p:cNvPr id="939" name="図 7" descr=""/>
          <p:cNvPicPr/>
          <p:nvPr/>
        </p:nvPicPr>
        <p:blipFill>
          <a:blip r:embed="rId4"/>
          <a:stretch/>
        </p:blipFill>
        <p:spPr>
          <a:xfrm>
            <a:off x="2773440" y="3573360"/>
            <a:ext cx="1861920" cy="1395360"/>
          </a:xfrm>
          <a:prstGeom prst="rect">
            <a:avLst/>
          </a:prstGeom>
          <a:ln w="0">
            <a:noFill/>
          </a:ln>
        </p:spPr>
      </p:pic>
      <p:pic>
        <p:nvPicPr>
          <p:cNvPr id="940" name="図 59" descr=""/>
          <p:cNvPicPr/>
          <p:nvPr/>
        </p:nvPicPr>
        <p:blipFill>
          <a:blip r:embed="rId5"/>
          <a:stretch/>
        </p:blipFill>
        <p:spPr>
          <a:xfrm>
            <a:off x="2773440" y="6419880"/>
            <a:ext cx="1861920" cy="1393920"/>
          </a:xfrm>
          <a:prstGeom prst="rect">
            <a:avLst/>
          </a:prstGeom>
          <a:ln w="0">
            <a:noFill/>
          </a:ln>
        </p:spPr>
      </p:pic>
      <p:pic>
        <p:nvPicPr>
          <p:cNvPr id="941" name="図 60" descr=""/>
          <p:cNvPicPr/>
          <p:nvPr/>
        </p:nvPicPr>
        <p:blipFill>
          <a:blip r:embed="rId6"/>
          <a:stretch/>
        </p:blipFill>
        <p:spPr>
          <a:xfrm>
            <a:off x="2773440" y="4995720"/>
            <a:ext cx="1861920" cy="1393920"/>
          </a:xfrm>
          <a:prstGeom prst="rect">
            <a:avLst/>
          </a:prstGeom>
          <a:ln w="0">
            <a:noFill/>
          </a:ln>
        </p:spPr>
      </p:pic>
      <p:pic>
        <p:nvPicPr>
          <p:cNvPr id="942" name="図 14" descr=""/>
          <p:cNvPicPr/>
          <p:nvPr/>
        </p:nvPicPr>
        <p:blipFill>
          <a:blip r:embed="rId7"/>
          <a:stretch/>
        </p:blipFill>
        <p:spPr>
          <a:xfrm>
            <a:off x="876240" y="3573360"/>
            <a:ext cx="1862280" cy="1395360"/>
          </a:xfrm>
          <a:prstGeom prst="rect">
            <a:avLst/>
          </a:prstGeom>
          <a:ln w="0">
            <a:noFill/>
          </a:ln>
        </p:spPr>
      </p:pic>
      <p:pic>
        <p:nvPicPr>
          <p:cNvPr id="943" name="図 15" descr=""/>
          <p:cNvPicPr/>
          <p:nvPr/>
        </p:nvPicPr>
        <p:blipFill>
          <a:blip r:embed="rId8"/>
          <a:stretch/>
        </p:blipFill>
        <p:spPr>
          <a:xfrm>
            <a:off x="876240" y="6419880"/>
            <a:ext cx="1862280" cy="1393920"/>
          </a:xfrm>
          <a:prstGeom prst="rect">
            <a:avLst/>
          </a:prstGeom>
          <a:ln w="0">
            <a:noFill/>
          </a:ln>
        </p:spPr>
      </p:pic>
      <p:pic>
        <p:nvPicPr>
          <p:cNvPr id="944" name="図 18" descr=""/>
          <p:cNvPicPr/>
          <p:nvPr/>
        </p:nvPicPr>
        <p:blipFill>
          <a:blip r:embed="rId9"/>
          <a:stretch/>
        </p:blipFill>
        <p:spPr>
          <a:xfrm>
            <a:off x="876240" y="4995720"/>
            <a:ext cx="1862280" cy="1393920"/>
          </a:xfrm>
          <a:prstGeom prst="rect">
            <a:avLst/>
          </a:prstGeom>
          <a:ln w="0">
            <a:noFill/>
          </a:ln>
        </p:spPr>
      </p:pic>
      <p:pic>
        <p:nvPicPr>
          <p:cNvPr id="945" name="図 1" descr=""/>
          <p:cNvPicPr/>
          <p:nvPr/>
        </p:nvPicPr>
        <p:blipFill>
          <a:blip r:embed="rId10"/>
          <a:stretch/>
        </p:blipFill>
        <p:spPr>
          <a:xfrm>
            <a:off x="2774880" y="415800"/>
            <a:ext cx="1860480" cy="1393920"/>
          </a:xfrm>
          <a:prstGeom prst="rect">
            <a:avLst/>
          </a:prstGeom>
          <a:ln w="0">
            <a:noFill/>
          </a:ln>
        </p:spPr>
      </p:pic>
      <p:pic>
        <p:nvPicPr>
          <p:cNvPr id="946" name="図 2" descr=""/>
          <p:cNvPicPr/>
          <p:nvPr/>
        </p:nvPicPr>
        <p:blipFill>
          <a:blip r:embed="rId11"/>
          <a:stretch/>
        </p:blipFill>
        <p:spPr>
          <a:xfrm>
            <a:off x="2774880" y="1843200"/>
            <a:ext cx="1860480" cy="1395360"/>
          </a:xfrm>
          <a:prstGeom prst="rect">
            <a:avLst/>
          </a:prstGeom>
          <a:ln w="0">
            <a:noFill/>
          </a:ln>
        </p:spPr>
      </p:pic>
      <p:pic>
        <p:nvPicPr>
          <p:cNvPr id="947" name="図 3" descr=""/>
          <p:cNvPicPr/>
          <p:nvPr/>
        </p:nvPicPr>
        <p:blipFill>
          <a:blip r:embed="rId12"/>
          <a:stretch/>
        </p:blipFill>
        <p:spPr>
          <a:xfrm>
            <a:off x="4672080" y="415800"/>
            <a:ext cx="1861920" cy="1393920"/>
          </a:xfrm>
          <a:prstGeom prst="rect">
            <a:avLst/>
          </a:prstGeom>
          <a:ln w="0">
            <a:noFill/>
          </a:ln>
        </p:spPr>
      </p:pic>
      <p:pic>
        <p:nvPicPr>
          <p:cNvPr id="948" name="図 4" descr=""/>
          <p:cNvPicPr/>
          <p:nvPr/>
        </p:nvPicPr>
        <p:blipFill>
          <a:blip r:embed="rId13"/>
          <a:stretch/>
        </p:blipFill>
        <p:spPr>
          <a:xfrm>
            <a:off x="4672080" y="1843200"/>
            <a:ext cx="1861920" cy="1395360"/>
          </a:xfrm>
          <a:prstGeom prst="rect">
            <a:avLst/>
          </a:prstGeom>
          <a:ln w="0">
            <a:noFill/>
          </a:ln>
        </p:spPr>
      </p:pic>
      <p:pic>
        <p:nvPicPr>
          <p:cNvPr id="949" name="図 5" descr=""/>
          <p:cNvPicPr/>
          <p:nvPr/>
        </p:nvPicPr>
        <p:blipFill>
          <a:blip r:embed="rId14"/>
          <a:stretch/>
        </p:blipFill>
        <p:spPr>
          <a:xfrm>
            <a:off x="876240" y="415800"/>
            <a:ext cx="1862280" cy="1393920"/>
          </a:xfrm>
          <a:prstGeom prst="rect">
            <a:avLst/>
          </a:prstGeom>
          <a:ln w="0">
            <a:noFill/>
          </a:ln>
        </p:spPr>
      </p:pic>
      <p:sp>
        <p:nvSpPr>
          <p:cNvPr id="950" name="テキスト ボックス 7"/>
          <p:cNvSpPr/>
          <p:nvPr/>
        </p:nvSpPr>
        <p:spPr>
          <a:xfrm>
            <a:off x="219960" y="880920"/>
            <a:ext cx="5374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ff"/>
                </a:solidFill>
                <a:latin typeface="Arial"/>
              </a:rPr>
              <a:t>DAP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CD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1" name="テキスト ボックス 8"/>
          <p:cNvSpPr/>
          <p:nvPr/>
        </p:nvSpPr>
        <p:spPr>
          <a:xfrm>
            <a:off x="219960" y="2309760"/>
            <a:ext cx="5724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ff"/>
                </a:solidFill>
                <a:latin typeface="Arial"/>
              </a:rPr>
              <a:t>DAP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F4/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2" name="テキスト ボックス 9"/>
          <p:cNvSpPr/>
          <p:nvPr/>
        </p:nvSpPr>
        <p:spPr>
          <a:xfrm>
            <a:off x="1239840" y="204840"/>
            <a:ext cx="1168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29       129, PB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3" name="テキスト ボックス 10"/>
          <p:cNvSpPr/>
          <p:nvPr/>
        </p:nvSpPr>
        <p:spPr>
          <a:xfrm>
            <a:off x="3107520" y="204840"/>
            <a:ext cx="1211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29       C3H, PB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4" name="テキスト ボックス 11"/>
          <p:cNvSpPr/>
          <p:nvPr/>
        </p:nvSpPr>
        <p:spPr>
          <a:xfrm>
            <a:off x="4704120" y="204840"/>
            <a:ext cx="1837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29       C3H, ES-SCs treat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955" name="直線矢印コネクタ 13"/>
          <p:cNvCxnSpPr/>
          <p:nvPr/>
        </p:nvCxnSpPr>
        <p:spPr>
          <a:xfrm>
            <a:off x="1538280" y="331560"/>
            <a:ext cx="22464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56" name="直線矢印コネクタ 16"/>
          <p:cNvCxnSpPr/>
          <p:nvPr/>
        </p:nvCxnSpPr>
        <p:spPr>
          <a:xfrm>
            <a:off x="3402000" y="331560"/>
            <a:ext cx="22464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57" name="直線矢印コネクタ 17"/>
          <p:cNvCxnSpPr/>
          <p:nvPr/>
        </p:nvCxnSpPr>
        <p:spPr>
          <a:xfrm>
            <a:off x="4983120" y="331560"/>
            <a:ext cx="22464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pic>
        <p:nvPicPr>
          <p:cNvPr id="958" name="図 2" descr=""/>
          <p:cNvPicPr/>
          <p:nvPr/>
        </p:nvPicPr>
        <p:blipFill>
          <a:blip r:embed="rId15"/>
          <a:stretch/>
        </p:blipFill>
        <p:spPr>
          <a:xfrm>
            <a:off x="876240" y="1849320"/>
            <a:ext cx="1862280" cy="1395360"/>
          </a:xfrm>
          <a:prstGeom prst="rect">
            <a:avLst/>
          </a:prstGeom>
          <a:ln w="0">
            <a:noFill/>
          </a:ln>
        </p:spPr>
      </p:pic>
      <p:sp>
        <p:nvSpPr>
          <p:cNvPr id="959" name="フリーフォーム 3"/>
          <p:cNvSpPr/>
          <p:nvPr/>
        </p:nvSpPr>
        <p:spPr>
          <a:xfrm>
            <a:off x="860400" y="2433600"/>
            <a:ext cx="1914480" cy="344520"/>
          </a:xfrm>
          <a:custGeom>
            <a:avLst/>
            <a:gdLst/>
            <a:ahLst/>
            <a:rect l="l" t="t" r="r" b="b"/>
            <a:pathLst>
              <a:path w="1885950" h="344082">
                <a:moveTo>
                  <a:pt x="0" y="339725"/>
                </a:moveTo>
                <a:lnTo>
                  <a:pt x="66675" y="330200"/>
                </a:lnTo>
                <a:cubicBezTo>
                  <a:pt x="85725" y="327025"/>
                  <a:pt x="96308" y="325967"/>
                  <a:pt x="114300" y="320675"/>
                </a:cubicBezTo>
                <a:cubicBezTo>
                  <a:pt x="132292" y="315383"/>
                  <a:pt x="153988" y="303742"/>
                  <a:pt x="174625" y="298450"/>
                </a:cubicBezTo>
                <a:cubicBezTo>
                  <a:pt x="195262" y="293158"/>
                  <a:pt x="215371" y="293158"/>
                  <a:pt x="238125" y="288925"/>
                </a:cubicBezTo>
                <a:cubicBezTo>
                  <a:pt x="260879" y="284692"/>
                  <a:pt x="286279" y="275696"/>
                  <a:pt x="311150" y="273050"/>
                </a:cubicBezTo>
                <a:cubicBezTo>
                  <a:pt x="336021" y="270404"/>
                  <a:pt x="387350" y="273050"/>
                  <a:pt x="387350" y="273050"/>
                </a:cubicBezTo>
                <a:lnTo>
                  <a:pt x="498475" y="273050"/>
                </a:lnTo>
                <a:cubicBezTo>
                  <a:pt x="525992" y="273050"/>
                  <a:pt x="532871" y="271992"/>
                  <a:pt x="552450" y="273050"/>
                </a:cubicBezTo>
                <a:cubicBezTo>
                  <a:pt x="572029" y="274108"/>
                  <a:pt x="591608" y="274638"/>
                  <a:pt x="615950" y="279400"/>
                </a:cubicBezTo>
                <a:cubicBezTo>
                  <a:pt x="640292" y="284162"/>
                  <a:pt x="698500" y="301625"/>
                  <a:pt x="698500" y="301625"/>
                </a:cubicBezTo>
                <a:lnTo>
                  <a:pt x="781050" y="323850"/>
                </a:lnTo>
                <a:cubicBezTo>
                  <a:pt x="807508" y="330729"/>
                  <a:pt x="833438" y="340254"/>
                  <a:pt x="857250" y="342900"/>
                </a:cubicBezTo>
                <a:cubicBezTo>
                  <a:pt x="881062" y="345546"/>
                  <a:pt x="898525" y="343429"/>
                  <a:pt x="923925" y="339725"/>
                </a:cubicBezTo>
                <a:cubicBezTo>
                  <a:pt x="949325" y="336021"/>
                  <a:pt x="985838" y="327025"/>
                  <a:pt x="1009650" y="320675"/>
                </a:cubicBezTo>
                <a:cubicBezTo>
                  <a:pt x="1033462" y="314325"/>
                  <a:pt x="1066800" y="301625"/>
                  <a:pt x="1066800" y="301625"/>
                </a:cubicBezTo>
                <a:cubicBezTo>
                  <a:pt x="1095375" y="291571"/>
                  <a:pt x="1147233" y="274108"/>
                  <a:pt x="1181100" y="260350"/>
                </a:cubicBezTo>
                <a:cubicBezTo>
                  <a:pt x="1214967" y="246592"/>
                  <a:pt x="1235075" y="233892"/>
                  <a:pt x="1270000" y="219075"/>
                </a:cubicBezTo>
                <a:cubicBezTo>
                  <a:pt x="1304925" y="204258"/>
                  <a:pt x="1390650" y="171450"/>
                  <a:pt x="1390650" y="171450"/>
                </a:cubicBezTo>
                <a:cubicBezTo>
                  <a:pt x="1427692" y="156633"/>
                  <a:pt x="1459442" y="141817"/>
                  <a:pt x="1492250" y="130175"/>
                </a:cubicBezTo>
                <a:cubicBezTo>
                  <a:pt x="1525058" y="118533"/>
                  <a:pt x="1548342" y="114829"/>
                  <a:pt x="1587500" y="101600"/>
                </a:cubicBezTo>
                <a:cubicBezTo>
                  <a:pt x="1626658" y="88371"/>
                  <a:pt x="1689100" y="63500"/>
                  <a:pt x="1727200" y="50800"/>
                </a:cubicBezTo>
                <a:cubicBezTo>
                  <a:pt x="1765300" y="38100"/>
                  <a:pt x="1794404" y="31221"/>
                  <a:pt x="1816100" y="25400"/>
                </a:cubicBezTo>
                <a:cubicBezTo>
                  <a:pt x="1837796" y="19579"/>
                  <a:pt x="1845733" y="20108"/>
                  <a:pt x="1857375" y="15875"/>
                </a:cubicBezTo>
                <a:cubicBezTo>
                  <a:pt x="1869017" y="11642"/>
                  <a:pt x="1877483" y="5821"/>
                  <a:pt x="1885950" y="0"/>
                </a:cubicBezTo>
              </a:path>
            </a:pathLst>
          </a:custGeom>
          <a:noFill/>
          <a:ln w="12600">
            <a:solidFill>
              <a:srgbClr val="ffffff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0" name="フリーフォーム 19"/>
          <p:cNvSpPr/>
          <p:nvPr/>
        </p:nvSpPr>
        <p:spPr>
          <a:xfrm>
            <a:off x="841320" y="1171440"/>
            <a:ext cx="1916280" cy="343080"/>
          </a:xfrm>
          <a:custGeom>
            <a:avLst/>
            <a:gdLst/>
            <a:ahLst/>
            <a:rect l="l" t="t" r="r" b="b"/>
            <a:pathLst>
              <a:path w="1885950" h="344082">
                <a:moveTo>
                  <a:pt x="0" y="339725"/>
                </a:moveTo>
                <a:lnTo>
                  <a:pt x="66675" y="330200"/>
                </a:lnTo>
                <a:cubicBezTo>
                  <a:pt x="85725" y="327025"/>
                  <a:pt x="96308" y="325967"/>
                  <a:pt x="114300" y="320675"/>
                </a:cubicBezTo>
                <a:cubicBezTo>
                  <a:pt x="132292" y="315383"/>
                  <a:pt x="153988" y="303742"/>
                  <a:pt x="174625" y="298450"/>
                </a:cubicBezTo>
                <a:cubicBezTo>
                  <a:pt x="195262" y="293158"/>
                  <a:pt x="215371" y="293158"/>
                  <a:pt x="238125" y="288925"/>
                </a:cubicBezTo>
                <a:cubicBezTo>
                  <a:pt x="260879" y="284692"/>
                  <a:pt x="286279" y="275696"/>
                  <a:pt x="311150" y="273050"/>
                </a:cubicBezTo>
                <a:cubicBezTo>
                  <a:pt x="336021" y="270404"/>
                  <a:pt x="387350" y="273050"/>
                  <a:pt x="387350" y="273050"/>
                </a:cubicBezTo>
                <a:lnTo>
                  <a:pt x="498475" y="273050"/>
                </a:lnTo>
                <a:cubicBezTo>
                  <a:pt x="525992" y="273050"/>
                  <a:pt x="532871" y="271992"/>
                  <a:pt x="552450" y="273050"/>
                </a:cubicBezTo>
                <a:cubicBezTo>
                  <a:pt x="572029" y="274108"/>
                  <a:pt x="591608" y="274638"/>
                  <a:pt x="615950" y="279400"/>
                </a:cubicBezTo>
                <a:cubicBezTo>
                  <a:pt x="640292" y="284162"/>
                  <a:pt x="698500" y="301625"/>
                  <a:pt x="698500" y="301625"/>
                </a:cubicBezTo>
                <a:lnTo>
                  <a:pt x="781050" y="323850"/>
                </a:lnTo>
                <a:cubicBezTo>
                  <a:pt x="807508" y="330729"/>
                  <a:pt x="833438" y="340254"/>
                  <a:pt x="857250" y="342900"/>
                </a:cubicBezTo>
                <a:cubicBezTo>
                  <a:pt x="881062" y="345546"/>
                  <a:pt x="898525" y="343429"/>
                  <a:pt x="923925" y="339725"/>
                </a:cubicBezTo>
                <a:cubicBezTo>
                  <a:pt x="949325" y="336021"/>
                  <a:pt x="985838" y="327025"/>
                  <a:pt x="1009650" y="320675"/>
                </a:cubicBezTo>
                <a:cubicBezTo>
                  <a:pt x="1033462" y="314325"/>
                  <a:pt x="1066800" y="301625"/>
                  <a:pt x="1066800" y="301625"/>
                </a:cubicBezTo>
                <a:cubicBezTo>
                  <a:pt x="1095375" y="291571"/>
                  <a:pt x="1147233" y="274108"/>
                  <a:pt x="1181100" y="260350"/>
                </a:cubicBezTo>
                <a:cubicBezTo>
                  <a:pt x="1214967" y="246592"/>
                  <a:pt x="1235075" y="233892"/>
                  <a:pt x="1270000" y="219075"/>
                </a:cubicBezTo>
                <a:cubicBezTo>
                  <a:pt x="1304925" y="204258"/>
                  <a:pt x="1390650" y="171450"/>
                  <a:pt x="1390650" y="171450"/>
                </a:cubicBezTo>
                <a:cubicBezTo>
                  <a:pt x="1427692" y="156633"/>
                  <a:pt x="1459442" y="141817"/>
                  <a:pt x="1492250" y="130175"/>
                </a:cubicBezTo>
                <a:cubicBezTo>
                  <a:pt x="1525058" y="118533"/>
                  <a:pt x="1548342" y="114829"/>
                  <a:pt x="1587500" y="101600"/>
                </a:cubicBezTo>
                <a:cubicBezTo>
                  <a:pt x="1626658" y="88371"/>
                  <a:pt x="1689100" y="63500"/>
                  <a:pt x="1727200" y="50800"/>
                </a:cubicBezTo>
                <a:cubicBezTo>
                  <a:pt x="1765300" y="38100"/>
                  <a:pt x="1794404" y="31221"/>
                  <a:pt x="1816100" y="25400"/>
                </a:cubicBezTo>
                <a:cubicBezTo>
                  <a:pt x="1837796" y="19579"/>
                  <a:pt x="1845733" y="20108"/>
                  <a:pt x="1857375" y="15875"/>
                </a:cubicBezTo>
                <a:cubicBezTo>
                  <a:pt x="1869017" y="11642"/>
                  <a:pt x="1877483" y="5821"/>
                  <a:pt x="1885950" y="0"/>
                </a:cubicBezTo>
              </a:path>
            </a:pathLst>
          </a:custGeom>
          <a:noFill/>
          <a:ln w="12600">
            <a:solidFill>
              <a:srgbClr val="ffffff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1" name="フリーフォーム 4"/>
          <p:cNvSpPr/>
          <p:nvPr/>
        </p:nvSpPr>
        <p:spPr>
          <a:xfrm>
            <a:off x="3130560" y="2325600"/>
            <a:ext cx="1501920" cy="924120"/>
          </a:xfrm>
          <a:custGeom>
            <a:avLst/>
            <a:gdLst/>
            <a:ahLst/>
            <a:rect l="l" t="t" r="r" b="b"/>
            <a:pathLst>
              <a:path w="1501775" h="923925">
                <a:moveTo>
                  <a:pt x="0" y="923925"/>
                </a:moveTo>
                <a:cubicBezTo>
                  <a:pt x="25929" y="900906"/>
                  <a:pt x="51858" y="877887"/>
                  <a:pt x="73025" y="854075"/>
                </a:cubicBezTo>
                <a:cubicBezTo>
                  <a:pt x="94192" y="830262"/>
                  <a:pt x="102658" y="809096"/>
                  <a:pt x="127000" y="781050"/>
                </a:cubicBezTo>
                <a:cubicBezTo>
                  <a:pt x="151342" y="753004"/>
                  <a:pt x="187854" y="711729"/>
                  <a:pt x="219075" y="685800"/>
                </a:cubicBezTo>
                <a:cubicBezTo>
                  <a:pt x="250296" y="659871"/>
                  <a:pt x="282046" y="649287"/>
                  <a:pt x="314325" y="625475"/>
                </a:cubicBezTo>
                <a:cubicBezTo>
                  <a:pt x="346604" y="601662"/>
                  <a:pt x="382058" y="567267"/>
                  <a:pt x="412750" y="542925"/>
                </a:cubicBezTo>
                <a:cubicBezTo>
                  <a:pt x="443442" y="518583"/>
                  <a:pt x="463021" y="505883"/>
                  <a:pt x="498475" y="479425"/>
                </a:cubicBezTo>
                <a:lnTo>
                  <a:pt x="625475" y="384175"/>
                </a:lnTo>
                <a:cubicBezTo>
                  <a:pt x="664633" y="355600"/>
                  <a:pt x="697442" y="330729"/>
                  <a:pt x="733425" y="307975"/>
                </a:cubicBezTo>
                <a:cubicBezTo>
                  <a:pt x="769408" y="285221"/>
                  <a:pt x="799042" y="268288"/>
                  <a:pt x="841375" y="247650"/>
                </a:cubicBezTo>
                <a:cubicBezTo>
                  <a:pt x="883708" y="227012"/>
                  <a:pt x="938742" y="205317"/>
                  <a:pt x="987425" y="184150"/>
                </a:cubicBezTo>
                <a:cubicBezTo>
                  <a:pt x="1026583" y="167217"/>
                  <a:pt x="1040871" y="158750"/>
                  <a:pt x="1076325" y="146050"/>
                </a:cubicBezTo>
                <a:cubicBezTo>
                  <a:pt x="1111779" y="133350"/>
                  <a:pt x="1151996" y="123825"/>
                  <a:pt x="1200150" y="107950"/>
                </a:cubicBezTo>
                <a:cubicBezTo>
                  <a:pt x="1248304" y="92075"/>
                  <a:pt x="1323975" y="66675"/>
                  <a:pt x="1365250" y="50800"/>
                </a:cubicBezTo>
                <a:cubicBezTo>
                  <a:pt x="1406525" y="34925"/>
                  <a:pt x="1425046" y="21167"/>
                  <a:pt x="1447800" y="12700"/>
                </a:cubicBezTo>
                <a:cubicBezTo>
                  <a:pt x="1470554" y="4233"/>
                  <a:pt x="1486164" y="2116"/>
                  <a:pt x="1501775" y="0"/>
                </a:cubicBezTo>
              </a:path>
            </a:pathLst>
          </a:custGeom>
          <a:noFill/>
          <a:ln w="12600">
            <a:solidFill>
              <a:srgbClr val="ffffff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2" name="フリーフォーム 21"/>
          <p:cNvSpPr/>
          <p:nvPr/>
        </p:nvSpPr>
        <p:spPr>
          <a:xfrm>
            <a:off x="3268800" y="990720"/>
            <a:ext cx="1363680" cy="819000"/>
          </a:xfrm>
          <a:custGeom>
            <a:avLst/>
            <a:gdLst/>
            <a:ahLst/>
            <a:rect l="l" t="t" r="r" b="b"/>
            <a:pathLst>
              <a:path w="1501775" h="923925">
                <a:moveTo>
                  <a:pt x="0" y="923925"/>
                </a:moveTo>
                <a:cubicBezTo>
                  <a:pt x="25929" y="900906"/>
                  <a:pt x="48945" y="876095"/>
                  <a:pt x="73025" y="854075"/>
                </a:cubicBezTo>
                <a:cubicBezTo>
                  <a:pt x="97105" y="832055"/>
                  <a:pt x="119559" y="815070"/>
                  <a:pt x="144483" y="791803"/>
                </a:cubicBezTo>
                <a:cubicBezTo>
                  <a:pt x="169407" y="768536"/>
                  <a:pt x="191933" y="739807"/>
                  <a:pt x="222571" y="714475"/>
                </a:cubicBezTo>
                <a:cubicBezTo>
                  <a:pt x="253209" y="689143"/>
                  <a:pt x="296033" y="661235"/>
                  <a:pt x="328312" y="639812"/>
                </a:cubicBezTo>
                <a:cubicBezTo>
                  <a:pt x="360591" y="618389"/>
                  <a:pt x="381262" y="608674"/>
                  <a:pt x="416247" y="585937"/>
                </a:cubicBezTo>
                <a:cubicBezTo>
                  <a:pt x="451232" y="563200"/>
                  <a:pt x="503346" y="529505"/>
                  <a:pt x="538224" y="503388"/>
                </a:cubicBezTo>
                <a:cubicBezTo>
                  <a:pt x="573102" y="477271"/>
                  <a:pt x="592446" y="456426"/>
                  <a:pt x="625515" y="429234"/>
                </a:cubicBezTo>
                <a:cubicBezTo>
                  <a:pt x="658584" y="402042"/>
                  <a:pt x="696001" y="369303"/>
                  <a:pt x="736640" y="340234"/>
                </a:cubicBezTo>
                <a:cubicBezTo>
                  <a:pt x="777279" y="311165"/>
                  <a:pt x="827551" y="280833"/>
                  <a:pt x="869348" y="254819"/>
                </a:cubicBezTo>
                <a:cubicBezTo>
                  <a:pt x="911145" y="228805"/>
                  <a:pt x="952929" y="202278"/>
                  <a:pt x="987425" y="184150"/>
                </a:cubicBezTo>
                <a:cubicBezTo>
                  <a:pt x="1021921" y="166022"/>
                  <a:pt x="1040871" y="158750"/>
                  <a:pt x="1076325" y="146050"/>
                </a:cubicBezTo>
                <a:cubicBezTo>
                  <a:pt x="1111779" y="133350"/>
                  <a:pt x="1151996" y="123825"/>
                  <a:pt x="1200150" y="107950"/>
                </a:cubicBezTo>
                <a:cubicBezTo>
                  <a:pt x="1248304" y="92075"/>
                  <a:pt x="1323975" y="66675"/>
                  <a:pt x="1365250" y="50800"/>
                </a:cubicBezTo>
                <a:cubicBezTo>
                  <a:pt x="1406525" y="34925"/>
                  <a:pt x="1425046" y="21167"/>
                  <a:pt x="1447800" y="12700"/>
                </a:cubicBezTo>
                <a:cubicBezTo>
                  <a:pt x="1470554" y="4233"/>
                  <a:pt x="1486164" y="2116"/>
                  <a:pt x="1501775" y="0"/>
                </a:cubicBezTo>
              </a:path>
            </a:pathLst>
          </a:custGeom>
          <a:noFill/>
          <a:ln w="12600">
            <a:solidFill>
              <a:srgbClr val="ffffff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3" name="フリーフォーム 5"/>
          <p:cNvSpPr/>
          <p:nvPr/>
        </p:nvSpPr>
        <p:spPr>
          <a:xfrm>
            <a:off x="4676760" y="703440"/>
            <a:ext cx="1692360" cy="1133280"/>
          </a:xfrm>
          <a:custGeom>
            <a:avLst/>
            <a:gdLst/>
            <a:ahLst/>
            <a:rect l="l" t="t" r="r" b="b"/>
            <a:pathLst>
              <a:path w="1717483" h="1169408">
                <a:moveTo>
                  <a:pt x="0" y="0"/>
                </a:moveTo>
                <a:cubicBezTo>
                  <a:pt x="43921" y="21696"/>
                  <a:pt x="87842" y="43392"/>
                  <a:pt x="117475" y="60325"/>
                </a:cubicBezTo>
                <a:cubicBezTo>
                  <a:pt x="147108" y="77258"/>
                  <a:pt x="142875" y="80962"/>
                  <a:pt x="177800" y="101600"/>
                </a:cubicBezTo>
                <a:cubicBezTo>
                  <a:pt x="212725" y="122238"/>
                  <a:pt x="286279" y="159808"/>
                  <a:pt x="327025" y="184150"/>
                </a:cubicBezTo>
                <a:cubicBezTo>
                  <a:pt x="367771" y="208492"/>
                  <a:pt x="380487" y="222183"/>
                  <a:pt x="422275" y="247650"/>
                </a:cubicBezTo>
                <a:cubicBezTo>
                  <a:pt x="464063" y="273117"/>
                  <a:pt x="524308" y="301944"/>
                  <a:pt x="577754" y="336953"/>
                </a:cubicBezTo>
                <a:cubicBezTo>
                  <a:pt x="631200" y="371962"/>
                  <a:pt x="683675" y="418000"/>
                  <a:pt x="742950" y="457704"/>
                </a:cubicBezTo>
                <a:cubicBezTo>
                  <a:pt x="802225" y="497408"/>
                  <a:pt x="872003" y="537062"/>
                  <a:pt x="933402" y="575179"/>
                </a:cubicBezTo>
                <a:cubicBezTo>
                  <a:pt x="994801" y="613296"/>
                  <a:pt x="1041512" y="640317"/>
                  <a:pt x="1111346" y="686405"/>
                </a:cubicBezTo>
                <a:cubicBezTo>
                  <a:pt x="1181180" y="732493"/>
                  <a:pt x="1291327" y="804946"/>
                  <a:pt x="1352406" y="851706"/>
                </a:cubicBezTo>
                <a:cubicBezTo>
                  <a:pt x="1413485" y="898466"/>
                  <a:pt x="1435702" y="930392"/>
                  <a:pt x="1477818" y="966964"/>
                </a:cubicBezTo>
                <a:cubicBezTo>
                  <a:pt x="1519934" y="1003536"/>
                  <a:pt x="1582349" y="1050498"/>
                  <a:pt x="1605103" y="1071135"/>
                </a:cubicBezTo>
                <a:cubicBezTo>
                  <a:pt x="1627857" y="1091772"/>
                  <a:pt x="1697679" y="1149753"/>
                  <a:pt x="1717483" y="1169408"/>
                </a:cubicBezTo>
              </a:path>
            </a:pathLst>
          </a:custGeom>
          <a:noFill/>
          <a:ln w="12600">
            <a:solidFill>
              <a:srgbClr val="ffffff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4" name="フリーフォーム 23"/>
          <p:cNvSpPr/>
          <p:nvPr/>
        </p:nvSpPr>
        <p:spPr>
          <a:xfrm>
            <a:off x="4672080" y="2023920"/>
            <a:ext cx="1712880" cy="1236960"/>
          </a:xfrm>
          <a:custGeom>
            <a:avLst/>
            <a:gdLst/>
            <a:ahLst/>
            <a:rect l="l" t="t" r="r" b="b"/>
            <a:pathLst>
              <a:path w="1689307" h="1246199">
                <a:moveTo>
                  <a:pt x="0" y="0"/>
                </a:moveTo>
                <a:cubicBezTo>
                  <a:pt x="43921" y="21696"/>
                  <a:pt x="87842" y="43392"/>
                  <a:pt x="117475" y="60325"/>
                </a:cubicBezTo>
                <a:cubicBezTo>
                  <a:pt x="147108" y="77258"/>
                  <a:pt x="142875" y="80962"/>
                  <a:pt x="177800" y="101600"/>
                </a:cubicBezTo>
                <a:cubicBezTo>
                  <a:pt x="212725" y="122238"/>
                  <a:pt x="283148" y="159808"/>
                  <a:pt x="327025" y="184150"/>
                </a:cubicBezTo>
                <a:cubicBezTo>
                  <a:pt x="370902" y="208492"/>
                  <a:pt x="399271" y="222183"/>
                  <a:pt x="441059" y="247650"/>
                </a:cubicBezTo>
                <a:cubicBezTo>
                  <a:pt x="482847" y="273117"/>
                  <a:pt x="525874" y="304077"/>
                  <a:pt x="577754" y="336953"/>
                </a:cubicBezTo>
                <a:cubicBezTo>
                  <a:pt x="629634" y="369829"/>
                  <a:pt x="693067" y="405202"/>
                  <a:pt x="752342" y="444906"/>
                </a:cubicBezTo>
                <a:cubicBezTo>
                  <a:pt x="811617" y="484610"/>
                  <a:pt x="874612" y="531730"/>
                  <a:pt x="933402" y="575179"/>
                </a:cubicBezTo>
                <a:cubicBezTo>
                  <a:pt x="992192" y="618628"/>
                  <a:pt x="1043078" y="655782"/>
                  <a:pt x="1105085" y="705603"/>
                </a:cubicBezTo>
                <a:cubicBezTo>
                  <a:pt x="1167092" y="755424"/>
                  <a:pt x="1250107" y="825210"/>
                  <a:pt x="1305446" y="874103"/>
                </a:cubicBezTo>
                <a:cubicBezTo>
                  <a:pt x="1360785" y="922996"/>
                  <a:pt x="1391873" y="956522"/>
                  <a:pt x="1437120" y="998960"/>
                </a:cubicBezTo>
                <a:lnTo>
                  <a:pt x="1576927" y="1128729"/>
                </a:lnTo>
                <a:cubicBezTo>
                  <a:pt x="1599681" y="1149366"/>
                  <a:pt x="1669503" y="1226544"/>
                  <a:pt x="1689307" y="1246199"/>
                </a:cubicBezTo>
              </a:path>
            </a:pathLst>
          </a:custGeom>
          <a:noFill/>
          <a:ln w="12600">
            <a:solidFill>
              <a:srgbClr val="ffffff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5" name="テキスト ボックス 8"/>
          <p:cNvSpPr/>
          <p:nvPr/>
        </p:nvSpPr>
        <p:spPr>
          <a:xfrm>
            <a:off x="222840" y="6788160"/>
            <a:ext cx="5842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ff"/>
                </a:solidFill>
                <a:latin typeface="Arial"/>
              </a:rPr>
              <a:t>DAP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ff00"/>
                </a:solidFill>
                <a:latin typeface="Arial"/>
              </a:rPr>
              <a:t>F4/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H-2D</a:t>
            </a:r>
            <a:r>
              <a:rPr b="0" lang="en-US" sz="1200" spc="-1" strike="noStrike" baseline="30000">
                <a:solidFill>
                  <a:srgbClr val="ff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6" name="フリーフォーム 28"/>
          <p:cNvSpPr/>
          <p:nvPr/>
        </p:nvSpPr>
        <p:spPr>
          <a:xfrm>
            <a:off x="826920" y="4176720"/>
            <a:ext cx="1924200" cy="457200"/>
          </a:xfrm>
          <a:custGeom>
            <a:avLst/>
            <a:gdLst/>
            <a:ahLst/>
            <a:rect l="l" t="t" r="r" b="b"/>
            <a:pathLst>
              <a:path w="1895332" h="457512">
                <a:moveTo>
                  <a:pt x="0" y="457512"/>
                </a:moveTo>
                <a:cubicBezTo>
                  <a:pt x="38100" y="446400"/>
                  <a:pt x="100415" y="393687"/>
                  <a:pt x="147140" y="371710"/>
                </a:cubicBezTo>
                <a:cubicBezTo>
                  <a:pt x="193865" y="349733"/>
                  <a:pt x="216075" y="347112"/>
                  <a:pt x="280349" y="325650"/>
                </a:cubicBezTo>
                <a:cubicBezTo>
                  <a:pt x="344623" y="304188"/>
                  <a:pt x="452611" y="258065"/>
                  <a:pt x="532784" y="242939"/>
                </a:cubicBezTo>
                <a:cubicBezTo>
                  <a:pt x="612957" y="227813"/>
                  <a:pt x="690508" y="233311"/>
                  <a:pt x="761385" y="234896"/>
                </a:cubicBezTo>
                <a:cubicBezTo>
                  <a:pt x="832262" y="236481"/>
                  <a:pt x="903232" y="251110"/>
                  <a:pt x="958044" y="252450"/>
                </a:cubicBezTo>
                <a:cubicBezTo>
                  <a:pt x="992021" y="250870"/>
                  <a:pt x="1049172" y="251403"/>
                  <a:pt x="1090257" y="242939"/>
                </a:cubicBezTo>
                <a:cubicBezTo>
                  <a:pt x="1131342" y="234475"/>
                  <a:pt x="1170690" y="215422"/>
                  <a:pt x="1204557" y="201664"/>
                </a:cubicBezTo>
                <a:cubicBezTo>
                  <a:pt x="1238424" y="187906"/>
                  <a:pt x="1260096" y="176793"/>
                  <a:pt x="1293457" y="160389"/>
                </a:cubicBezTo>
                <a:cubicBezTo>
                  <a:pt x="1326818" y="143985"/>
                  <a:pt x="1359864" y="124401"/>
                  <a:pt x="1404724" y="103239"/>
                </a:cubicBezTo>
                <a:cubicBezTo>
                  <a:pt x="1449584" y="82077"/>
                  <a:pt x="1510264" y="50604"/>
                  <a:pt x="1562620" y="33419"/>
                </a:cubicBezTo>
                <a:cubicBezTo>
                  <a:pt x="1614976" y="16234"/>
                  <a:pt x="1662626" y="17064"/>
                  <a:pt x="1718860" y="130"/>
                </a:cubicBezTo>
                <a:cubicBezTo>
                  <a:pt x="1822009" y="-2493"/>
                  <a:pt x="1830223" y="35667"/>
                  <a:pt x="1895332" y="22438"/>
                </a:cubicBezTo>
              </a:path>
            </a:pathLst>
          </a:custGeom>
          <a:noFill/>
          <a:ln w="12600">
            <a:solidFill>
              <a:srgbClr val="ffffff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7" name="フリーフォーム 30"/>
          <p:cNvSpPr/>
          <p:nvPr/>
        </p:nvSpPr>
        <p:spPr>
          <a:xfrm>
            <a:off x="4676760" y="4011480"/>
            <a:ext cx="1306440" cy="949320"/>
          </a:xfrm>
          <a:custGeom>
            <a:avLst/>
            <a:gdLst/>
            <a:ahLst/>
            <a:rect l="l" t="t" r="r" b="b"/>
            <a:pathLst>
              <a:path w="1485172" h="1203730">
                <a:moveTo>
                  <a:pt x="0" y="0"/>
                </a:moveTo>
                <a:cubicBezTo>
                  <a:pt x="43890" y="19167"/>
                  <a:pt x="183462" y="113711"/>
                  <a:pt x="259802" y="165414"/>
                </a:cubicBezTo>
                <a:cubicBezTo>
                  <a:pt x="336142" y="217117"/>
                  <a:pt x="397282" y="265986"/>
                  <a:pt x="458041" y="310218"/>
                </a:cubicBezTo>
                <a:lnTo>
                  <a:pt x="624358" y="430807"/>
                </a:lnTo>
                <a:cubicBezTo>
                  <a:pt x="679490" y="471297"/>
                  <a:pt x="733953" y="510049"/>
                  <a:pt x="788832" y="553160"/>
                </a:cubicBezTo>
                <a:cubicBezTo>
                  <a:pt x="843711" y="596271"/>
                  <a:pt x="897552" y="642619"/>
                  <a:pt x="953633" y="689475"/>
                </a:cubicBezTo>
                <a:cubicBezTo>
                  <a:pt x="1009714" y="736331"/>
                  <a:pt x="1073062" y="785069"/>
                  <a:pt x="1125316" y="834297"/>
                </a:cubicBezTo>
                <a:cubicBezTo>
                  <a:pt x="1177570" y="883525"/>
                  <a:pt x="1207179" y="923270"/>
                  <a:pt x="1267155" y="984842"/>
                </a:cubicBezTo>
                <a:cubicBezTo>
                  <a:pt x="1327131" y="1046414"/>
                  <a:pt x="1438360" y="1157293"/>
                  <a:pt x="1485172" y="1203730"/>
                </a:cubicBezTo>
              </a:path>
            </a:pathLst>
          </a:custGeom>
          <a:noFill/>
          <a:ln w="12600">
            <a:solidFill>
              <a:srgbClr val="ffffff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8" name="テキスト ボックス 17"/>
          <p:cNvSpPr/>
          <p:nvPr/>
        </p:nvSpPr>
        <p:spPr>
          <a:xfrm>
            <a:off x="217440" y="20484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9" name="テキスト ボックス 18"/>
          <p:cNvSpPr/>
          <p:nvPr/>
        </p:nvSpPr>
        <p:spPr>
          <a:xfrm>
            <a:off x="217440" y="333864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0" name="テキスト ボックス 33"/>
          <p:cNvSpPr/>
          <p:nvPr/>
        </p:nvSpPr>
        <p:spPr>
          <a:xfrm>
            <a:off x="1224000" y="3338640"/>
            <a:ext cx="1168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29       129, PB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1" name="テキスト ボックス 34"/>
          <p:cNvSpPr/>
          <p:nvPr/>
        </p:nvSpPr>
        <p:spPr>
          <a:xfrm>
            <a:off x="3091680" y="3338640"/>
            <a:ext cx="1211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29       C3H, PB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2" name="テキスト ボックス 35"/>
          <p:cNvSpPr/>
          <p:nvPr/>
        </p:nvSpPr>
        <p:spPr>
          <a:xfrm>
            <a:off x="4688280" y="3338640"/>
            <a:ext cx="1837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29       C3H, ES-SCs treat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973" name="直線矢印コネクタ 36"/>
          <p:cNvCxnSpPr/>
          <p:nvPr/>
        </p:nvCxnSpPr>
        <p:spPr>
          <a:xfrm>
            <a:off x="1522440" y="3465000"/>
            <a:ext cx="22464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74" name="直線矢印コネクタ 37"/>
          <p:cNvCxnSpPr/>
          <p:nvPr/>
        </p:nvCxnSpPr>
        <p:spPr>
          <a:xfrm>
            <a:off x="3386160" y="3465000"/>
            <a:ext cx="22464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75" name="直線矢印コネクタ 38"/>
          <p:cNvCxnSpPr/>
          <p:nvPr/>
        </p:nvCxnSpPr>
        <p:spPr>
          <a:xfrm>
            <a:off x="4967280" y="3465000"/>
            <a:ext cx="22464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976" name="フリーフォーム 47"/>
          <p:cNvSpPr/>
          <p:nvPr/>
        </p:nvSpPr>
        <p:spPr>
          <a:xfrm>
            <a:off x="3170160" y="6575400"/>
            <a:ext cx="1497240" cy="1266840"/>
          </a:xfrm>
          <a:custGeom>
            <a:avLst/>
            <a:gdLst/>
            <a:ahLst/>
            <a:rect l="l" t="t" r="r" b="b"/>
            <a:pathLst>
              <a:path w="1497013" h="1266826">
                <a:moveTo>
                  <a:pt x="0" y="1266826"/>
                </a:moveTo>
                <a:cubicBezTo>
                  <a:pt x="25929" y="1243807"/>
                  <a:pt x="51858" y="1220788"/>
                  <a:pt x="73025" y="1196976"/>
                </a:cubicBezTo>
                <a:cubicBezTo>
                  <a:pt x="94192" y="1173163"/>
                  <a:pt x="102658" y="1151997"/>
                  <a:pt x="127000" y="1123951"/>
                </a:cubicBezTo>
                <a:cubicBezTo>
                  <a:pt x="151342" y="1095905"/>
                  <a:pt x="187854" y="1054630"/>
                  <a:pt x="219075" y="1028701"/>
                </a:cubicBezTo>
                <a:cubicBezTo>
                  <a:pt x="250296" y="1002772"/>
                  <a:pt x="282046" y="992188"/>
                  <a:pt x="314325" y="968376"/>
                </a:cubicBezTo>
                <a:cubicBezTo>
                  <a:pt x="346604" y="944563"/>
                  <a:pt x="382058" y="910168"/>
                  <a:pt x="412750" y="885826"/>
                </a:cubicBezTo>
                <a:cubicBezTo>
                  <a:pt x="443442" y="861484"/>
                  <a:pt x="463021" y="848784"/>
                  <a:pt x="498475" y="822326"/>
                </a:cubicBezTo>
                <a:lnTo>
                  <a:pt x="625475" y="727076"/>
                </a:lnTo>
                <a:cubicBezTo>
                  <a:pt x="664633" y="698501"/>
                  <a:pt x="684742" y="687918"/>
                  <a:pt x="733425" y="650876"/>
                </a:cubicBezTo>
                <a:cubicBezTo>
                  <a:pt x="782108" y="613834"/>
                  <a:pt x="859631" y="552451"/>
                  <a:pt x="917575" y="504826"/>
                </a:cubicBezTo>
                <a:cubicBezTo>
                  <a:pt x="975519" y="457201"/>
                  <a:pt x="1027642" y="411428"/>
                  <a:pt x="1081088" y="365126"/>
                </a:cubicBezTo>
                <a:cubicBezTo>
                  <a:pt x="1134534" y="318824"/>
                  <a:pt x="1190891" y="264296"/>
                  <a:pt x="1238251" y="227012"/>
                </a:cubicBezTo>
                <a:cubicBezTo>
                  <a:pt x="1276086" y="189728"/>
                  <a:pt x="1357843" y="114963"/>
                  <a:pt x="1393826" y="93796"/>
                </a:cubicBezTo>
                <a:cubicBezTo>
                  <a:pt x="1429809" y="72629"/>
                  <a:pt x="1485372" y="5314"/>
                  <a:pt x="1497013" y="0"/>
                </a:cubicBezTo>
              </a:path>
            </a:pathLst>
          </a:custGeom>
          <a:noFill/>
          <a:ln w="12600">
            <a:solidFill>
              <a:srgbClr val="ffffff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7" name="フリーフォーム 49"/>
          <p:cNvSpPr/>
          <p:nvPr/>
        </p:nvSpPr>
        <p:spPr>
          <a:xfrm>
            <a:off x="3189240" y="5167440"/>
            <a:ext cx="1478160" cy="1230120"/>
          </a:xfrm>
          <a:custGeom>
            <a:avLst/>
            <a:gdLst/>
            <a:ahLst/>
            <a:rect l="l" t="t" r="r" b="b"/>
            <a:pathLst>
              <a:path w="1477963" h="1266970">
                <a:moveTo>
                  <a:pt x="0" y="1266970"/>
                </a:moveTo>
                <a:cubicBezTo>
                  <a:pt x="25929" y="1243951"/>
                  <a:pt x="41540" y="1211119"/>
                  <a:pt x="63500" y="1187306"/>
                </a:cubicBezTo>
                <a:cubicBezTo>
                  <a:pt x="85460" y="1163493"/>
                  <a:pt x="107420" y="1146415"/>
                  <a:pt x="131762" y="1124094"/>
                </a:cubicBezTo>
                <a:cubicBezTo>
                  <a:pt x="156104" y="1101773"/>
                  <a:pt x="185473" y="1080125"/>
                  <a:pt x="209550" y="1053378"/>
                </a:cubicBezTo>
                <a:cubicBezTo>
                  <a:pt x="233627" y="1026631"/>
                  <a:pt x="248708" y="992332"/>
                  <a:pt x="276225" y="963613"/>
                </a:cubicBezTo>
                <a:cubicBezTo>
                  <a:pt x="303742" y="934894"/>
                  <a:pt x="343958" y="905405"/>
                  <a:pt x="374650" y="881063"/>
                </a:cubicBezTo>
                <a:cubicBezTo>
                  <a:pt x="405342" y="856721"/>
                  <a:pt x="424921" y="844021"/>
                  <a:pt x="460375" y="817563"/>
                </a:cubicBezTo>
                <a:lnTo>
                  <a:pt x="587375" y="722313"/>
                </a:lnTo>
                <a:cubicBezTo>
                  <a:pt x="626533" y="693738"/>
                  <a:pt x="646642" y="683155"/>
                  <a:pt x="695325" y="646113"/>
                </a:cubicBezTo>
                <a:cubicBezTo>
                  <a:pt x="744008" y="609071"/>
                  <a:pt x="821531" y="547688"/>
                  <a:pt x="879475" y="500063"/>
                </a:cubicBezTo>
                <a:cubicBezTo>
                  <a:pt x="937419" y="452438"/>
                  <a:pt x="989542" y="406665"/>
                  <a:pt x="1042988" y="360363"/>
                </a:cubicBezTo>
                <a:cubicBezTo>
                  <a:pt x="1096434" y="314061"/>
                  <a:pt x="1152791" y="259533"/>
                  <a:pt x="1200151" y="222249"/>
                </a:cubicBezTo>
                <a:cubicBezTo>
                  <a:pt x="1237986" y="184965"/>
                  <a:pt x="1319743" y="110200"/>
                  <a:pt x="1355726" y="89033"/>
                </a:cubicBezTo>
                <a:cubicBezTo>
                  <a:pt x="1391709" y="67866"/>
                  <a:pt x="1466322" y="5314"/>
                  <a:pt x="1477963" y="0"/>
                </a:cubicBezTo>
              </a:path>
            </a:pathLst>
          </a:custGeom>
          <a:noFill/>
          <a:ln w="12600">
            <a:solidFill>
              <a:srgbClr val="ffffff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8" name="フリーフォーム 51"/>
          <p:cNvSpPr/>
          <p:nvPr/>
        </p:nvSpPr>
        <p:spPr>
          <a:xfrm>
            <a:off x="3189240" y="3722760"/>
            <a:ext cx="1478160" cy="1230120"/>
          </a:xfrm>
          <a:custGeom>
            <a:avLst/>
            <a:gdLst/>
            <a:ahLst/>
            <a:rect l="l" t="t" r="r" b="b"/>
            <a:pathLst>
              <a:path w="1477963" h="1266970">
                <a:moveTo>
                  <a:pt x="0" y="1266970"/>
                </a:moveTo>
                <a:cubicBezTo>
                  <a:pt x="25929" y="1243951"/>
                  <a:pt x="41540" y="1211119"/>
                  <a:pt x="63500" y="1187306"/>
                </a:cubicBezTo>
                <a:cubicBezTo>
                  <a:pt x="85460" y="1163493"/>
                  <a:pt x="107420" y="1146415"/>
                  <a:pt x="131762" y="1124094"/>
                </a:cubicBezTo>
                <a:cubicBezTo>
                  <a:pt x="156104" y="1101773"/>
                  <a:pt x="185473" y="1080125"/>
                  <a:pt x="209550" y="1053378"/>
                </a:cubicBezTo>
                <a:cubicBezTo>
                  <a:pt x="233627" y="1026631"/>
                  <a:pt x="248708" y="992332"/>
                  <a:pt x="276225" y="963613"/>
                </a:cubicBezTo>
                <a:cubicBezTo>
                  <a:pt x="303742" y="934894"/>
                  <a:pt x="343958" y="905405"/>
                  <a:pt x="374650" y="881063"/>
                </a:cubicBezTo>
                <a:cubicBezTo>
                  <a:pt x="405342" y="856721"/>
                  <a:pt x="424921" y="844021"/>
                  <a:pt x="460375" y="817563"/>
                </a:cubicBezTo>
                <a:lnTo>
                  <a:pt x="587375" y="722313"/>
                </a:lnTo>
                <a:cubicBezTo>
                  <a:pt x="626533" y="693738"/>
                  <a:pt x="646642" y="683155"/>
                  <a:pt x="695325" y="646113"/>
                </a:cubicBezTo>
                <a:cubicBezTo>
                  <a:pt x="744008" y="609071"/>
                  <a:pt x="821531" y="547688"/>
                  <a:pt x="879475" y="500063"/>
                </a:cubicBezTo>
                <a:cubicBezTo>
                  <a:pt x="937419" y="452438"/>
                  <a:pt x="989542" y="406665"/>
                  <a:pt x="1042988" y="360363"/>
                </a:cubicBezTo>
                <a:cubicBezTo>
                  <a:pt x="1096434" y="314061"/>
                  <a:pt x="1152791" y="259533"/>
                  <a:pt x="1200151" y="222249"/>
                </a:cubicBezTo>
                <a:cubicBezTo>
                  <a:pt x="1237986" y="184965"/>
                  <a:pt x="1319743" y="110200"/>
                  <a:pt x="1355726" y="89033"/>
                </a:cubicBezTo>
                <a:cubicBezTo>
                  <a:pt x="1391709" y="67866"/>
                  <a:pt x="1466322" y="5314"/>
                  <a:pt x="1477963" y="0"/>
                </a:cubicBezTo>
              </a:path>
            </a:pathLst>
          </a:custGeom>
          <a:noFill/>
          <a:ln w="12600">
            <a:solidFill>
              <a:srgbClr val="ffffff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9" name="フリーフォーム 55"/>
          <p:cNvSpPr/>
          <p:nvPr/>
        </p:nvSpPr>
        <p:spPr>
          <a:xfrm>
            <a:off x="826920" y="5591160"/>
            <a:ext cx="1924200" cy="457200"/>
          </a:xfrm>
          <a:custGeom>
            <a:avLst/>
            <a:gdLst/>
            <a:ahLst/>
            <a:rect l="l" t="t" r="r" b="b"/>
            <a:pathLst>
              <a:path w="1895332" h="457512">
                <a:moveTo>
                  <a:pt x="0" y="457512"/>
                </a:moveTo>
                <a:cubicBezTo>
                  <a:pt x="38100" y="446400"/>
                  <a:pt x="100415" y="393687"/>
                  <a:pt x="147140" y="371710"/>
                </a:cubicBezTo>
                <a:cubicBezTo>
                  <a:pt x="193865" y="349733"/>
                  <a:pt x="216075" y="347112"/>
                  <a:pt x="280349" y="325650"/>
                </a:cubicBezTo>
                <a:cubicBezTo>
                  <a:pt x="344623" y="304188"/>
                  <a:pt x="452611" y="258065"/>
                  <a:pt x="532784" y="242939"/>
                </a:cubicBezTo>
                <a:cubicBezTo>
                  <a:pt x="612957" y="227813"/>
                  <a:pt x="690508" y="233311"/>
                  <a:pt x="761385" y="234896"/>
                </a:cubicBezTo>
                <a:cubicBezTo>
                  <a:pt x="832262" y="236481"/>
                  <a:pt x="903232" y="251110"/>
                  <a:pt x="958044" y="252450"/>
                </a:cubicBezTo>
                <a:cubicBezTo>
                  <a:pt x="992021" y="250870"/>
                  <a:pt x="1049172" y="251403"/>
                  <a:pt x="1090257" y="242939"/>
                </a:cubicBezTo>
                <a:cubicBezTo>
                  <a:pt x="1131342" y="234475"/>
                  <a:pt x="1170690" y="215422"/>
                  <a:pt x="1204557" y="201664"/>
                </a:cubicBezTo>
                <a:cubicBezTo>
                  <a:pt x="1238424" y="187906"/>
                  <a:pt x="1260096" y="176793"/>
                  <a:pt x="1293457" y="160389"/>
                </a:cubicBezTo>
                <a:cubicBezTo>
                  <a:pt x="1326818" y="143985"/>
                  <a:pt x="1359864" y="124401"/>
                  <a:pt x="1404724" y="103239"/>
                </a:cubicBezTo>
                <a:cubicBezTo>
                  <a:pt x="1449584" y="82077"/>
                  <a:pt x="1510264" y="50604"/>
                  <a:pt x="1562620" y="33419"/>
                </a:cubicBezTo>
                <a:cubicBezTo>
                  <a:pt x="1614976" y="16234"/>
                  <a:pt x="1662626" y="17064"/>
                  <a:pt x="1718860" y="130"/>
                </a:cubicBezTo>
                <a:cubicBezTo>
                  <a:pt x="1822009" y="-2493"/>
                  <a:pt x="1830223" y="35667"/>
                  <a:pt x="1895332" y="22438"/>
                </a:cubicBezTo>
              </a:path>
            </a:pathLst>
          </a:custGeom>
          <a:noFill/>
          <a:ln w="12600">
            <a:solidFill>
              <a:srgbClr val="ffffff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0" name="フリーフォーム 56"/>
          <p:cNvSpPr/>
          <p:nvPr/>
        </p:nvSpPr>
        <p:spPr>
          <a:xfrm>
            <a:off x="826920" y="7024680"/>
            <a:ext cx="1924200" cy="457200"/>
          </a:xfrm>
          <a:custGeom>
            <a:avLst/>
            <a:gdLst/>
            <a:ahLst/>
            <a:rect l="l" t="t" r="r" b="b"/>
            <a:pathLst>
              <a:path w="1895332" h="457512">
                <a:moveTo>
                  <a:pt x="0" y="457512"/>
                </a:moveTo>
                <a:cubicBezTo>
                  <a:pt x="38100" y="446400"/>
                  <a:pt x="100415" y="393687"/>
                  <a:pt x="147140" y="371710"/>
                </a:cubicBezTo>
                <a:cubicBezTo>
                  <a:pt x="193865" y="349733"/>
                  <a:pt x="216075" y="347112"/>
                  <a:pt x="280349" y="325650"/>
                </a:cubicBezTo>
                <a:cubicBezTo>
                  <a:pt x="344623" y="304188"/>
                  <a:pt x="452611" y="258065"/>
                  <a:pt x="532784" y="242939"/>
                </a:cubicBezTo>
                <a:cubicBezTo>
                  <a:pt x="612957" y="227813"/>
                  <a:pt x="690508" y="233311"/>
                  <a:pt x="761385" y="234896"/>
                </a:cubicBezTo>
                <a:cubicBezTo>
                  <a:pt x="832262" y="236481"/>
                  <a:pt x="903232" y="251110"/>
                  <a:pt x="958044" y="252450"/>
                </a:cubicBezTo>
                <a:cubicBezTo>
                  <a:pt x="992021" y="250870"/>
                  <a:pt x="1049172" y="251403"/>
                  <a:pt x="1090257" y="242939"/>
                </a:cubicBezTo>
                <a:cubicBezTo>
                  <a:pt x="1131342" y="234475"/>
                  <a:pt x="1170690" y="215422"/>
                  <a:pt x="1204557" y="201664"/>
                </a:cubicBezTo>
                <a:cubicBezTo>
                  <a:pt x="1238424" y="187906"/>
                  <a:pt x="1260096" y="176793"/>
                  <a:pt x="1293457" y="160389"/>
                </a:cubicBezTo>
                <a:cubicBezTo>
                  <a:pt x="1326818" y="143985"/>
                  <a:pt x="1359864" y="124401"/>
                  <a:pt x="1404724" y="103239"/>
                </a:cubicBezTo>
                <a:cubicBezTo>
                  <a:pt x="1449584" y="82077"/>
                  <a:pt x="1510264" y="50604"/>
                  <a:pt x="1562620" y="33419"/>
                </a:cubicBezTo>
                <a:cubicBezTo>
                  <a:pt x="1614976" y="16234"/>
                  <a:pt x="1662626" y="17064"/>
                  <a:pt x="1718860" y="130"/>
                </a:cubicBezTo>
                <a:cubicBezTo>
                  <a:pt x="1822009" y="-2493"/>
                  <a:pt x="1830223" y="35667"/>
                  <a:pt x="1895332" y="22438"/>
                </a:cubicBezTo>
              </a:path>
            </a:pathLst>
          </a:custGeom>
          <a:noFill/>
          <a:ln w="12600">
            <a:solidFill>
              <a:srgbClr val="ffffff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1" name="フリーフォーム 57"/>
          <p:cNvSpPr/>
          <p:nvPr/>
        </p:nvSpPr>
        <p:spPr>
          <a:xfrm>
            <a:off x="4676760" y="5446800"/>
            <a:ext cx="1306440" cy="947520"/>
          </a:xfrm>
          <a:custGeom>
            <a:avLst/>
            <a:gdLst/>
            <a:ahLst/>
            <a:rect l="l" t="t" r="r" b="b"/>
            <a:pathLst>
              <a:path w="1485172" h="1203730">
                <a:moveTo>
                  <a:pt x="0" y="0"/>
                </a:moveTo>
                <a:cubicBezTo>
                  <a:pt x="43890" y="19167"/>
                  <a:pt x="183462" y="113711"/>
                  <a:pt x="259802" y="165414"/>
                </a:cubicBezTo>
                <a:cubicBezTo>
                  <a:pt x="336142" y="217117"/>
                  <a:pt x="397282" y="265986"/>
                  <a:pt x="458041" y="310218"/>
                </a:cubicBezTo>
                <a:lnTo>
                  <a:pt x="624358" y="430807"/>
                </a:lnTo>
                <a:cubicBezTo>
                  <a:pt x="679490" y="471297"/>
                  <a:pt x="733953" y="510049"/>
                  <a:pt x="788832" y="553160"/>
                </a:cubicBezTo>
                <a:cubicBezTo>
                  <a:pt x="843711" y="596271"/>
                  <a:pt x="897552" y="642619"/>
                  <a:pt x="953633" y="689475"/>
                </a:cubicBezTo>
                <a:cubicBezTo>
                  <a:pt x="1009714" y="736331"/>
                  <a:pt x="1073062" y="785069"/>
                  <a:pt x="1125316" y="834297"/>
                </a:cubicBezTo>
                <a:cubicBezTo>
                  <a:pt x="1177570" y="883525"/>
                  <a:pt x="1207179" y="923270"/>
                  <a:pt x="1267155" y="984842"/>
                </a:cubicBezTo>
                <a:cubicBezTo>
                  <a:pt x="1327131" y="1046414"/>
                  <a:pt x="1438360" y="1157293"/>
                  <a:pt x="1485172" y="1203730"/>
                </a:cubicBezTo>
              </a:path>
            </a:pathLst>
          </a:custGeom>
          <a:noFill/>
          <a:ln w="12600">
            <a:solidFill>
              <a:srgbClr val="ffffff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2" name="フリーフォーム 58"/>
          <p:cNvSpPr/>
          <p:nvPr/>
        </p:nvSpPr>
        <p:spPr>
          <a:xfrm>
            <a:off x="4676760" y="6877080"/>
            <a:ext cx="1306440" cy="947880"/>
          </a:xfrm>
          <a:custGeom>
            <a:avLst/>
            <a:gdLst/>
            <a:ahLst/>
            <a:rect l="l" t="t" r="r" b="b"/>
            <a:pathLst>
              <a:path w="1485172" h="1203730">
                <a:moveTo>
                  <a:pt x="0" y="0"/>
                </a:moveTo>
                <a:cubicBezTo>
                  <a:pt x="43890" y="19167"/>
                  <a:pt x="183462" y="113711"/>
                  <a:pt x="259802" y="165414"/>
                </a:cubicBezTo>
                <a:cubicBezTo>
                  <a:pt x="336142" y="217117"/>
                  <a:pt x="397282" y="265986"/>
                  <a:pt x="458041" y="310218"/>
                </a:cubicBezTo>
                <a:lnTo>
                  <a:pt x="624358" y="430807"/>
                </a:lnTo>
                <a:cubicBezTo>
                  <a:pt x="679490" y="471297"/>
                  <a:pt x="733953" y="510049"/>
                  <a:pt x="788832" y="553160"/>
                </a:cubicBezTo>
                <a:cubicBezTo>
                  <a:pt x="843711" y="596271"/>
                  <a:pt x="897552" y="642619"/>
                  <a:pt x="953633" y="689475"/>
                </a:cubicBezTo>
                <a:cubicBezTo>
                  <a:pt x="1009714" y="736331"/>
                  <a:pt x="1073062" y="785069"/>
                  <a:pt x="1125316" y="834297"/>
                </a:cubicBezTo>
                <a:cubicBezTo>
                  <a:pt x="1177570" y="883525"/>
                  <a:pt x="1207179" y="923270"/>
                  <a:pt x="1267155" y="984842"/>
                </a:cubicBezTo>
                <a:cubicBezTo>
                  <a:pt x="1327131" y="1046414"/>
                  <a:pt x="1438360" y="1157293"/>
                  <a:pt x="1485172" y="1203730"/>
                </a:cubicBezTo>
              </a:path>
            </a:pathLst>
          </a:custGeom>
          <a:noFill/>
          <a:ln w="12600">
            <a:solidFill>
              <a:srgbClr val="ffffff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3" name="テキスト ボックス 8"/>
          <p:cNvSpPr/>
          <p:nvPr/>
        </p:nvSpPr>
        <p:spPr>
          <a:xfrm>
            <a:off x="225360" y="5459400"/>
            <a:ext cx="584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ff"/>
                </a:solidFill>
                <a:latin typeface="Arial"/>
              </a:rPr>
              <a:t>DAP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H-2D</a:t>
            </a:r>
            <a:r>
              <a:rPr b="0" lang="en-US" sz="1200" spc="-1" strike="noStrike" baseline="30000">
                <a:solidFill>
                  <a:srgbClr val="ff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4" name="テキスト ボックス 8"/>
          <p:cNvSpPr/>
          <p:nvPr/>
        </p:nvSpPr>
        <p:spPr>
          <a:xfrm>
            <a:off x="217800" y="4021200"/>
            <a:ext cx="5724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ff"/>
                </a:solidFill>
                <a:latin typeface="Arial"/>
              </a:rPr>
              <a:t>DAP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ff00"/>
                </a:solidFill>
                <a:latin typeface="Arial"/>
              </a:rPr>
              <a:t>F4/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5" name="テキスト ボックス 18"/>
          <p:cNvSpPr/>
          <p:nvPr/>
        </p:nvSpPr>
        <p:spPr>
          <a:xfrm>
            <a:off x="217440" y="7835760"/>
            <a:ext cx="6380280" cy="131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</a:t>
            </a:r>
            <a:r>
              <a:rPr b="1" lang="ja-JP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5, ES-SCs act systemically rather than locally at transplantation sit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mmunohistological staining for CD3 antigen (indicating T cell infiltration) of ESCs-derived cardiomyocytes transplanted into renal subcapsule at day 6 after transplantation. Recipient mouse was pre-treated with PBS (129→129, PBS and 129→C3H, PBS) or ES-SCs (129→C3H, ES-SCs treated). Dotted line indicated the border of kidney and graft.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; graft, k; kidney. Scale bars, 100 </a:t>
            </a:r>
            <a:r>
              <a:rPr b="0" lang="el-G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.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non-specific staining of kidney cells. (A) Immunohistological staining for CD3 antigen (indicating T cell infiltration) or F4/80 antigen (indicating macrophage infiltration). (B) Immunohistological staining for F4/80 antigen and H-2D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tigen (indicating recipient cell infiltration in recipient 129 mouse or ES-SCs in recipient C3H mouse)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6" name="Text Box 53"/>
          <p:cNvSpPr/>
          <p:nvPr/>
        </p:nvSpPr>
        <p:spPr>
          <a:xfrm>
            <a:off x="2533680" y="9540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7" name="Text Box 54"/>
          <p:cNvSpPr/>
          <p:nvPr/>
        </p:nvSpPr>
        <p:spPr>
          <a:xfrm>
            <a:off x="2535120" y="118584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8" name="Text Box 55"/>
          <p:cNvSpPr/>
          <p:nvPr/>
        </p:nvSpPr>
        <p:spPr>
          <a:xfrm>
            <a:off x="4432320" y="76212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9" name="Text Box 56"/>
          <p:cNvSpPr/>
          <p:nvPr/>
        </p:nvSpPr>
        <p:spPr>
          <a:xfrm>
            <a:off x="4433760" y="9936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0" name="Text Box 57"/>
          <p:cNvSpPr/>
          <p:nvPr/>
        </p:nvSpPr>
        <p:spPr>
          <a:xfrm>
            <a:off x="4622760" y="49068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1" name="Text Box 58"/>
          <p:cNvSpPr/>
          <p:nvPr/>
        </p:nvSpPr>
        <p:spPr>
          <a:xfrm>
            <a:off x="4624200" y="72216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2" name="Text Box 53"/>
          <p:cNvSpPr/>
          <p:nvPr/>
        </p:nvSpPr>
        <p:spPr>
          <a:xfrm>
            <a:off x="2535120" y="222732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3" name="Text Box 54"/>
          <p:cNvSpPr/>
          <p:nvPr/>
        </p:nvSpPr>
        <p:spPr>
          <a:xfrm>
            <a:off x="2536560" y="245916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4" name="Text Box 55"/>
          <p:cNvSpPr/>
          <p:nvPr/>
        </p:nvSpPr>
        <p:spPr>
          <a:xfrm>
            <a:off x="4433760" y="209088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5" name="Text Box 56"/>
          <p:cNvSpPr/>
          <p:nvPr/>
        </p:nvSpPr>
        <p:spPr>
          <a:xfrm>
            <a:off x="4435200" y="232236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6" name="Text Box 57"/>
          <p:cNvSpPr/>
          <p:nvPr/>
        </p:nvSpPr>
        <p:spPr>
          <a:xfrm>
            <a:off x="4624200" y="179532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7" name="Text Box 58"/>
          <p:cNvSpPr/>
          <p:nvPr/>
        </p:nvSpPr>
        <p:spPr>
          <a:xfrm>
            <a:off x="4625640" y="202716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98" name="Group 72"/>
          <p:cNvGrpSpPr/>
          <p:nvPr/>
        </p:nvGrpSpPr>
        <p:grpSpPr>
          <a:xfrm>
            <a:off x="822240" y="3568680"/>
            <a:ext cx="4043520" cy="1221120"/>
            <a:chOff x="822240" y="3568680"/>
            <a:chExt cx="4043520" cy="1221120"/>
          </a:xfrm>
        </p:grpSpPr>
        <p:sp>
          <p:nvSpPr>
            <p:cNvPr id="999" name="Text Box 53"/>
            <p:cNvSpPr/>
            <p:nvPr/>
          </p:nvSpPr>
          <p:spPr>
            <a:xfrm>
              <a:off x="822240" y="431172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Arial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0" name="Text Box 54"/>
            <p:cNvSpPr/>
            <p:nvPr/>
          </p:nvSpPr>
          <p:spPr>
            <a:xfrm>
              <a:off x="823680" y="454356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Arial"/>
                </a:rPr>
                <a:t>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1" name="Text Box 53"/>
            <p:cNvSpPr/>
            <p:nvPr/>
          </p:nvSpPr>
          <p:spPr>
            <a:xfrm>
              <a:off x="4422600" y="356868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Arial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2" name="Text Box 54"/>
            <p:cNvSpPr/>
            <p:nvPr/>
          </p:nvSpPr>
          <p:spPr>
            <a:xfrm>
              <a:off x="4424040" y="380052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Arial"/>
                </a:rPr>
                <a:t>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3" name="Text Box 53"/>
            <p:cNvSpPr/>
            <p:nvPr/>
          </p:nvSpPr>
          <p:spPr>
            <a:xfrm>
              <a:off x="4614840" y="379080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Arial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4" name="Text Box 54"/>
            <p:cNvSpPr/>
            <p:nvPr/>
          </p:nvSpPr>
          <p:spPr>
            <a:xfrm>
              <a:off x="4616280" y="402264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Arial"/>
                </a:rPr>
                <a:t>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05" name="Group 73"/>
          <p:cNvGrpSpPr/>
          <p:nvPr/>
        </p:nvGrpSpPr>
        <p:grpSpPr>
          <a:xfrm>
            <a:off x="822240" y="4998960"/>
            <a:ext cx="4043520" cy="1221120"/>
            <a:chOff x="822240" y="4998960"/>
            <a:chExt cx="4043520" cy="1221120"/>
          </a:xfrm>
        </p:grpSpPr>
        <p:sp>
          <p:nvSpPr>
            <p:cNvPr id="1006" name="Text Box 53"/>
            <p:cNvSpPr/>
            <p:nvPr/>
          </p:nvSpPr>
          <p:spPr>
            <a:xfrm>
              <a:off x="822240" y="574200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Arial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7" name="Text Box 54"/>
            <p:cNvSpPr/>
            <p:nvPr/>
          </p:nvSpPr>
          <p:spPr>
            <a:xfrm>
              <a:off x="823680" y="597384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Arial"/>
                </a:rPr>
                <a:t>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8" name="Text Box 53"/>
            <p:cNvSpPr/>
            <p:nvPr/>
          </p:nvSpPr>
          <p:spPr>
            <a:xfrm>
              <a:off x="4422600" y="499896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Arial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9" name="Text Box 54"/>
            <p:cNvSpPr/>
            <p:nvPr/>
          </p:nvSpPr>
          <p:spPr>
            <a:xfrm>
              <a:off x="4424040" y="523080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Arial"/>
                </a:rPr>
                <a:t>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0" name="Text Box 53"/>
            <p:cNvSpPr/>
            <p:nvPr/>
          </p:nvSpPr>
          <p:spPr>
            <a:xfrm>
              <a:off x="4614840" y="522108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Arial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1" name="Text Box 54"/>
            <p:cNvSpPr/>
            <p:nvPr/>
          </p:nvSpPr>
          <p:spPr>
            <a:xfrm>
              <a:off x="4616280" y="545292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Arial"/>
                </a:rPr>
                <a:t>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12" name="Group 80"/>
          <p:cNvGrpSpPr/>
          <p:nvPr/>
        </p:nvGrpSpPr>
        <p:grpSpPr>
          <a:xfrm>
            <a:off x="822240" y="6427800"/>
            <a:ext cx="4043520" cy="1221120"/>
            <a:chOff x="822240" y="6427800"/>
            <a:chExt cx="4043520" cy="1221120"/>
          </a:xfrm>
        </p:grpSpPr>
        <p:sp>
          <p:nvSpPr>
            <p:cNvPr id="1013" name="Text Box 53"/>
            <p:cNvSpPr/>
            <p:nvPr/>
          </p:nvSpPr>
          <p:spPr>
            <a:xfrm>
              <a:off x="822240" y="71708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Arial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4" name="Text Box 54"/>
            <p:cNvSpPr/>
            <p:nvPr/>
          </p:nvSpPr>
          <p:spPr>
            <a:xfrm>
              <a:off x="823680" y="740268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Arial"/>
                </a:rPr>
                <a:t>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5" name="Text Box 53"/>
            <p:cNvSpPr/>
            <p:nvPr/>
          </p:nvSpPr>
          <p:spPr>
            <a:xfrm>
              <a:off x="4422600" y="642780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Arial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6" name="Text Box 54"/>
            <p:cNvSpPr/>
            <p:nvPr/>
          </p:nvSpPr>
          <p:spPr>
            <a:xfrm>
              <a:off x="4424040" y="665964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Arial"/>
                </a:rPr>
                <a:t>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7" name="Text Box 53"/>
            <p:cNvSpPr/>
            <p:nvPr/>
          </p:nvSpPr>
          <p:spPr>
            <a:xfrm>
              <a:off x="4614840" y="664992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Arial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8" name="Text Box 54"/>
            <p:cNvSpPr/>
            <p:nvPr/>
          </p:nvSpPr>
          <p:spPr>
            <a:xfrm>
              <a:off x="4616280" y="688176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Arial"/>
                </a:rPr>
                <a:t>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19" name="Group 91"/>
          <p:cNvGrpSpPr/>
          <p:nvPr/>
        </p:nvGrpSpPr>
        <p:grpSpPr>
          <a:xfrm>
            <a:off x="2494080" y="6167520"/>
            <a:ext cx="3309480" cy="368280"/>
            <a:chOff x="2494080" y="6167520"/>
            <a:chExt cx="3309480" cy="368280"/>
          </a:xfrm>
        </p:grpSpPr>
        <p:sp>
          <p:nvSpPr>
            <p:cNvPr id="1020" name="Text Box 88"/>
            <p:cNvSpPr/>
            <p:nvPr/>
          </p:nvSpPr>
          <p:spPr>
            <a:xfrm>
              <a:off x="2494080" y="616752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800" spc="-1" strike="noStrike">
                  <a:solidFill>
                    <a:srgbClr val="ffffff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1" name="Text Box 89"/>
            <p:cNvSpPr/>
            <p:nvPr/>
          </p:nvSpPr>
          <p:spPr>
            <a:xfrm>
              <a:off x="3294360" y="616752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800" spc="-1" strike="noStrike">
                  <a:solidFill>
                    <a:srgbClr val="ffffff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2" name="Text Box 90"/>
            <p:cNvSpPr/>
            <p:nvPr/>
          </p:nvSpPr>
          <p:spPr>
            <a:xfrm>
              <a:off x="5534280" y="616752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800" spc="-1" strike="noStrike">
                  <a:solidFill>
                    <a:srgbClr val="ffffff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23" name="Group 92"/>
          <p:cNvGrpSpPr/>
          <p:nvPr/>
        </p:nvGrpSpPr>
        <p:grpSpPr>
          <a:xfrm>
            <a:off x="2494080" y="7610400"/>
            <a:ext cx="3309480" cy="368280"/>
            <a:chOff x="2494080" y="7610400"/>
            <a:chExt cx="3309480" cy="368280"/>
          </a:xfrm>
        </p:grpSpPr>
        <p:sp>
          <p:nvSpPr>
            <p:cNvPr id="1024" name="Text Box 93"/>
            <p:cNvSpPr/>
            <p:nvPr/>
          </p:nvSpPr>
          <p:spPr>
            <a:xfrm>
              <a:off x="2494080" y="761040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800" spc="-1" strike="noStrike">
                  <a:solidFill>
                    <a:srgbClr val="ffffff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5" name="Text Box 94"/>
            <p:cNvSpPr/>
            <p:nvPr/>
          </p:nvSpPr>
          <p:spPr>
            <a:xfrm>
              <a:off x="3294360" y="761040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800" spc="-1" strike="noStrike">
                  <a:solidFill>
                    <a:srgbClr val="ffffff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6" name="Text Box 95"/>
            <p:cNvSpPr/>
            <p:nvPr/>
          </p:nvSpPr>
          <p:spPr>
            <a:xfrm>
              <a:off x="5534280" y="761040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800" spc="-1" strike="noStrike">
                  <a:solidFill>
                    <a:srgbClr val="ffffff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27" name="Group 96"/>
          <p:cNvGrpSpPr/>
          <p:nvPr/>
        </p:nvGrpSpPr>
        <p:grpSpPr>
          <a:xfrm>
            <a:off x="2494080" y="4743360"/>
            <a:ext cx="3309480" cy="368280"/>
            <a:chOff x="2494080" y="4743360"/>
            <a:chExt cx="3309480" cy="368280"/>
          </a:xfrm>
        </p:grpSpPr>
        <p:sp>
          <p:nvSpPr>
            <p:cNvPr id="1028" name="Text Box 97"/>
            <p:cNvSpPr/>
            <p:nvPr/>
          </p:nvSpPr>
          <p:spPr>
            <a:xfrm>
              <a:off x="2494080" y="474336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800" spc="-1" strike="noStrike">
                  <a:solidFill>
                    <a:srgbClr val="ffffff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9" name="Text Box 98"/>
            <p:cNvSpPr/>
            <p:nvPr/>
          </p:nvSpPr>
          <p:spPr>
            <a:xfrm>
              <a:off x="3294360" y="474336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800" spc="-1" strike="noStrike">
                  <a:solidFill>
                    <a:srgbClr val="ffffff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0" name="Text Box 99"/>
            <p:cNvSpPr/>
            <p:nvPr/>
          </p:nvSpPr>
          <p:spPr>
            <a:xfrm>
              <a:off x="5534280" y="474336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800" spc="-1" strike="noStrike">
                  <a:solidFill>
                    <a:srgbClr val="ffffff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31" name="テキスト ボックス 96"/>
          <p:cNvSpPr/>
          <p:nvPr/>
        </p:nvSpPr>
        <p:spPr>
          <a:xfrm>
            <a:off x="-37800" y="-49320"/>
            <a:ext cx="953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Figure S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0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6-18T15:52:43Z</dcterms:created>
  <dc:creator>きのこさん</dc:creator>
  <dc:description/>
  <dc:language>en-US</dc:language>
  <cp:lastModifiedBy>Flow jo</cp:lastModifiedBy>
  <cp:lastPrinted>2014-09-24T08:18:49Z</cp:lastPrinted>
  <dcterms:modified xsi:type="dcterms:W3CDTF">2014-10-10T04:49:38Z</dcterms:modified>
  <cp:revision>103</cp:revision>
  <dc:subject/>
  <dc:title>スライド 1</dc:title>
</cp:coreProperties>
</file>